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3" r:id="rId2"/>
    <p:sldId id="310" r:id="rId3"/>
    <p:sldId id="306" r:id="rId4"/>
    <p:sldId id="308" r:id="rId5"/>
    <p:sldId id="311" r:id="rId6"/>
  </p:sldIdLst>
  <p:sldSz cx="6858000" cy="9144000" type="screen4x3"/>
  <p:notesSz cx="6797675" cy="9926638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66FF33"/>
    <a:srgbClr val="017528"/>
    <a:srgbClr val="78A888"/>
    <a:srgbClr val="4CD4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Stile medio 2 - Colore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20" autoAdjust="0"/>
    <p:restoredTop sz="93525" autoAdjust="0"/>
  </p:normalViewPr>
  <p:slideViewPr>
    <p:cSldViewPr>
      <p:cViewPr varScale="1">
        <p:scale>
          <a:sx n="79" d="100"/>
          <a:sy n="79" d="100"/>
        </p:scale>
        <p:origin x="3648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ilippo Acconcia" userId="844af49c-a8a0-47ac-a7dd-14a44b60cd18" providerId="ADAL" clId="{F95F0201-6B3C-479C-9473-CC4C485F19A1}"/>
    <pc:docChg chg="undo custSel addSld delSld modSld">
      <pc:chgData name="Filippo Acconcia" userId="844af49c-a8a0-47ac-a7dd-14a44b60cd18" providerId="ADAL" clId="{F95F0201-6B3C-479C-9473-CC4C485F19A1}" dt="2022-09-04T09:57:23.972" v="1893" actId="1035"/>
      <pc:docMkLst>
        <pc:docMk/>
      </pc:docMkLst>
      <pc:sldChg chg="del">
        <pc:chgData name="Filippo Acconcia" userId="844af49c-a8a0-47ac-a7dd-14a44b60cd18" providerId="ADAL" clId="{F95F0201-6B3C-479C-9473-CC4C485F19A1}" dt="2022-07-30T06:35:59.624" v="36" actId="47"/>
        <pc:sldMkLst>
          <pc:docMk/>
          <pc:sldMk cId="0" sldId="274"/>
        </pc:sldMkLst>
      </pc:sldChg>
      <pc:sldChg chg="del">
        <pc:chgData name="Filippo Acconcia" userId="844af49c-a8a0-47ac-a7dd-14a44b60cd18" providerId="ADAL" clId="{F95F0201-6B3C-479C-9473-CC4C485F19A1}" dt="2022-07-30T06:36:03.131" v="42" actId="47"/>
        <pc:sldMkLst>
          <pc:docMk/>
          <pc:sldMk cId="484234585" sldId="289"/>
        </pc:sldMkLst>
      </pc:sldChg>
      <pc:sldChg chg="del">
        <pc:chgData name="Filippo Acconcia" userId="844af49c-a8a0-47ac-a7dd-14a44b60cd18" providerId="ADAL" clId="{F95F0201-6B3C-479C-9473-CC4C485F19A1}" dt="2022-07-30T06:36:00.234" v="37" actId="47"/>
        <pc:sldMkLst>
          <pc:docMk/>
          <pc:sldMk cId="3001412858" sldId="301"/>
        </pc:sldMkLst>
      </pc:sldChg>
      <pc:sldChg chg="del">
        <pc:chgData name="Filippo Acconcia" userId="844af49c-a8a0-47ac-a7dd-14a44b60cd18" providerId="ADAL" clId="{F95F0201-6B3C-479C-9473-CC4C485F19A1}" dt="2022-07-30T06:36:00.734" v="38" actId="47"/>
        <pc:sldMkLst>
          <pc:docMk/>
          <pc:sldMk cId="2515327059" sldId="302"/>
        </pc:sldMkLst>
      </pc:sldChg>
      <pc:sldChg chg="addSp modSp mod">
        <pc:chgData name="Filippo Acconcia" userId="844af49c-a8a0-47ac-a7dd-14a44b60cd18" providerId="ADAL" clId="{F95F0201-6B3C-479C-9473-CC4C485F19A1}" dt="2022-08-01T07:01:12.004" v="1237" actId="164"/>
        <pc:sldMkLst>
          <pc:docMk/>
          <pc:sldMk cId="371560362" sldId="303"/>
        </pc:sldMkLst>
        <pc:spChg chg="mod">
          <ac:chgData name="Filippo Acconcia" userId="844af49c-a8a0-47ac-a7dd-14a44b60cd18" providerId="ADAL" clId="{F95F0201-6B3C-479C-9473-CC4C485F19A1}" dt="2022-07-30T06:35:10.009" v="19" actId="12788"/>
          <ac:spMkLst>
            <pc:docMk/>
            <pc:sldMk cId="371560362" sldId="303"/>
            <ac:spMk id="2" creationId="{BFD6BFD1-3D4E-35A7-1E9A-8043425ADD79}"/>
          </ac:spMkLst>
        </pc:spChg>
        <pc:spChg chg="add mod">
          <ac:chgData name="Filippo Acconcia" userId="844af49c-a8a0-47ac-a7dd-14a44b60cd18" providerId="ADAL" clId="{F95F0201-6B3C-479C-9473-CC4C485F19A1}" dt="2022-07-30T06:35:40.452" v="28" actId="1038"/>
          <ac:spMkLst>
            <pc:docMk/>
            <pc:sldMk cId="371560362" sldId="303"/>
            <ac:spMk id="50" creationId="{0E0B81DE-450D-F5EA-E35E-DEC4D45AAF7F}"/>
          </ac:spMkLst>
        </pc:spChg>
        <pc:spChg chg="add mod">
          <ac:chgData name="Filippo Acconcia" userId="844af49c-a8a0-47ac-a7dd-14a44b60cd18" providerId="ADAL" clId="{F95F0201-6B3C-479C-9473-CC4C485F19A1}" dt="2022-07-30T06:35:47.125" v="35" actId="1037"/>
          <ac:spMkLst>
            <pc:docMk/>
            <pc:sldMk cId="371560362" sldId="303"/>
            <ac:spMk id="51" creationId="{D65105B2-D63B-C863-901B-6C5DB63CFCB6}"/>
          </ac:spMkLst>
        </pc:spChg>
        <pc:spChg chg="add mod">
          <ac:chgData name="Filippo Acconcia" userId="844af49c-a8a0-47ac-a7dd-14a44b60cd18" providerId="ADAL" clId="{F95F0201-6B3C-479C-9473-CC4C485F19A1}" dt="2022-08-01T07:00:16.206" v="1210" actId="164"/>
          <ac:spMkLst>
            <pc:docMk/>
            <pc:sldMk cId="371560362" sldId="303"/>
            <ac:spMk id="52" creationId="{74429B4B-8440-93C5-7FB3-CEB389A9383D}"/>
          </ac:spMkLst>
        </pc:spChg>
        <pc:spChg chg="add mod">
          <ac:chgData name="Filippo Acconcia" userId="844af49c-a8a0-47ac-a7dd-14a44b60cd18" providerId="ADAL" clId="{F95F0201-6B3C-479C-9473-CC4C485F19A1}" dt="2022-08-01T07:00:16.206" v="1210" actId="164"/>
          <ac:spMkLst>
            <pc:docMk/>
            <pc:sldMk cId="371560362" sldId="303"/>
            <ac:spMk id="53" creationId="{81AD984E-17B4-C477-836F-9AC80E59738B}"/>
          </ac:spMkLst>
        </pc:spChg>
        <pc:spChg chg="add mod">
          <ac:chgData name="Filippo Acconcia" userId="844af49c-a8a0-47ac-a7dd-14a44b60cd18" providerId="ADAL" clId="{F95F0201-6B3C-479C-9473-CC4C485F19A1}" dt="2022-08-01T07:00:16.206" v="1210" actId="164"/>
          <ac:spMkLst>
            <pc:docMk/>
            <pc:sldMk cId="371560362" sldId="303"/>
            <ac:spMk id="54" creationId="{912BDF3F-3B53-EE34-D6DD-C189A25F9B48}"/>
          </ac:spMkLst>
        </pc:spChg>
        <pc:spChg chg="add mod">
          <ac:chgData name="Filippo Acconcia" userId="844af49c-a8a0-47ac-a7dd-14a44b60cd18" providerId="ADAL" clId="{F95F0201-6B3C-479C-9473-CC4C485F19A1}" dt="2022-08-01T07:01:12.004" v="1237" actId="164"/>
          <ac:spMkLst>
            <pc:docMk/>
            <pc:sldMk cId="371560362" sldId="303"/>
            <ac:spMk id="55" creationId="{DC114B67-5341-846A-C5C8-A8AB4E8574B7}"/>
          </ac:spMkLst>
        </pc:spChg>
        <pc:spChg chg="add mod">
          <ac:chgData name="Filippo Acconcia" userId="844af49c-a8a0-47ac-a7dd-14a44b60cd18" providerId="ADAL" clId="{F95F0201-6B3C-479C-9473-CC4C485F19A1}" dt="2022-08-01T07:01:12.004" v="1237" actId="164"/>
          <ac:spMkLst>
            <pc:docMk/>
            <pc:sldMk cId="371560362" sldId="303"/>
            <ac:spMk id="56" creationId="{69726699-FCD4-636B-819D-6340F5831230}"/>
          </ac:spMkLst>
        </pc:spChg>
        <pc:spChg chg="add mod">
          <ac:chgData name="Filippo Acconcia" userId="844af49c-a8a0-47ac-a7dd-14a44b60cd18" providerId="ADAL" clId="{F95F0201-6B3C-479C-9473-CC4C485F19A1}" dt="2022-08-01T07:01:12.004" v="1237" actId="164"/>
          <ac:spMkLst>
            <pc:docMk/>
            <pc:sldMk cId="371560362" sldId="303"/>
            <ac:spMk id="57" creationId="{9887D3B5-EA77-5424-8C55-7B10B9B3F5CC}"/>
          </ac:spMkLst>
        </pc:spChg>
        <pc:grpChg chg="add mod">
          <ac:chgData name="Filippo Acconcia" userId="844af49c-a8a0-47ac-a7dd-14a44b60cd18" providerId="ADAL" clId="{F95F0201-6B3C-479C-9473-CC4C485F19A1}" dt="2022-08-01T07:00:16.206" v="1210" actId="164"/>
          <ac:grpSpMkLst>
            <pc:docMk/>
            <pc:sldMk cId="371560362" sldId="303"/>
            <ac:grpSpMk id="3" creationId="{0F2ACBBC-E116-803E-AA50-7F515E1F7507}"/>
          </ac:grpSpMkLst>
        </pc:grpChg>
        <pc:grpChg chg="add mod">
          <ac:chgData name="Filippo Acconcia" userId="844af49c-a8a0-47ac-a7dd-14a44b60cd18" providerId="ADAL" clId="{F95F0201-6B3C-479C-9473-CC4C485F19A1}" dt="2022-08-01T07:01:12.004" v="1237" actId="164"/>
          <ac:grpSpMkLst>
            <pc:docMk/>
            <pc:sldMk cId="371560362" sldId="303"/>
            <ac:grpSpMk id="4" creationId="{32C6D7C6-26BE-9B1F-00A1-B51CF80FE24B}"/>
          </ac:grpSpMkLst>
        </pc:grpChg>
        <pc:grpChg chg="mod">
          <ac:chgData name="Filippo Acconcia" userId="844af49c-a8a0-47ac-a7dd-14a44b60cd18" providerId="ADAL" clId="{F95F0201-6B3C-479C-9473-CC4C485F19A1}" dt="2022-08-01T07:00:16.206" v="1210" actId="164"/>
          <ac:grpSpMkLst>
            <pc:docMk/>
            <pc:sldMk cId="371560362" sldId="303"/>
            <ac:grpSpMk id="25" creationId="{DA0DA6EC-6138-78E1-86AD-890037E86759}"/>
          </ac:grpSpMkLst>
        </pc:grpChg>
        <pc:grpChg chg="mod">
          <ac:chgData name="Filippo Acconcia" userId="844af49c-a8a0-47ac-a7dd-14a44b60cd18" providerId="ADAL" clId="{F95F0201-6B3C-479C-9473-CC4C485F19A1}" dt="2022-08-01T07:01:12.004" v="1237" actId="164"/>
          <ac:grpSpMkLst>
            <pc:docMk/>
            <pc:sldMk cId="371560362" sldId="303"/>
            <ac:grpSpMk id="37" creationId="{68488E12-958F-9D95-24C4-0C4DD20BF883}"/>
          </ac:grpSpMkLst>
        </pc:grpChg>
      </pc:sldChg>
      <pc:sldChg chg="del">
        <pc:chgData name="Filippo Acconcia" userId="844af49c-a8a0-47ac-a7dd-14a44b60cd18" providerId="ADAL" clId="{F95F0201-6B3C-479C-9473-CC4C485F19A1}" dt="2022-07-30T06:36:01.328" v="39" actId="47"/>
        <pc:sldMkLst>
          <pc:docMk/>
          <pc:sldMk cId="2074646068" sldId="304"/>
        </pc:sldMkLst>
      </pc:sldChg>
      <pc:sldChg chg="del">
        <pc:chgData name="Filippo Acconcia" userId="844af49c-a8a0-47ac-a7dd-14a44b60cd18" providerId="ADAL" clId="{F95F0201-6B3C-479C-9473-CC4C485F19A1}" dt="2022-07-30T06:36:01.865" v="40" actId="47"/>
        <pc:sldMkLst>
          <pc:docMk/>
          <pc:sldMk cId="3592222437" sldId="305"/>
        </pc:sldMkLst>
      </pc:sldChg>
      <pc:sldChg chg="addSp delSp modSp mod">
        <pc:chgData name="Filippo Acconcia" userId="844af49c-a8a0-47ac-a7dd-14a44b60cd18" providerId="ADAL" clId="{F95F0201-6B3C-479C-9473-CC4C485F19A1}" dt="2022-08-01T07:29:47.040" v="1769" actId="164"/>
        <pc:sldMkLst>
          <pc:docMk/>
          <pc:sldMk cId="2872089465" sldId="306"/>
        </pc:sldMkLst>
        <pc:spChg chg="del">
          <ac:chgData name="Filippo Acconcia" userId="844af49c-a8a0-47ac-a7dd-14a44b60cd18" providerId="ADAL" clId="{F95F0201-6B3C-479C-9473-CC4C485F19A1}" dt="2022-07-30T09:51:47.826" v="147" actId="478"/>
          <ac:spMkLst>
            <pc:docMk/>
            <pc:sldMk cId="2872089465" sldId="306"/>
            <ac:spMk id="104" creationId="{BD175017-E89B-B361-41D8-0000D0D83CA6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57" creationId="{AA4361D6-8C73-FC12-7963-AE9A8E0DF535}"/>
          </ac:spMkLst>
        </pc:spChg>
        <pc:spChg chg="add del mod">
          <ac:chgData name="Filippo Acconcia" userId="844af49c-a8a0-47ac-a7dd-14a44b60cd18" providerId="ADAL" clId="{F95F0201-6B3C-479C-9473-CC4C485F19A1}" dt="2022-07-30T09:51:50.368" v="148" actId="478"/>
          <ac:spMkLst>
            <pc:docMk/>
            <pc:sldMk cId="2872089465" sldId="306"/>
            <ac:spMk id="157" creationId="{DB9BD6E6-045F-B1E6-3EC3-7A14071C464F}"/>
          </ac:spMkLst>
        </pc:spChg>
        <pc:spChg chg="add mod">
          <ac:chgData name="Filippo Acconcia" userId="844af49c-a8a0-47ac-a7dd-14a44b60cd18" providerId="ADAL" clId="{F95F0201-6B3C-479C-9473-CC4C485F19A1}" dt="2022-07-30T09:51:56.160" v="150" actId="20577"/>
          <ac:spMkLst>
            <pc:docMk/>
            <pc:sldMk cId="2872089465" sldId="306"/>
            <ac:spMk id="158" creationId="{64C87A1B-968C-036D-0268-9B6A7784BA52}"/>
          </ac:spMkLst>
        </pc:spChg>
        <pc:spChg chg="add mod">
          <ac:chgData name="Filippo Acconcia" userId="844af49c-a8a0-47ac-a7dd-14a44b60cd18" providerId="ADAL" clId="{F95F0201-6B3C-479C-9473-CC4C485F19A1}" dt="2022-07-30T09:55:08.641" v="518" actId="1037"/>
          <ac:spMkLst>
            <pc:docMk/>
            <pc:sldMk cId="2872089465" sldId="306"/>
            <ac:spMk id="159" creationId="{E11C2CA5-10D7-FC4A-0F1D-A63F3A4AB720}"/>
          </ac:spMkLst>
        </pc:spChg>
        <pc:spChg chg="add mod">
          <ac:chgData name="Filippo Acconcia" userId="844af49c-a8a0-47ac-a7dd-14a44b60cd18" providerId="ADAL" clId="{F95F0201-6B3C-479C-9473-CC4C485F19A1}" dt="2022-07-30T09:55:00.438" v="515" actId="12788"/>
          <ac:spMkLst>
            <pc:docMk/>
            <pc:sldMk cId="2872089465" sldId="306"/>
            <ac:spMk id="160" creationId="{2B758461-EF77-4FA0-09C8-358155873DA3}"/>
          </ac:spMkLst>
        </pc:spChg>
        <pc:spChg chg="add mod">
          <ac:chgData name="Filippo Acconcia" userId="844af49c-a8a0-47ac-a7dd-14a44b60cd18" providerId="ADAL" clId="{F95F0201-6B3C-479C-9473-CC4C485F19A1}" dt="2022-07-30T09:54:18.148" v="357" actId="554"/>
          <ac:spMkLst>
            <pc:docMk/>
            <pc:sldMk cId="2872089465" sldId="306"/>
            <ac:spMk id="161" creationId="{C17DF0D6-4F62-8443-944F-B5FC4E409780}"/>
          </ac:spMkLst>
        </pc:spChg>
        <pc:spChg chg="add mod">
          <ac:chgData name="Filippo Acconcia" userId="844af49c-a8a0-47ac-a7dd-14a44b60cd18" providerId="ADAL" clId="{F95F0201-6B3C-479C-9473-CC4C485F19A1}" dt="2022-07-30T09:54:18.148" v="357" actId="554"/>
          <ac:spMkLst>
            <pc:docMk/>
            <pc:sldMk cId="2872089465" sldId="306"/>
            <ac:spMk id="162" creationId="{0E4588E4-57A3-7C46-954F-4E33C786B610}"/>
          </ac:spMkLst>
        </pc:spChg>
        <pc:spChg chg="add mod">
          <ac:chgData name="Filippo Acconcia" userId="844af49c-a8a0-47ac-a7dd-14a44b60cd18" providerId="ADAL" clId="{F95F0201-6B3C-479C-9473-CC4C485F19A1}" dt="2022-07-30T09:54:18.148" v="357" actId="554"/>
          <ac:spMkLst>
            <pc:docMk/>
            <pc:sldMk cId="2872089465" sldId="306"/>
            <ac:spMk id="163" creationId="{65DE1AD6-4E12-9DC9-BEC1-0BB4F32BF1A2}"/>
          </ac:spMkLst>
        </pc:spChg>
        <pc:spChg chg="add del mod">
          <ac:chgData name="Filippo Acconcia" userId="844af49c-a8a0-47ac-a7dd-14a44b60cd18" providerId="ADAL" clId="{F95F0201-6B3C-479C-9473-CC4C485F19A1}" dt="2022-07-30T09:54:22.225" v="359" actId="478"/>
          <ac:spMkLst>
            <pc:docMk/>
            <pc:sldMk cId="2872089465" sldId="306"/>
            <ac:spMk id="164" creationId="{3691D852-D431-21DF-9072-EAD9378DBE6E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64" creationId="{7030109A-1EE3-5708-015E-F895CE68DEEB}"/>
          </ac:spMkLst>
        </pc:spChg>
        <pc:spChg chg="add mod">
          <ac:chgData name="Filippo Acconcia" userId="844af49c-a8a0-47ac-a7dd-14a44b60cd18" providerId="ADAL" clId="{F95F0201-6B3C-479C-9473-CC4C485F19A1}" dt="2022-07-30T09:55:08.641" v="518" actId="1037"/>
          <ac:spMkLst>
            <pc:docMk/>
            <pc:sldMk cId="2872089465" sldId="306"/>
            <ac:spMk id="165" creationId="{7335B171-C705-2AB6-4619-FD8E85690C0B}"/>
          </ac:spMkLst>
        </pc:spChg>
        <pc:spChg chg="add mod">
          <ac:chgData name="Filippo Acconcia" userId="844af49c-a8a0-47ac-a7dd-14a44b60cd18" providerId="ADAL" clId="{F95F0201-6B3C-479C-9473-CC4C485F19A1}" dt="2022-07-30T09:55:00.438" v="515" actId="12788"/>
          <ac:spMkLst>
            <pc:docMk/>
            <pc:sldMk cId="2872089465" sldId="306"/>
            <ac:spMk id="166" creationId="{F9BFE31A-60D4-A916-0AA3-D45441A66596}"/>
          </ac:spMkLst>
        </pc:spChg>
        <pc:spChg chg="add mod">
          <ac:chgData name="Filippo Acconcia" userId="844af49c-a8a0-47ac-a7dd-14a44b60cd18" providerId="ADAL" clId="{F95F0201-6B3C-479C-9473-CC4C485F19A1}" dt="2022-07-30T09:55:08.641" v="518" actId="1037"/>
          <ac:spMkLst>
            <pc:docMk/>
            <pc:sldMk cId="2872089465" sldId="306"/>
            <ac:spMk id="167" creationId="{9D9E3D6C-04F7-1F65-5F91-C11202728B70}"/>
          </ac:spMkLst>
        </pc:spChg>
        <pc:spChg chg="add mod">
          <ac:chgData name="Filippo Acconcia" userId="844af49c-a8a0-47ac-a7dd-14a44b60cd18" providerId="ADAL" clId="{F95F0201-6B3C-479C-9473-CC4C485F19A1}" dt="2022-07-30T09:55:00.438" v="515" actId="12788"/>
          <ac:spMkLst>
            <pc:docMk/>
            <pc:sldMk cId="2872089465" sldId="306"/>
            <ac:spMk id="168" creationId="{D094C953-4EAC-EA93-8FBB-B3B5A58F3F54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69" creationId="{5EC5C797-850E-A53A-4A8E-D4BA8CAD9136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70" creationId="{4F41EEB1-EEE2-61DA-B115-1D6B4EF254BF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71" creationId="{113A81E0-FBEB-64DA-8FA5-1B36AAAF181F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72" creationId="{CB361518-300E-662A-ACD2-570EE64C2B1A}"/>
          </ac:spMkLst>
        </pc:spChg>
        <pc:spChg chg="add mod">
          <ac:chgData name="Filippo Acconcia" userId="844af49c-a8a0-47ac-a7dd-14a44b60cd18" providerId="ADAL" clId="{F95F0201-6B3C-479C-9473-CC4C485F19A1}" dt="2022-08-01T07:03:58.421" v="1310" actId="164"/>
          <ac:spMkLst>
            <pc:docMk/>
            <pc:sldMk cId="2872089465" sldId="306"/>
            <ac:spMk id="173" creationId="{2C02AF4A-9D97-ADD5-D83E-58A2F5636E28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4" creationId="{EE433E3C-9431-53A1-9E95-2FAF0EFEC5A7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5" creationId="{19B73D97-25C5-DDD7-6CD6-921134EF3F48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6" creationId="{4FBA3FCA-9927-D165-EF19-EF2468F8CA8B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7" creationId="{9816F464-DABC-8DBB-949F-45D2028DECCC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8" creationId="{BF1790D3-A0F9-6307-AE2C-4849B97FD971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79" creationId="{78A4BB4B-7E38-4508-F1DD-98E4BAD76041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80" creationId="{E5C6C19B-43C3-7D81-D608-3853F6F5F0C1}"/>
          </ac:spMkLst>
        </pc:spChg>
        <pc:spChg chg="add mod">
          <ac:chgData name="Filippo Acconcia" userId="844af49c-a8a0-47ac-a7dd-14a44b60cd18" providerId="ADAL" clId="{F95F0201-6B3C-479C-9473-CC4C485F19A1}" dt="2022-08-01T07:17:13.540" v="1378" actId="164"/>
          <ac:spMkLst>
            <pc:docMk/>
            <pc:sldMk cId="2872089465" sldId="306"/>
            <ac:spMk id="181" creationId="{F401DAB6-630F-F565-DF1A-1FD016D56E49}"/>
          </ac:spMkLst>
        </pc:spChg>
        <pc:spChg chg="add mod">
          <ac:chgData name="Filippo Acconcia" userId="844af49c-a8a0-47ac-a7dd-14a44b60cd18" providerId="ADAL" clId="{F95F0201-6B3C-479C-9473-CC4C485F19A1}" dt="2022-08-01T07:19:34.891" v="1395" actId="164"/>
          <ac:spMkLst>
            <pc:docMk/>
            <pc:sldMk cId="2872089465" sldId="306"/>
            <ac:spMk id="182" creationId="{CA592A86-A466-2550-D461-43029AA22878}"/>
          </ac:spMkLst>
        </pc:spChg>
        <pc:spChg chg="add mod">
          <ac:chgData name="Filippo Acconcia" userId="844af49c-a8a0-47ac-a7dd-14a44b60cd18" providerId="ADAL" clId="{F95F0201-6B3C-479C-9473-CC4C485F19A1}" dt="2022-08-01T07:19:34.891" v="1395" actId="164"/>
          <ac:spMkLst>
            <pc:docMk/>
            <pc:sldMk cId="2872089465" sldId="306"/>
            <ac:spMk id="183" creationId="{54486052-8190-07D7-7845-90E8D9D6131C}"/>
          </ac:spMkLst>
        </pc:spChg>
        <pc:spChg chg="add mod">
          <ac:chgData name="Filippo Acconcia" userId="844af49c-a8a0-47ac-a7dd-14a44b60cd18" providerId="ADAL" clId="{F95F0201-6B3C-479C-9473-CC4C485F19A1}" dt="2022-08-01T07:19:34.891" v="1395" actId="164"/>
          <ac:spMkLst>
            <pc:docMk/>
            <pc:sldMk cId="2872089465" sldId="306"/>
            <ac:spMk id="184" creationId="{EB22C0B8-0426-A27A-A940-4014CE96F617}"/>
          </ac:spMkLst>
        </pc:spChg>
        <pc:spChg chg="add mod">
          <ac:chgData name="Filippo Acconcia" userId="844af49c-a8a0-47ac-a7dd-14a44b60cd18" providerId="ADAL" clId="{F95F0201-6B3C-479C-9473-CC4C485F19A1}" dt="2022-08-01T07:19:34.891" v="1395" actId="164"/>
          <ac:spMkLst>
            <pc:docMk/>
            <pc:sldMk cId="2872089465" sldId="306"/>
            <ac:spMk id="185" creationId="{BF16472F-AC69-4A36-3302-EE4ABF174EFA}"/>
          </ac:spMkLst>
        </pc:spChg>
        <pc:spChg chg="add mod">
          <ac:chgData name="Filippo Acconcia" userId="844af49c-a8a0-47ac-a7dd-14a44b60cd18" providerId="ADAL" clId="{F95F0201-6B3C-479C-9473-CC4C485F19A1}" dt="2022-08-01T07:19:34.891" v="1395" actId="164"/>
          <ac:spMkLst>
            <pc:docMk/>
            <pc:sldMk cId="2872089465" sldId="306"/>
            <ac:spMk id="186" creationId="{C8D3ACF6-5869-7C02-902B-DDE9BA66DC1C}"/>
          </ac:spMkLst>
        </pc:spChg>
        <pc:spChg chg="add mod">
          <ac:chgData name="Filippo Acconcia" userId="844af49c-a8a0-47ac-a7dd-14a44b60cd18" providerId="ADAL" clId="{F95F0201-6B3C-479C-9473-CC4C485F19A1}" dt="2022-08-01T07:21:23.724" v="1444" actId="164"/>
          <ac:spMkLst>
            <pc:docMk/>
            <pc:sldMk cId="2872089465" sldId="306"/>
            <ac:spMk id="187" creationId="{1152D2B2-8BE4-8B75-3C8F-9AE08C51AA0B}"/>
          </ac:spMkLst>
        </pc:spChg>
        <pc:spChg chg="add mod">
          <ac:chgData name="Filippo Acconcia" userId="844af49c-a8a0-47ac-a7dd-14a44b60cd18" providerId="ADAL" clId="{F95F0201-6B3C-479C-9473-CC4C485F19A1}" dt="2022-08-01T07:21:23.724" v="1444" actId="164"/>
          <ac:spMkLst>
            <pc:docMk/>
            <pc:sldMk cId="2872089465" sldId="306"/>
            <ac:spMk id="188" creationId="{745AFCEC-EDA8-8F06-7D95-3F03E60D3DC0}"/>
          </ac:spMkLst>
        </pc:spChg>
        <pc:spChg chg="add mod">
          <ac:chgData name="Filippo Acconcia" userId="844af49c-a8a0-47ac-a7dd-14a44b60cd18" providerId="ADAL" clId="{F95F0201-6B3C-479C-9473-CC4C485F19A1}" dt="2022-08-01T07:21:23.724" v="1444" actId="164"/>
          <ac:spMkLst>
            <pc:docMk/>
            <pc:sldMk cId="2872089465" sldId="306"/>
            <ac:spMk id="189" creationId="{BF7F8073-6C51-A8D3-983D-55E375D734DB}"/>
          </ac:spMkLst>
        </pc:spChg>
        <pc:spChg chg="add mod">
          <ac:chgData name="Filippo Acconcia" userId="844af49c-a8a0-47ac-a7dd-14a44b60cd18" providerId="ADAL" clId="{F95F0201-6B3C-479C-9473-CC4C485F19A1}" dt="2022-08-01T07:21:23.724" v="1444" actId="164"/>
          <ac:spMkLst>
            <pc:docMk/>
            <pc:sldMk cId="2872089465" sldId="306"/>
            <ac:spMk id="190" creationId="{4D91EF8C-FEEF-AD77-268B-27949009F328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1" creationId="{D237AB70-141A-B17E-896B-FA483EBBBDDA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2" creationId="{AAF22751-E142-5272-C26A-142F53D1E86E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3" creationId="{3404E098-D439-5309-A861-B67CF12C8964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4" creationId="{379B2AC4-BE99-1733-4CCB-2A248621A624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5" creationId="{373B8C65-9E2B-25B2-A523-9279DE3CBB9B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6" creationId="{1AF3BEB0-6EF6-E092-0FFC-F2267E01EE85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7" creationId="{CBEB5537-FC20-C05D-9BC4-E4F93D1D6093}"/>
          </ac:spMkLst>
        </pc:spChg>
        <pc:spChg chg="add mod">
          <ac:chgData name="Filippo Acconcia" userId="844af49c-a8a0-47ac-a7dd-14a44b60cd18" providerId="ADAL" clId="{F95F0201-6B3C-479C-9473-CC4C485F19A1}" dt="2022-08-01T07:24:39.647" v="1676" actId="164"/>
          <ac:spMkLst>
            <pc:docMk/>
            <pc:sldMk cId="2872089465" sldId="306"/>
            <ac:spMk id="198" creationId="{60AEA678-B86A-3945-E4CB-755D1DD7BDDC}"/>
          </ac:spMkLst>
        </pc:spChg>
        <pc:spChg chg="add mod">
          <ac:chgData name="Filippo Acconcia" userId="844af49c-a8a0-47ac-a7dd-14a44b60cd18" providerId="ADAL" clId="{F95F0201-6B3C-479C-9473-CC4C485F19A1}" dt="2022-08-01T07:26:30.172" v="1700" actId="164"/>
          <ac:spMkLst>
            <pc:docMk/>
            <pc:sldMk cId="2872089465" sldId="306"/>
            <ac:spMk id="199" creationId="{36EE16C7-9605-7964-8A32-403F3630653E}"/>
          </ac:spMkLst>
        </pc:spChg>
        <pc:spChg chg="add mod">
          <ac:chgData name="Filippo Acconcia" userId="844af49c-a8a0-47ac-a7dd-14a44b60cd18" providerId="ADAL" clId="{F95F0201-6B3C-479C-9473-CC4C485F19A1}" dt="2022-08-01T07:26:30.172" v="1700" actId="164"/>
          <ac:spMkLst>
            <pc:docMk/>
            <pc:sldMk cId="2872089465" sldId="306"/>
            <ac:spMk id="200" creationId="{2C9A0CB1-25BA-5221-493B-6B9F5C9F57AE}"/>
          </ac:spMkLst>
        </pc:spChg>
        <pc:spChg chg="add mod">
          <ac:chgData name="Filippo Acconcia" userId="844af49c-a8a0-47ac-a7dd-14a44b60cd18" providerId="ADAL" clId="{F95F0201-6B3C-479C-9473-CC4C485F19A1}" dt="2022-08-01T07:27:54.446" v="1740" actId="164"/>
          <ac:spMkLst>
            <pc:docMk/>
            <pc:sldMk cId="2872089465" sldId="306"/>
            <ac:spMk id="201" creationId="{A28BDCB5-4302-D3F4-C592-68749F5057E1}"/>
          </ac:spMkLst>
        </pc:spChg>
        <pc:spChg chg="add mod">
          <ac:chgData name="Filippo Acconcia" userId="844af49c-a8a0-47ac-a7dd-14a44b60cd18" providerId="ADAL" clId="{F95F0201-6B3C-479C-9473-CC4C485F19A1}" dt="2022-08-01T07:27:54.446" v="1740" actId="164"/>
          <ac:spMkLst>
            <pc:docMk/>
            <pc:sldMk cId="2872089465" sldId="306"/>
            <ac:spMk id="202" creationId="{9EE7B063-F8D3-CC15-96F2-265DF4F40D13}"/>
          </ac:spMkLst>
        </pc:spChg>
        <pc:spChg chg="add mod">
          <ac:chgData name="Filippo Acconcia" userId="844af49c-a8a0-47ac-a7dd-14a44b60cd18" providerId="ADAL" clId="{F95F0201-6B3C-479C-9473-CC4C485F19A1}" dt="2022-08-01T07:27:54.446" v="1740" actId="164"/>
          <ac:spMkLst>
            <pc:docMk/>
            <pc:sldMk cId="2872089465" sldId="306"/>
            <ac:spMk id="203" creationId="{B272F1FE-4E18-ED6D-1A7D-9F701ABD3536}"/>
          </ac:spMkLst>
        </pc:spChg>
        <pc:spChg chg="add mod">
          <ac:chgData name="Filippo Acconcia" userId="844af49c-a8a0-47ac-a7dd-14a44b60cd18" providerId="ADAL" clId="{F95F0201-6B3C-479C-9473-CC4C485F19A1}" dt="2022-08-01T07:27:54.446" v="1740" actId="164"/>
          <ac:spMkLst>
            <pc:docMk/>
            <pc:sldMk cId="2872089465" sldId="306"/>
            <ac:spMk id="204" creationId="{2582B475-1B9F-706F-262F-54FB84EACD04}"/>
          </ac:spMkLst>
        </pc:spChg>
        <pc:spChg chg="add mod">
          <ac:chgData name="Filippo Acconcia" userId="844af49c-a8a0-47ac-a7dd-14a44b60cd18" providerId="ADAL" clId="{F95F0201-6B3C-479C-9473-CC4C485F19A1}" dt="2022-08-01T07:29:47.040" v="1769" actId="164"/>
          <ac:spMkLst>
            <pc:docMk/>
            <pc:sldMk cId="2872089465" sldId="306"/>
            <ac:spMk id="205" creationId="{DFA37A46-CD4B-AA9A-45DB-9F69209A776F}"/>
          </ac:spMkLst>
        </pc:spChg>
        <pc:spChg chg="add mod">
          <ac:chgData name="Filippo Acconcia" userId="844af49c-a8a0-47ac-a7dd-14a44b60cd18" providerId="ADAL" clId="{F95F0201-6B3C-479C-9473-CC4C485F19A1}" dt="2022-08-01T07:29:47.040" v="1769" actId="164"/>
          <ac:spMkLst>
            <pc:docMk/>
            <pc:sldMk cId="2872089465" sldId="306"/>
            <ac:spMk id="206" creationId="{7D8C0CB2-19CA-3DB4-C236-01B51255A6B1}"/>
          </ac:spMkLst>
        </pc:spChg>
        <pc:spChg chg="add mod">
          <ac:chgData name="Filippo Acconcia" userId="844af49c-a8a0-47ac-a7dd-14a44b60cd18" providerId="ADAL" clId="{F95F0201-6B3C-479C-9473-CC4C485F19A1}" dt="2022-08-01T07:29:39.552" v="1768" actId="164"/>
          <ac:spMkLst>
            <pc:docMk/>
            <pc:sldMk cId="2872089465" sldId="306"/>
            <ac:spMk id="207" creationId="{9F89EC4B-80B7-8270-58D7-3AAD915EC7EE}"/>
          </ac:spMkLst>
        </pc:spChg>
        <pc:spChg chg="add mod">
          <ac:chgData name="Filippo Acconcia" userId="844af49c-a8a0-47ac-a7dd-14a44b60cd18" providerId="ADAL" clId="{F95F0201-6B3C-479C-9473-CC4C485F19A1}" dt="2022-08-01T07:29:39.552" v="1768" actId="164"/>
          <ac:spMkLst>
            <pc:docMk/>
            <pc:sldMk cId="2872089465" sldId="306"/>
            <ac:spMk id="208" creationId="{B1741483-E9FA-E30E-81D4-E927C96EB51C}"/>
          </ac:spMkLst>
        </pc:spChg>
        <pc:grpChg chg="mod">
          <ac:chgData name="Filippo Acconcia" userId="844af49c-a8a0-47ac-a7dd-14a44b60cd18" providerId="ADAL" clId="{F95F0201-6B3C-479C-9473-CC4C485F19A1}" dt="2022-08-01T07:03:58.421" v="1310" actId="164"/>
          <ac:grpSpMkLst>
            <pc:docMk/>
            <pc:sldMk cId="2872089465" sldId="306"/>
            <ac:grpSpMk id="2" creationId="{3B354346-6EAE-8047-2081-759A7D74FA00}"/>
          </ac:grpSpMkLst>
        </pc:grpChg>
        <pc:grpChg chg="mod">
          <ac:chgData name="Filippo Acconcia" userId="844af49c-a8a0-47ac-a7dd-14a44b60cd18" providerId="ADAL" clId="{F95F0201-6B3C-479C-9473-CC4C485F19A1}" dt="2022-08-01T07:17:13.540" v="1378" actId="164"/>
          <ac:grpSpMkLst>
            <pc:docMk/>
            <pc:sldMk cId="2872089465" sldId="306"/>
            <ac:grpSpMk id="19" creationId="{54C4EDFE-2C47-2663-C4A3-E84F9D14A153}"/>
          </ac:grpSpMkLst>
        </pc:grpChg>
        <pc:grpChg chg="mod">
          <ac:chgData name="Filippo Acconcia" userId="844af49c-a8a0-47ac-a7dd-14a44b60cd18" providerId="ADAL" clId="{F95F0201-6B3C-479C-9473-CC4C485F19A1}" dt="2022-08-01T07:24:39.647" v="1676" actId="164"/>
          <ac:grpSpMkLst>
            <pc:docMk/>
            <pc:sldMk cId="2872089465" sldId="306"/>
            <ac:grpSpMk id="36" creationId="{4CCBCED7-1CC4-1B0F-186E-9A01450CD7EF}"/>
          </ac:grpSpMkLst>
        </pc:grpChg>
        <pc:grpChg chg="add mod">
          <ac:chgData name="Filippo Acconcia" userId="844af49c-a8a0-47ac-a7dd-14a44b60cd18" providerId="ADAL" clId="{F95F0201-6B3C-479C-9473-CC4C485F19A1}" dt="2022-08-01T07:03:58.421" v="1310" actId="164"/>
          <ac:grpSpMkLst>
            <pc:docMk/>
            <pc:sldMk cId="2872089465" sldId="306"/>
            <ac:grpSpMk id="53" creationId="{4CFB67A6-3658-BDD7-AB0B-03722173DF47}"/>
          </ac:grpSpMkLst>
        </pc:grpChg>
        <pc:grpChg chg="del mod">
          <ac:chgData name="Filippo Acconcia" userId="844af49c-a8a0-47ac-a7dd-14a44b60cd18" providerId="ADAL" clId="{F95F0201-6B3C-479C-9473-CC4C485F19A1}" dt="2022-07-30T09:52:50.161" v="187" actId="478"/>
          <ac:grpSpMkLst>
            <pc:docMk/>
            <pc:sldMk cId="2872089465" sldId="306"/>
            <ac:grpSpMk id="53" creationId="{C3448AB6-317E-F27D-E5F4-4BAAE542C77C}"/>
          </ac:grpSpMkLst>
        </pc:grpChg>
        <pc:grpChg chg="add mod">
          <ac:chgData name="Filippo Acconcia" userId="844af49c-a8a0-47ac-a7dd-14a44b60cd18" providerId="ADAL" clId="{F95F0201-6B3C-479C-9473-CC4C485F19A1}" dt="2022-08-01T07:17:13.540" v="1378" actId="164"/>
          <ac:grpSpMkLst>
            <pc:docMk/>
            <pc:sldMk cId="2872089465" sldId="306"/>
            <ac:grpSpMk id="54" creationId="{468B3F36-5B1D-5381-ECB5-46E172C3AC9D}"/>
          </ac:grpSpMkLst>
        </pc:grpChg>
        <pc:grpChg chg="add mod">
          <ac:chgData name="Filippo Acconcia" userId="844af49c-a8a0-47ac-a7dd-14a44b60cd18" providerId="ADAL" clId="{F95F0201-6B3C-479C-9473-CC4C485F19A1}" dt="2022-08-01T07:19:34.891" v="1395" actId="164"/>
          <ac:grpSpMkLst>
            <pc:docMk/>
            <pc:sldMk cId="2872089465" sldId="306"/>
            <ac:grpSpMk id="55" creationId="{5A06061E-351A-E4A8-B1B0-ED7362E878A8}"/>
          </ac:grpSpMkLst>
        </pc:grpChg>
        <pc:grpChg chg="add mod">
          <ac:chgData name="Filippo Acconcia" userId="844af49c-a8a0-47ac-a7dd-14a44b60cd18" providerId="ADAL" clId="{F95F0201-6B3C-479C-9473-CC4C485F19A1}" dt="2022-08-01T07:21:23.724" v="1444" actId="164"/>
          <ac:grpSpMkLst>
            <pc:docMk/>
            <pc:sldMk cId="2872089465" sldId="306"/>
            <ac:grpSpMk id="56" creationId="{47987D7A-24E1-107F-0CA4-2BEA609AA061}"/>
          </ac:grpSpMkLst>
        </pc:grpChg>
        <pc:grpChg chg="add mod">
          <ac:chgData name="Filippo Acconcia" userId="844af49c-a8a0-47ac-a7dd-14a44b60cd18" providerId="ADAL" clId="{F95F0201-6B3C-479C-9473-CC4C485F19A1}" dt="2022-08-01T07:24:39.647" v="1676" actId="164"/>
          <ac:grpSpMkLst>
            <pc:docMk/>
            <pc:sldMk cId="2872089465" sldId="306"/>
            <ac:grpSpMk id="57" creationId="{A0CBE48D-8E0F-B2B3-67EF-FE1E8396A586}"/>
          </ac:grpSpMkLst>
        </pc:grpChg>
        <pc:grpChg chg="add mod">
          <ac:chgData name="Filippo Acconcia" userId="844af49c-a8a0-47ac-a7dd-14a44b60cd18" providerId="ADAL" clId="{F95F0201-6B3C-479C-9473-CC4C485F19A1}" dt="2022-08-01T07:26:30.172" v="1700" actId="164"/>
          <ac:grpSpMkLst>
            <pc:docMk/>
            <pc:sldMk cId="2872089465" sldId="306"/>
            <ac:grpSpMk id="58" creationId="{57C0C524-383F-BCAB-4B53-F43E729E9D64}"/>
          </ac:grpSpMkLst>
        </pc:grpChg>
        <pc:grpChg chg="add mod">
          <ac:chgData name="Filippo Acconcia" userId="844af49c-a8a0-47ac-a7dd-14a44b60cd18" providerId="ADAL" clId="{F95F0201-6B3C-479C-9473-CC4C485F19A1}" dt="2022-08-01T07:27:54.446" v="1740" actId="164"/>
          <ac:grpSpMkLst>
            <pc:docMk/>
            <pc:sldMk cId="2872089465" sldId="306"/>
            <ac:grpSpMk id="59" creationId="{D013DCB4-B3E3-0209-9AC8-2EEEE5D11CDD}"/>
          </ac:grpSpMkLst>
        </pc:grpChg>
        <pc:grpChg chg="add mod">
          <ac:chgData name="Filippo Acconcia" userId="844af49c-a8a0-47ac-a7dd-14a44b60cd18" providerId="ADAL" clId="{F95F0201-6B3C-479C-9473-CC4C485F19A1}" dt="2022-08-01T07:29:39.552" v="1768" actId="164"/>
          <ac:grpSpMkLst>
            <pc:docMk/>
            <pc:sldMk cId="2872089465" sldId="306"/>
            <ac:grpSpMk id="60" creationId="{A3663AEC-36ED-9ADF-13D1-5FC592EB7C80}"/>
          </ac:grpSpMkLst>
        </pc:grpChg>
        <pc:grpChg chg="add mod">
          <ac:chgData name="Filippo Acconcia" userId="844af49c-a8a0-47ac-a7dd-14a44b60cd18" providerId="ADAL" clId="{F95F0201-6B3C-479C-9473-CC4C485F19A1}" dt="2022-08-01T07:29:47.040" v="1769" actId="164"/>
          <ac:grpSpMkLst>
            <pc:docMk/>
            <pc:sldMk cId="2872089465" sldId="306"/>
            <ac:grpSpMk id="61" creationId="{77C24B0F-E378-42A4-5481-77DEFF5DCFCB}"/>
          </ac:grpSpMkLst>
        </pc:grpChg>
        <pc:grpChg chg="mod">
          <ac:chgData name="Filippo Acconcia" userId="844af49c-a8a0-47ac-a7dd-14a44b60cd18" providerId="ADAL" clId="{F95F0201-6B3C-479C-9473-CC4C485F19A1}" dt="2022-08-01T07:19:34.891" v="1395" actId="164"/>
          <ac:grpSpMkLst>
            <pc:docMk/>
            <pc:sldMk cId="2872089465" sldId="306"/>
            <ac:grpSpMk id="70" creationId="{E2DD7F69-BAA9-C637-542E-CF9DF0870285}"/>
          </ac:grpSpMkLst>
        </pc:grpChg>
        <pc:grpChg chg="mod">
          <ac:chgData name="Filippo Acconcia" userId="844af49c-a8a0-47ac-a7dd-14a44b60cd18" providerId="ADAL" clId="{F95F0201-6B3C-479C-9473-CC4C485F19A1}" dt="2022-08-01T07:21:23.724" v="1444" actId="164"/>
          <ac:grpSpMkLst>
            <pc:docMk/>
            <pc:sldMk cId="2872089465" sldId="306"/>
            <ac:grpSpMk id="87" creationId="{CB5927FD-2CAA-343C-1004-D6CCA916567A}"/>
          </ac:grpSpMkLst>
        </pc:grpChg>
        <pc:grpChg chg="mod">
          <ac:chgData name="Filippo Acconcia" userId="844af49c-a8a0-47ac-a7dd-14a44b60cd18" providerId="ADAL" clId="{F95F0201-6B3C-479C-9473-CC4C485F19A1}" dt="2022-08-01T07:29:47.040" v="1769" actId="164"/>
          <ac:grpSpMkLst>
            <pc:docMk/>
            <pc:sldMk cId="2872089465" sldId="306"/>
            <ac:grpSpMk id="105" creationId="{1931345C-9B1F-8D64-DB71-3AB7D60C8ED0}"/>
          </ac:grpSpMkLst>
        </pc:grpChg>
        <pc:grpChg chg="mod">
          <ac:chgData name="Filippo Acconcia" userId="844af49c-a8a0-47ac-a7dd-14a44b60cd18" providerId="ADAL" clId="{F95F0201-6B3C-479C-9473-CC4C485F19A1}" dt="2022-08-01T07:29:39.552" v="1768" actId="164"/>
          <ac:grpSpMkLst>
            <pc:docMk/>
            <pc:sldMk cId="2872089465" sldId="306"/>
            <ac:grpSpMk id="118" creationId="{4B3D6DFD-CA45-9FDE-7A21-394691492E2B}"/>
          </ac:grpSpMkLst>
        </pc:grpChg>
        <pc:grpChg chg="mod">
          <ac:chgData name="Filippo Acconcia" userId="844af49c-a8a0-47ac-a7dd-14a44b60cd18" providerId="ADAL" clId="{F95F0201-6B3C-479C-9473-CC4C485F19A1}" dt="2022-08-01T07:26:30.172" v="1700" actId="164"/>
          <ac:grpSpMkLst>
            <pc:docMk/>
            <pc:sldMk cId="2872089465" sldId="306"/>
            <ac:grpSpMk id="131" creationId="{55BC3A1A-EDF6-044C-48FB-3A64CAA5891E}"/>
          </ac:grpSpMkLst>
        </pc:grpChg>
        <pc:grpChg chg="mod">
          <ac:chgData name="Filippo Acconcia" userId="844af49c-a8a0-47ac-a7dd-14a44b60cd18" providerId="ADAL" clId="{F95F0201-6B3C-479C-9473-CC4C485F19A1}" dt="2022-08-01T07:27:54.446" v="1740" actId="164"/>
          <ac:grpSpMkLst>
            <pc:docMk/>
            <pc:sldMk cId="2872089465" sldId="306"/>
            <ac:grpSpMk id="144" creationId="{7F4EC62F-19B7-5A24-B074-B1FE7DA16537}"/>
          </ac:grpSpMkLst>
        </pc:grpChg>
      </pc:sldChg>
      <pc:sldChg chg="del">
        <pc:chgData name="Filippo Acconcia" userId="844af49c-a8a0-47ac-a7dd-14a44b60cd18" providerId="ADAL" clId="{F95F0201-6B3C-479C-9473-CC4C485F19A1}" dt="2022-07-30T06:36:02.443" v="41" actId="47"/>
        <pc:sldMkLst>
          <pc:docMk/>
          <pc:sldMk cId="1457797328" sldId="307"/>
        </pc:sldMkLst>
      </pc:sldChg>
      <pc:sldChg chg="addSp delSp modSp mod">
        <pc:chgData name="Filippo Acconcia" userId="844af49c-a8a0-47ac-a7dd-14a44b60cd18" providerId="ADAL" clId="{F95F0201-6B3C-479C-9473-CC4C485F19A1}" dt="2022-08-01T07:33:34.497" v="1799" actId="164"/>
        <pc:sldMkLst>
          <pc:docMk/>
          <pc:sldMk cId="786280344" sldId="308"/>
        </pc:sldMkLst>
        <pc:spChg chg="mod">
          <ac:chgData name="Filippo Acconcia" userId="844af49c-a8a0-47ac-a7dd-14a44b60cd18" providerId="ADAL" clId="{F95F0201-6B3C-479C-9473-CC4C485F19A1}" dt="2022-08-01T07:30:04.209" v="1770" actId="1076"/>
          <ac:spMkLst>
            <pc:docMk/>
            <pc:sldMk cId="786280344" sldId="308"/>
            <ac:spMk id="4" creationId="{C9C3C577-9484-60D1-5463-7B07BAF228E7}"/>
          </ac:spMkLst>
        </pc:spChg>
        <pc:spChg chg="add mod">
          <ac:chgData name="Filippo Acconcia" userId="844af49c-a8a0-47ac-a7dd-14a44b60cd18" providerId="ADAL" clId="{F95F0201-6B3C-479C-9473-CC4C485F19A1}" dt="2022-07-30T12:00:50.526" v="522" actId="20577"/>
          <ac:spMkLst>
            <pc:docMk/>
            <pc:sldMk cId="786280344" sldId="308"/>
            <ac:spMk id="17" creationId="{91F886CC-E53A-736B-D7C2-F2157BF3B2DB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0" creationId="{32DCF4AE-BDF5-1551-2B77-F442B9B35A87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1" creationId="{016EF145-4AE7-89C1-17AF-A3201AD5D856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2" creationId="{83A9A9DF-6B45-D984-0F8C-0B57E04A75DA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3" creationId="{5D417451-FEB0-7EE6-057E-7D63BED1DB82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4" creationId="{C13E590F-398A-5707-36F0-4DF4A0B035CD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5" creationId="{4FAD96CE-F873-A000-F717-13AF84F8D8AC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6" creationId="{855F4F18-A4EA-F8AC-5978-9E99758854F4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7" creationId="{3231B69F-C68B-9D86-D4DB-E4EFCAE698D2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28" creationId="{239C68C3-CB17-FF63-E0EA-5811AC86480A}"/>
          </ac:spMkLst>
        </pc:spChg>
        <pc:spChg chg="del mod topLvl">
          <ac:chgData name="Filippo Acconcia" userId="844af49c-a8a0-47ac-a7dd-14a44b60cd18" providerId="ADAL" clId="{F95F0201-6B3C-479C-9473-CC4C485F19A1}" dt="2022-07-30T12:03:42.025" v="540" actId="478"/>
          <ac:spMkLst>
            <pc:docMk/>
            <pc:sldMk cId="786280344" sldId="308"/>
            <ac:spMk id="29" creationId="{AF230E60-36E6-9F74-29FE-A632576E3F3E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30" creationId="{4F27DBE9-16C5-A86F-E448-B820EB1564A0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33" creationId="{1FCCD2E6-984F-DE76-82B8-86EDCEBA61AD}"/>
          </ac:spMkLst>
        </pc:spChg>
        <pc:spChg chg="mod topLvl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34" creationId="{862B674D-9DE0-9999-C062-ED603EEF6898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37" creationId="{A6125769-5EFA-C090-949E-7C229BC74636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38" creationId="{4966416E-DFD2-49D7-BCF8-C01D36C71EB1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39" creationId="{13CA1A3E-E1AD-B7AF-82B2-D5C6270AB3ED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0" creationId="{9E63AF12-5063-204D-2C12-7DBC1EC51CD9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1" creationId="{EF3CBE19-B589-F7B3-5AD4-AE3B09FD3557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2" creationId="{0438BC80-42BC-854A-0C04-F3986D08FCB8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3" creationId="{4006BC0C-A33A-872D-F28F-459A4F765564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4" creationId="{B9E3ECE0-99C2-4F82-45B3-D4B650F32440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5" creationId="{396D279D-38B2-805A-6749-4A846C9780DB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6" creationId="{938149B2-DD16-A6E4-CE18-3D6909614A77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47" creationId="{15FE996B-FEEB-D6FF-C7C1-C512FD6B5575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50" creationId="{4CF7477F-95D3-CAC1-4FB2-95B03CF0E523}"/>
          </ac:spMkLst>
        </pc:spChg>
        <pc:spChg chg="mod">
          <ac:chgData name="Filippo Acconcia" userId="844af49c-a8a0-47ac-a7dd-14a44b60cd18" providerId="ADAL" clId="{F95F0201-6B3C-479C-9473-CC4C485F19A1}" dt="2022-07-30T12:01:00.346" v="523"/>
          <ac:spMkLst>
            <pc:docMk/>
            <pc:sldMk cId="786280344" sldId="308"/>
            <ac:spMk id="51" creationId="{9B1153AB-0CE1-6B71-5EDA-B96B0C915DD5}"/>
          </ac:spMkLst>
        </pc:spChg>
        <pc:spChg chg="add mod">
          <ac:chgData name="Filippo Acconcia" userId="844af49c-a8a0-47ac-a7dd-14a44b60cd18" providerId="ADAL" clId="{F95F0201-6B3C-479C-9473-CC4C485F19A1}" dt="2022-08-01T07:33:27.246" v="1798" actId="1035"/>
          <ac:spMkLst>
            <pc:docMk/>
            <pc:sldMk cId="786280344" sldId="308"/>
            <ac:spMk id="52" creationId="{300E67E3-4048-6D96-6E04-B01263B10967}"/>
          </ac:spMkLst>
        </pc:spChg>
        <pc:spChg chg="add mod">
          <ac:chgData name="Filippo Acconcia" userId="844af49c-a8a0-47ac-a7dd-14a44b60cd18" providerId="ADAL" clId="{F95F0201-6B3C-479C-9473-CC4C485F19A1}" dt="2022-08-01T07:33:27.246" v="1798" actId="1035"/>
          <ac:spMkLst>
            <pc:docMk/>
            <pc:sldMk cId="786280344" sldId="308"/>
            <ac:spMk id="53" creationId="{67D59B7B-6FA0-8896-72E2-9F0F6BD7A30D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4" creationId="{E7ADE498-6500-1B6E-D71E-872D4D7ADAF6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5" creationId="{58FE380E-151A-1EA8-D187-F1496FB210CD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6" creationId="{A83FFA8C-4E07-199F-0CFD-3C21A0F27DAB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7" creationId="{C06EEE40-D691-6E3D-45B1-23D59D283F17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8" creationId="{DBFDA900-813F-E535-ACD9-AC777A89ED1E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59" creationId="{00424509-4B7C-6E60-DADF-178CAB3013A1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60" creationId="{2D27656C-7486-031D-527E-27654BB678C6}"/>
          </ac:spMkLst>
        </pc:spChg>
        <pc:spChg chg="add mod">
          <ac:chgData name="Filippo Acconcia" userId="844af49c-a8a0-47ac-a7dd-14a44b60cd18" providerId="ADAL" clId="{F95F0201-6B3C-479C-9473-CC4C485F19A1}" dt="2022-07-30T12:09:06.860" v="701" actId="164"/>
          <ac:spMkLst>
            <pc:docMk/>
            <pc:sldMk cId="786280344" sldId="308"/>
            <ac:spMk id="61" creationId="{BDBA115D-BB05-0E91-7867-421FADD43CF5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4" creationId="{29A6AAFE-A21F-797F-9EE6-3517864DA7A7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5" creationId="{509CA473-DC95-E6A8-A83E-6241A38CB5DF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6" creationId="{4350B398-2EFE-C855-B364-EECD72494988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7" creationId="{9AC80309-2BDB-889E-DDA3-59A40F5A46E2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8" creationId="{069E4A68-467D-D814-633A-12709DB2DAB2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69" creationId="{DEA65DEC-4807-5A21-1A09-BAD95298E22F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0" creationId="{D7002510-B816-948A-E99D-00B424AA0726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1" creationId="{3E94036E-8F90-C08D-22A7-9236E61316BD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2" creationId="{EB481914-F176-4822-3FA7-ADDDE397F120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3" creationId="{1B7C7A36-21D4-2515-FE7C-1EAFA78C0373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6" creationId="{5757F812-EAC2-F276-89FC-16DB156AE8CD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7" creationId="{E5E05B83-6AE0-9C7E-33ED-336CF4133D4D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8" creationId="{02AE9BC2-4C72-3756-3A58-A893D82D575F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79" creationId="{9EBE6A0B-060C-F173-36F6-CC188AF1D3E7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0" creationId="{63E0A054-B360-7855-1832-AA750276044D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1" creationId="{691CB5C1-D571-2A29-A398-52952F4C1B3A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2" creationId="{77D25592-E415-7C81-E4C4-56A82466E497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3" creationId="{28B058C7-4D5A-D701-AAC0-CE520B2E2748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4" creationId="{2BE0D3EE-A038-07E0-9164-5474CA168173}"/>
          </ac:spMkLst>
        </pc:spChg>
        <pc:spChg chg="add mod">
          <ac:chgData name="Filippo Acconcia" userId="844af49c-a8a0-47ac-a7dd-14a44b60cd18" providerId="ADAL" clId="{F95F0201-6B3C-479C-9473-CC4C485F19A1}" dt="2022-07-30T12:09:01.975" v="700" actId="164"/>
          <ac:spMkLst>
            <pc:docMk/>
            <pc:sldMk cId="786280344" sldId="308"/>
            <ac:spMk id="85" creationId="{38260449-721A-9378-6CF8-F0C719FF185D}"/>
          </ac:spMkLst>
        </pc:spChg>
        <pc:spChg chg="add mod">
          <ac:chgData name="Filippo Acconcia" userId="844af49c-a8a0-47ac-a7dd-14a44b60cd18" providerId="ADAL" clId="{F95F0201-6B3C-479C-9473-CC4C485F19A1}" dt="2022-08-01T07:33:27.246" v="1798" actId="1035"/>
          <ac:spMkLst>
            <pc:docMk/>
            <pc:sldMk cId="786280344" sldId="308"/>
            <ac:spMk id="89" creationId="{AD34CF2B-1851-1BF0-5191-432DB0B2EE23}"/>
          </ac:spMkLst>
        </pc:spChg>
        <pc:spChg chg="add mod">
          <ac:chgData name="Filippo Acconcia" userId="844af49c-a8a0-47ac-a7dd-14a44b60cd18" providerId="ADAL" clId="{F95F0201-6B3C-479C-9473-CC4C485F19A1}" dt="2022-08-01T07:31:50.898" v="1780" actId="164"/>
          <ac:spMkLst>
            <pc:docMk/>
            <pc:sldMk cId="786280344" sldId="308"/>
            <ac:spMk id="90" creationId="{6BE94AC7-A9A7-8983-612C-FEF12D74567D}"/>
          </ac:spMkLst>
        </pc:spChg>
        <pc:spChg chg="add mod">
          <ac:chgData name="Filippo Acconcia" userId="844af49c-a8a0-47ac-a7dd-14a44b60cd18" providerId="ADAL" clId="{F95F0201-6B3C-479C-9473-CC4C485F19A1}" dt="2022-08-01T07:31:50.898" v="1780" actId="164"/>
          <ac:spMkLst>
            <pc:docMk/>
            <pc:sldMk cId="786280344" sldId="308"/>
            <ac:spMk id="91" creationId="{0141B8B0-A9A6-2F9F-F65C-D2CC313F0C4E}"/>
          </ac:spMkLst>
        </pc:spChg>
        <pc:spChg chg="add mod">
          <ac:chgData name="Filippo Acconcia" userId="844af49c-a8a0-47ac-a7dd-14a44b60cd18" providerId="ADAL" clId="{F95F0201-6B3C-479C-9473-CC4C485F19A1}" dt="2022-08-01T07:32:32.124" v="1790" actId="164"/>
          <ac:spMkLst>
            <pc:docMk/>
            <pc:sldMk cId="786280344" sldId="308"/>
            <ac:spMk id="92" creationId="{B6EB8A48-F3AC-FA4B-D59F-12D84062DD91}"/>
          </ac:spMkLst>
        </pc:spChg>
        <pc:spChg chg="add mod">
          <ac:chgData name="Filippo Acconcia" userId="844af49c-a8a0-47ac-a7dd-14a44b60cd18" providerId="ADAL" clId="{F95F0201-6B3C-479C-9473-CC4C485F19A1}" dt="2022-08-01T07:32:32.124" v="1790" actId="164"/>
          <ac:spMkLst>
            <pc:docMk/>
            <pc:sldMk cId="786280344" sldId="308"/>
            <ac:spMk id="93" creationId="{C584A86E-3836-554D-F77C-FF5A2C7948BC}"/>
          </ac:spMkLst>
        </pc:spChg>
        <pc:spChg chg="add mod">
          <ac:chgData name="Filippo Acconcia" userId="844af49c-a8a0-47ac-a7dd-14a44b60cd18" providerId="ADAL" clId="{F95F0201-6B3C-479C-9473-CC4C485F19A1}" dt="2022-08-01T07:33:34.497" v="1799" actId="164"/>
          <ac:spMkLst>
            <pc:docMk/>
            <pc:sldMk cId="786280344" sldId="308"/>
            <ac:spMk id="94" creationId="{7CB97EC8-6310-7100-8E47-630DD9A2D6DC}"/>
          </ac:spMkLst>
        </pc:spChg>
        <pc:spChg chg="add mod">
          <ac:chgData name="Filippo Acconcia" userId="844af49c-a8a0-47ac-a7dd-14a44b60cd18" providerId="ADAL" clId="{F95F0201-6B3C-479C-9473-CC4C485F19A1}" dt="2022-08-01T07:33:34.497" v="1799" actId="164"/>
          <ac:spMkLst>
            <pc:docMk/>
            <pc:sldMk cId="786280344" sldId="308"/>
            <ac:spMk id="95" creationId="{F8896A50-9C04-FAEE-2EE8-81DD81871DC4}"/>
          </ac:spMkLst>
        </pc:spChg>
        <pc:spChg chg="add mod">
          <ac:chgData name="Filippo Acconcia" userId="844af49c-a8a0-47ac-a7dd-14a44b60cd18" providerId="ADAL" clId="{F95F0201-6B3C-479C-9473-CC4C485F19A1}" dt="2022-08-01T07:33:34.497" v="1799" actId="164"/>
          <ac:spMkLst>
            <pc:docMk/>
            <pc:sldMk cId="786280344" sldId="308"/>
            <ac:spMk id="96" creationId="{B7F87CF6-A0C3-0325-E9E7-E3586DCECFCA}"/>
          </ac:spMkLst>
        </pc:spChg>
        <pc:grpChg chg="mod">
          <ac:chgData name="Filippo Acconcia" userId="844af49c-a8a0-47ac-a7dd-14a44b60cd18" providerId="ADAL" clId="{F95F0201-6B3C-479C-9473-CC4C485F19A1}" dt="2022-08-01T07:33:34.497" v="1799" actId="164"/>
          <ac:grpSpMkLst>
            <pc:docMk/>
            <pc:sldMk cId="786280344" sldId="308"/>
            <ac:grpSpMk id="2" creationId="{BCF04638-70EA-53EB-21D5-FF8C3F52D432}"/>
          </ac:grpSpMkLst>
        </pc:grpChg>
        <pc:grpChg chg="add mod">
          <ac:chgData name="Filippo Acconcia" userId="844af49c-a8a0-47ac-a7dd-14a44b60cd18" providerId="ADAL" clId="{F95F0201-6B3C-479C-9473-CC4C485F19A1}" dt="2022-08-01T07:31:50.898" v="1780" actId="164"/>
          <ac:grpSpMkLst>
            <pc:docMk/>
            <pc:sldMk cId="786280344" sldId="308"/>
            <ac:grpSpMk id="18" creationId="{0B7BF35D-AA37-165E-5DA7-71E8777949B1}"/>
          </ac:grpSpMkLst>
        </pc:grpChg>
        <pc:grpChg chg="add del mod">
          <ac:chgData name="Filippo Acconcia" userId="844af49c-a8a0-47ac-a7dd-14a44b60cd18" providerId="ADAL" clId="{F95F0201-6B3C-479C-9473-CC4C485F19A1}" dt="2022-07-30T12:03:24.625" v="524" actId="165"/>
          <ac:grpSpMkLst>
            <pc:docMk/>
            <pc:sldMk cId="786280344" sldId="308"/>
            <ac:grpSpMk id="18" creationId="{E311B0C5-245D-0EA9-0DCC-49A92DD46CA2}"/>
          </ac:grpSpMkLst>
        </pc:grpChg>
        <pc:grpChg chg="add mod">
          <ac:chgData name="Filippo Acconcia" userId="844af49c-a8a0-47ac-a7dd-14a44b60cd18" providerId="ADAL" clId="{F95F0201-6B3C-479C-9473-CC4C485F19A1}" dt="2022-08-01T07:32:32.124" v="1790" actId="164"/>
          <ac:grpSpMkLst>
            <pc:docMk/>
            <pc:sldMk cId="786280344" sldId="308"/>
            <ac:grpSpMk id="19" creationId="{2930A98E-13DC-7D02-8E07-13E11C186535}"/>
          </ac:grpSpMkLst>
        </pc:grpChg>
        <pc:grpChg chg="add mod">
          <ac:chgData name="Filippo Acconcia" userId="844af49c-a8a0-47ac-a7dd-14a44b60cd18" providerId="ADAL" clId="{F95F0201-6B3C-479C-9473-CC4C485F19A1}" dt="2022-08-01T07:33:34.497" v="1799" actId="164"/>
          <ac:grpSpMkLst>
            <pc:docMk/>
            <pc:sldMk cId="786280344" sldId="308"/>
            <ac:grpSpMk id="29" creationId="{82738BE6-ECB0-DBD7-8274-42721FE7BC38}"/>
          </ac:grpSpMkLst>
        </pc:grpChg>
        <pc:grpChg chg="add del mod">
          <ac:chgData name="Filippo Acconcia" userId="844af49c-a8a0-47ac-a7dd-14a44b60cd18" providerId="ADAL" clId="{F95F0201-6B3C-479C-9473-CC4C485F19A1}" dt="2022-07-30T12:06:27.603" v="674" actId="478"/>
          <ac:grpSpMkLst>
            <pc:docMk/>
            <pc:sldMk cId="786280344" sldId="308"/>
            <ac:grpSpMk id="35" creationId="{BD808E3D-A116-88FC-4AD6-0AF165BBF0C6}"/>
          </ac:grpSpMkLst>
        </pc:grpChg>
        <pc:grpChg chg="add mod">
          <ac:chgData name="Filippo Acconcia" userId="844af49c-a8a0-47ac-a7dd-14a44b60cd18" providerId="ADAL" clId="{F95F0201-6B3C-479C-9473-CC4C485F19A1}" dt="2022-08-01T07:31:50.898" v="1780" actId="164"/>
          <ac:grpSpMkLst>
            <pc:docMk/>
            <pc:sldMk cId="786280344" sldId="308"/>
            <ac:grpSpMk id="87" creationId="{D4480864-814A-7645-4111-9E458478A7B3}"/>
          </ac:grpSpMkLst>
        </pc:grpChg>
        <pc:grpChg chg="add mod">
          <ac:chgData name="Filippo Acconcia" userId="844af49c-a8a0-47ac-a7dd-14a44b60cd18" providerId="ADAL" clId="{F95F0201-6B3C-479C-9473-CC4C485F19A1}" dt="2022-08-01T07:32:32.124" v="1790" actId="164"/>
          <ac:grpSpMkLst>
            <pc:docMk/>
            <pc:sldMk cId="786280344" sldId="308"/>
            <ac:grpSpMk id="88" creationId="{D99FA70C-CA50-CE1A-A566-9F39045CF8E2}"/>
          </ac:grpSpMkLst>
        </pc:grpChg>
        <pc:picChg chg="del mod topLvl">
          <ac:chgData name="Filippo Acconcia" userId="844af49c-a8a0-47ac-a7dd-14a44b60cd18" providerId="ADAL" clId="{F95F0201-6B3C-479C-9473-CC4C485F19A1}" dt="2022-07-30T12:07:40.661" v="682" actId="478"/>
          <ac:picMkLst>
            <pc:docMk/>
            <pc:sldMk cId="786280344" sldId="308"/>
            <ac:picMk id="19" creationId="{09537993-9D7A-D829-7F43-58489EBAA321}"/>
          </ac:picMkLst>
        </pc:picChg>
        <pc:picChg chg="mod">
          <ac:chgData name="Filippo Acconcia" userId="844af49c-a8a0-47ac-a7dd-14a44b60cd18" providerId="ADAL" clId="{F95F0201-6B3C-479C-9473-CC4C485F19A1}" dt="2022-07-30T12:01:00.346" v="523"/>
          <ac:picMkLst>
            <pc:docMk/>
            <pc:sldMk cId="786280344" sldId="308"/>
            <ac:picMk id="36" creationId="{89AFCD92-08F1-C730-EC76-95AA51CF5BF5}"/>
          </ac:picMkLst>
        </pc:picChg>
        <pc:picChg chg="mod ord">
          <ac:chgData name="Filippo Acconcia" userId="844af49c-a8a0-47ac-a7dd-14a44b60cd18" providerId="ADAL" clId="{F95F0201-6B3C-479C-9473-CC4C485F19A1}" dt="2022-07-30T12:09:06.860" v="701" actId="164"/>
          <ac:picMkLst>
            <pc:docMk/>
            <pc:sldMk cId="786280344" sldId="308"/>
            <ac:picMk id="62" creationId="{973D4BB9-A2CD-0E53-9F72-26A9E5FF0655}"/>
          </ac:picMkLst>
        </pc:picChg>
        <pc:picChg chg="add del mod">
          <ac:chgData name="Filippo Acconcia" userId="844af49c-a8a0-47ac-a7dd-14a44b60cd18" providerId="ADAL" clId="{F95F0201-6B3C-479C-9473-CC4C485F19A1}" dt="2022-07-30T12:08:57.852" v="699" actId="478"/>
          <ac:picMkLst>
            <pc:docMk/>
            <pc:sldMk cId="786280344" sldId="308"/>
            <ac:picMk id="63" creationId="{22EE2D21-0DF8-7C13-96F3-166583214D53}"/>
          </ac:picMkLst>
        </pc:picChg>
        <pc:picChg chg="mod ord">
          <ac:chgData name="Filippo Acconcia" userId="844af49c-a8a0-47ac-a7dd-14a44b60cd18" providerId="ADAL" clId="{F95F0201-6B3C-479C-9473-CC4C485F19A1}" dt="2022-07-30T12:09:01.975" v="700" actId="164"/>
          <ac:picMkLst>
            <pc:docMk/>
            <pc:sldMk cId="786280344" sldId="308"/>
            <ac:picMk id="86" creationId="{ECC37A71-AD73-5846-0A5F-5D97F3C86DC0}"/>
          </ac:picMkLst>
        </pc:picChg>
        <pc:cxnChg chg="mod topLvl">
          <ac:chgData name="Filippo Acconcia" userId="844af49c-a8a0-47ac-a7dd-14a44b60cd18" providerId="ADAL" clId="{F95F0201-6B3C-479C-9473-CC4C485F19A1}" dt="2022-07-30T12:09:06.860" v="701" actId="164"/>
          <ac:cxnSpMkLst>
            <pc:docMk/>
            <pc:sldMk cId="786280344" sldId="308"/>
            <ac:cxnSpMk id="31" creationId="{21C274DF-A3C1-6301-EE5F-0914AAABA272}"/>
          </ac:cxnSpMkLst>
        </pc:cxnChg>
        <pc:cxnChg chg="mod topLvl">
          <ac:chgData name="Filippo Acconcia" userId="844af49c-a8a0-47ac-a7dd-14a44b60cd18" providerId="ADAL" clId="{F95F0201-6B3C-479C-9473-CC4C485F19A1}" dt="2022-07-30T12:09:06.860" v="701" actId="164"/>
          <ac:cxnSpMkLst>
            <pc:docMk/>
            <pc:sldMk cId="786280344" sldId="308"/>
            <ac:cxnSpMk id="32" creationId="{048D4001-6B81-C897-080B-BD10F1EF228E}"/>
          </ac:cxnSpMkLst>
        </pc:cxnChg>
        <pc:cxnChg chg="mod">
          <ac:chgData name="Filippo Acconcia" userId="844af49c-a8a0-47ac-a7dd-14a44b60cd18" providerId="ADAL" clId="{F95F0201-6B3C-479C-9473-CC4C485F19A1}" dt="2022-07-30T12:01:00.346" v="523"/>
          <ac:cxnSpMkLst>
            <pc:docMk/>
            <pc:sldMk cId="786280344" sldId="308"/>
            <ac:cxnSpMk id="48" creationId="{E19565CA-189C-FD5C-52B9-83E45A0499C5}"/>
          </ac:cxnSpMkLst>
        </pc:cxnChg>
        <pc:cxnChg chg="mod">
          <ac:chgData name="Filippo Acconcia" userId="844af49c-a8a0-47ac-a7dd-14a44b60cd18" providerId="ADAL" clId="{F95F0201-6B3C-479C-9473-CC4C485F19A1}" dt="2022-07-30T12:01:00.346" v="523"/>
          <ac:cxnSpMkLst>
            <pc:docMk/>
            <pc:sldMk cId="786280344" sldId="308"/>
            <ac:cxnSpMk id="49" creationId="{F7473011-D2FB-1D99-E84B-F23828CB1D2C}"/>
          </ac:cxnSpMkLst>
        </pc:cxnChg>
        <pc:cxnChg chg="add mod">
          <ac:chgData name="Filippo Acconcia" userId="844af49c-a8a0-47ac-a7dd-14a44b60cd18" providerId="ADAL" clId="{F95F0201-6B3C-479C-9473-CC4C485F19A1}" dt="2022-07-30T12:09:01.975" v="700" actId="164"/>
          <ac:cxnSpMkLst>
            <pc:docMk/>
            <pc:sldMk cId="786280344" sldId="308"/>
            <ac:cxnSpMk id="74" creationId="{CFB6C4C9-96C3-5E1B-F83E-EDC0F41849DA}"/>
          </ac:cxnSpMkLst>
        </pc:cxnChg>
        <pc:cxnChg chg="add mod">
          <ac:chgData name="Filippo Acconcia" userId="844af49c-a8a0-47ac-a7dd-14a44b60cd18" providerId="ADAL" clId="{F95F0201-6B3C-479C-9473-CC4C485F19A1}" dt="2022-07-30T12:09:01.975" v="700" actId="164"/>
          <ac:cxnSpMkLst>
            <pc:docMk/>
            <pc:sldMk cId="786280344" sldId="308"/>
            <ac:cxnSpMk id="75" creationId="{924A5436-BDDB-381E-7A21-137C3ADC573B}"/>
          </ac:cxnSpMkLst>
        </pc:cxnChg>
      </pc:sldChg>
      <pc:sldChg chg="del">
        <pc:chgData name="Filippo Acconcia" userId="844af49c-a8a0-47ac-a7dd-14a44b60cd18" providerId="ADAL" clId="{F95F0201-6B3C-479C-9473-CC4C485F19A1}" dt="2022-07-30T06:36:03.906" v="43" actId="47"/>
        <pc:sldMkLst>
          <pc:docMk/>
          <pc:sldMk cId="4183010025" sldId="309"/>
        </pc:sldMkLst>
      </pc:sldChg>
      <pc:sldChg chg="addSp delSp modSp mod">
        <pc:chgData name="Filippo Acconcia" userId="844af49c-a8a0-47ac-a7dd-14a44b60cd18" providerId="ADAL" clId="{F95F0201-6B3C-479C-9473-CC4C485F19A1}" dt="2022-09-04T09:57:23.972" v="1893" actId="1035"/>
        <pc:sldMkLst>
          <pc:docMk/>
          <pc:sldMk cId="2704834836" sldId="310"/>
        </pc:sldMkLst>
        <pc:spChg chg="mod">
          <ac:chgData name="Filippo Acconcia" userId="844af49c-a8a0-47ac-a7dd-14a44b60cd18" providerId="ADAL" clId="{F95F0201-6B3C-479C-9473-CC4C485F19A1}" dt="2022-07-30T06:37:21.902" v="53" actId="12788"/>
          <ac:spMkLst>
            <pc:docMk/>
            <pc:sldMk cId="2704834836" sldId="310"/>
            <ac:spMk id="2" creationId="{05BA7DE3-DBDB-B99A-4446-7FBCD138B40B}"/>
          </ac:spMkLst>
        </pc:spChg>
        <pc:spChg chg="del">
          <ac:chgData name="Filippo Acconcia" userId="844af49c-a8a0-47ac-a7dd-14a44b60cd18" providerId="ADAL" clId="{F95F0201-6B3C-479C-9473-CC4C485F19A1}" dt="2022-09-04T09:45:14.126" v="1876" actId="478"/>
          <ac:spMkLst>
            <pc:docMk/>
            <pc:sldMk cId="2704834836" sldId="310"/>
            <ac:spMk id="3" creationId="{F41A731C-6E8D-393E-FB71-31BFCB8C8FE3}"/>
          </ac:spMkLst>
        </pc:spChg>
        <pc:spChg chg="del">
          <ac:chgData name="Filippo Acconcia" userId="844af49c-a8a0-47ac-a7dd-14a44b60cd18" providerId="ADAL" clId="{F95F0201-6B3C-479C-9473-CC4C485F19A1}" dt="2022-09-04T09:45:14.126" v="1876" actId="478"/>
          <ac:spMkLst>
            <pc:docMk/>
            <pc:sldMk cId="2704834836" sldId="310"/>
            <ac:spMk id="4" creationId="{CCD08066-56ED-9E19-00A1-D98CE0480997}"/>
          </ac:spMkLst>
        </pc:spChg>
        <pc:spChg chg="mod topLvl">
          <ac:chgData name="Filippo Acconcia" userId="844af49c-a8a0-47ac-a7dd-14a44b60cd18" providerId="ADAL" clId="{F95F0201-6B3C-479C-9473-CC4C485F19A1}" dt="2022-08-22T14:23:57.433" v="1812" actId="164"/>
          <ac:spMkLst>
            <pc:docMk/>
            <pc:sldMk cId="2704834836" sldId="310"/>
            <ac:spMk id="25" creationId="{579CB955-14D0-BE95-559B-F8E4331A1A2A}"/>
          </ac:spMkLst>
        </pc:spChg>
        <pc:spChg chg="mod topLvl">
          <ac:chgData name="Filippo Acconcia" userId="844af49c-a8a0-47ac-a7dd-14a44b60cd18" providerId="ADAL" clId="{F95F0201-6B3C-479C-9473-CC4C485F19A1}" dt="2022-08-22T14:23:57.433" v="1812" actId="164"/>
          <ac:spMkLst>
            <pc:docMk/>
            <pc:sldMk cId="2704834836" sldId="310"/>
            <ac:spMk id="33" creationId="{16F8AD99-5F9F-A8C4-8B53-9C992EF10DCF}"/>
          </ac:spMkLst>
        </pc:spChg>
        <pc:spChg chg="del">
          <ac:chgData name="Filippo Acconcia" userId="844af49c-a8a0-47ac-a7dd-14a44b60cd18" providerId="ADAL" clId="{F95F0201-6B3C-479C-9473-CC4C485F19A1}" dt="2022-07-30T06:37:25.085" v="54" actId="478"/>
          <ac:spMkLst>
            <pc:docMk/>
            <pc:sldMk cId="2704834836" sldId="310"/>
            <ac:spMk id="50" creationId="{352A77D4-8248-5B5F-4BCC-F8AF474FD80A}"/>
          </ac:spMkLst>
        </pc:spChg>
        <pc:spChg chg="mod topLvl">
          <ac:chgData name="Filippo Acconcia" userId="844af49c-a8a0-47ac-a7dd-14a44b60cd18" providerId="ADAL" clId="{F95F0201-6B3C-479C-9473-CC4C485F19A1}" dt="2022-08-22T14:23:57.433" v="1812" actId="164"/>
          <ac:spMkLst>
            <pc:docMk/>
            <pc:sldMk cId="2704834836" sldId="310"/>
            <ac:spMk id="50" creationId="{D01F96FF-2238-4F3C-5479-05ED4B774E3F}"/>
          </ac:spMkLst>
        </pc:spChg>
        <pc:spChg chg="mod topLvl">
          <ac:chgData name="Filippo Acconcia" userId="844af49c-a8a0-47ac-a7dd-14a44b60cd18" providerId="ADAL" clId="{F95F0201-6B3C-479C-9473-CC4C485F19A1}" dt="2022-08-22T14:23:57.433" v="1812" actId="164"/>
          <ac:spMkLst>
            <pc:docMk/>
            <pc:sldMk cId="2704834836" sldId="310"/>
            <ac:spMk id="51" creationId="{C9C66DBA-D58A-3389-7BB7-BC86DA1D4226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2" creationId="{CECD1436-FB19-D686-0F95-D2442FFF36FF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3" creationId="{41A827EA-FEEA-F28F-FFE6-C00717E5ECD0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5" creationId="{B977F0A9-953A-4557-FFD1-27EA0C4D3B91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6" creationId="{0BEF0D54-D63C-5893-21AE-5EBB2382BF01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7" creationId="{DA00DFD7-A84E-EFEA-396B-1310661F3D59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59" creationId="{2E07F81D-0109-450B-2E6F-E5EECAA38C86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60" creationId="{5394EAC6-585D-E066-EE30-8FEFE06AAC15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61" creationId="{A5E381C8-BC1C-24DA-94BB-02857242D54F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64" creationId="{0577DFD3-2219-2345-92BB-9128933070C9}"/>
          </ac:spMkLst>
        </pc:spChg>
        <pc:spChg chg="del mod topLvl">
          <ac:chgData name="Filippo Acconcia" userId="844af49c-a8a0-47ac-a7dd-14a44b60cd18" providerId="ADAL" clId="{F95F0201-6B3C-479C-9473-CC4C485F19A1}" dt="2022-08-22T14:23:27.726" v="1807" actId="478"/>
          <ac:spMkLst>
            <pc:docMk/>
            <pc:sldMk cId="2704834836" sldId="310"/>
            <ac:spMk id="67" creationId="{267476A2-359A-0169-DF4B-5992960EF5DD}"/>
          </ac:spMkLst>
        </pc:spChg>
        <pc:spChg chg="del mod topLvl">
          <ac:chgData name="Filippo Acconcia" userId="844af49c-a8a0-47ac-a7dd-14a44b60cd18" providerId="ADAL" clId="{F95F0201-6B3C-479C-9473-CC4C485F19A1}" dt="2022-08-22T14:23:30.087" v="1808" actId="478"/>
          <ac:spMkLst>
            <pc:docMk/>
            <pc:sldMk cId="2704834836" sldId="310"/>
            <ac:spMk id="71" creationId="{9014A181-03D6-E444-3BD4-6CF17CBDA78F}"/>
          </ac:spMkLst>
        </pc:spChg>
        <pc:spChg chg="del mod topLvl">
          <ac:chgData name="Filippo Acconcia" userId="844af49c-a8a0-47ac-a7dd-14a44b60cd18" providerId="ADAL" clId="{F95F0201-6B3C-479C-9473-CC4C485F19A1}" dt="2022-08-22T14:23:32.569" v="1809" actId="478"/>
          <ac:spMkLst>
            <pc:docMk/>
            <pc:sldMk cId="2704834836" sldId="310"/>
            <ac:spMk id="75" creationId="{DE340F2A-30C4-3E6F-DA80-54D6D751F269}"/>
          </ac:spMkLst>
        </pc:spChg>
        <pc:spChg chg="del mod topLvl">
          <ac:chgData name="Filippo Acconcia" userId="844af49c-a8a0-47ac-a7dd-14a44b60cd18" providerId="ADAL" clId="{F95F0201-6B3C-479C-9473-CC4C485F19A1}" dt="2022-08-22T14:23:24.885" v="1806" actId="478"/>
          <ac:spMkLst>
            <pc:docMk/>
            <pc:sldMk cId="2704834836" sldId="310"/>
            <ac:spMk id="82" creationId="{036E8F84-3990-E2B6-F803-41FC59A01EEC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85" creationId="{2C1E71AC-2074-D482-1421-7A4FF33AAB53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86" creationId="{515A1A82-83AD-FCD0-FABC-E5CC5A1B8A8C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88" creationId="{F2716244-C915-9F5F-C266-E0B5F5EA11C0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89" creationId="{105E9E78-5137-5F5B-6965-8E217FF122C9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90" creationId="{244B0B6B-FFCA-97ED-0FEB-6E00B547A77D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91" creationId="{F947253B-3F30-7A77-9ABF-5784784E8498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92" creationId="{2987C082-2698-89CA-9F33-00F84D638851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93" creationId="{77F7CA3C-CA40-C2DA-7BC1-7670230EED71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94" creationId="{C7535A70-7697-75F9-AE7F-116EF948014D}"/>
          </ac:spMkLst>
        </pc:spChg>
        <pc:spChg chg="add mod">
          <ac:chgData name="Filippo Acconcia" userId="844af49c-a8a0-47ac-a7dd-14a44b60cd18" providerId="ADAL" clId="{F95F0201-6B3C-479C-9473-CC4C485F19A1}" dt="2022-07-30T06:38:23.001" v="144" actId="553"/>
          <ac:spMkLst>
            <pc:docMk/>
            <pc:sldMk cId="2704834836" sldId="310"/>
            <ac:spMk id="98" creationId="{D6A32688-DEC5-E854-8AF4-D41402392DCD}"/>
          </ac:spMkLst>
        </pc:spChg>
        <pc:spChg chg="add mod">
          <ac:chgData name="Filippo Acconcia" userId="844af49c-a8a0-47ac-a7dd-14a44b60cd18" providerId="ADAL" clId="{F95F0201-6B3C-479C-9473-CC4C485F19A1}" dt="2022-07-30T06:38:16.046" v="143" actId="552"/>
          <ac:spMkLst>
            <pc:docMk/>
            <pc:sldMk cId="2704834836" sldId="310"/>
            <ac:spMk id="99" creationId="{EB0BBE12-353E-601E-87EA-79CF0A9E61BB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0" creationId="{2803EE5A-FDFD-A7F8-BA4C-FEF37C7A4EC2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1" creationId="{40CB97CE-D31A-2550-9203-AB2AA953C65F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2" creationId="{DCE384BE-1730-8CE3-D2D1-2C53C504FB9E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3" creationId="{6F09AD7A-F282-F428-BA4A-F5F101ADDA6D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4" creationId="{A5A837A4-AAB5-7B12-5BFD-A992DDC2FFCD}"/>
          </ac:spMkLst>
        </pc:spChg>
        <pc:spChg chg="add del mod">
          <ac:chgData name="Filippo Acconcia" userId="844af49c-a8a0-47ac-a7dd-14a44b60cd18" providerId="ADAL" clId="{F95F0201-6B3C-479C-9473-CC4C485F19A1}" dt="2022-09-04T09:44:56.679" v="1819" actId="478"/>
          <ac:spMkLst>
            <pc:docMk/>
            <pc:sldMk cId="2704834836" sldId="310"/>
            <ac:spMk id="105" creationId="{B4BC129B-DF4E-5BFA-62DF-B430AE1C991B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6" creationId="{35F9FDE0-4D13-CCA9-3CC4-13412050C61F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7" creationId="{865717D7-1D4D-58A5-06CD-2F249854C96E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8" creationId="{F316DA25-E7EC-4245-85FA-F2DED56D67B7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09" creationId="{D8E5DF12-73FC-4A0A-945D-029DD637F695}"/>
          </ac:spMkLst>
        </pc:spChg>
        <pc:spChg chg="add del mod">
          <ac:chgData name="Filippo Acconcia" userId="844af49c-a8a0-47ac-a7dd-14a44b60cd18" providerId="ADAL" clId="{F95F0201-6B3C-479C-9473-CC4C485F19A1}" dt="2022-09-04T09:44:55.607" v="1818" actId="478"/>
          <ac:spMkLst>
            <pc:docMk/>
            <pc:sldMk cId="2704834836" sldId="310"/>
            <ac:spMk id="112" creationId="{E80BAFBF-AB11-F7A2-BE9E-58CFC92229E9}"/>
          </ac:spMkLst>
        </pc:spChg>
        <pc:spChg chg="add mod">
          <ac:chgData name="Filippo Acconcia" userId="844af49c-a8a0-47ac-a7dd-14a44b60cd18" providerId="ADAL" clId="{F95F0201-6B3C-479C-9473-CC4C485F19A1}" dt="2022-09-04T09:57:23.972" v="1893" actId="1035"/>
          <ac:spMkLst>
            <pc:docMk/>
            <pc:sldMk cId="2704834836" sldId="310"/>
            <ac:spMk id="113" creationId="{E20A8941-A9B2-3A6C-1DFC-87417B0FD181}"/>
          </ac:spMkLst>
        </pc:spChg>
        <pc:spChg chg="add mod">
          <ac:chgData name="Filippo Acconcia" userId="844af49c-a8a0-47ac-a7dd-14a44b60cd18" providerId="ADAL" clId="{F95F0201-6B3C-479C-9473-CC4C485F19A1}" dt="2022-09-04T09:57:23.972" v="1893" actId="1035"/>
          <ac:spMkLst>
            <pc:docMk/>
            <pc:sldMk cId="2704834836" sldId="310"/>
            <ac:spMk id="114" creationId="{37B624DC-BD1C-9BC9-A8D5-067E1D729D88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15" creationId="{E7F07299-EEF9-9622-CE56-C1B4380A1EFD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16" creationId="{20701049-F4E6-D72A-602E-C32BFE1A7B0F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17" creationId="{AC7828E3-AC17-9371-EB8C-B17EC37E0EFC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18" creationId="{8391248F-2875-5711-B6EC-E73AE6F8C6B9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19" creationId="{A919F5AC-66A7-419F-6C26-518118BE0E52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0" creationId="{64042756-28B9-A6A9-F458-F754796FC2DA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1" creationId="{88FB43B0-C88A-EABD-B35D-C12814209B48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2" creationId="{9309D04B-48CA-765D-7792-1942E37110E4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3" creationId="{DE164F92-CDDE-CFAB-0E03-C4AD9D28729E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5" creationId="{E36E78FE-15AE-E1CC-9CD7-0AC3558E88A9}"/>
          </ac:spMkLst>
        </pc:spChg>
        <pc:spChg chg="mod">
          <ac:chgData name="Filippo Acconcia" userId="844af49c-a8a0-47ac-a7dd-14a44b60cd18" providerId="ADAL" clId="{F95F0201-6B3C-479C-9473-CC4C485F19A1}" dt="2022-09-04T09:38:36.385" v="1813" actId="165"/>
          <ac:spMkLst>
            <pc:docMk/>
            <pc:sldMk cId="2704834836" sldId="310"/>
            <ac:spMk id="126" creationId="{18D0F4A4-B78C-1BDD-6D8E-5FB279E2DC00}"/>
          </ac:spMkLst>
        </pc:spChg>
        <pc:grpChg chg="del">
          <ac:chgData name="Filippo Acconcia" userId="844af49c-a8a0-47ac-a7dd-14a44b60cd18" providerId="ADAL" clId="{F95F0201-6B3C-479C-9473-CC4C485F19A1}" dt="2022-08-22T14:22:58.169" v="1800" actId="165"/>
          <ac:grpSpMkLst>
            <pc:docMk/>
            <pc:sldMk cId="2704834836" sldId="310"/>
            <ac:grpSpMk id="5" creationId="{3A088B93-8A8D-8C9A-F3AD-C18EFB1C6C6A}"/>
          </ac:grpSpMkLst>
        </pc:grpChg>
        <pc:grpChg chg="del mod topLvl">
          <ac:chgData name="Filippo Acconcia" userId="844af49c-a8a0-47ac-a7dd-14a44b60cd18" providerId="ADAL" clId="{F95F0201-6B3C-479C-9473-CC4C485F19A1}" dt="2022-08-22T14:23:05.169" v="1801" actId="165"/>
          <ac:grpSpMkLst>
            <pc:docMk/>
            <pc:sldMk cId="2704834836" sldId="310"/>
            <ac:grpSpMk id="27" creationId="{829B2ED9-A561-1FAA-9A7A-9F7488C4CFA6}"/>
          </ac:grpSpMkLst>
        </pc:grpChg>
        <pc:grpChg chg="del mod topLvl">
          <ac:chgData name="Filippo Acconcia" userId="844af49c-a8a0-47ac-a7dd-14a44b60cd18" providerId="ADAL" clId="{F95F0201-6B3C-479C-9473-CC4C485F19A1}" dt="2022-08-22T14:23:05.169" v="1801" actId="165"/>
          <ac:grpSpMkLst>
            <pc:docMk/>
            <pc:sldMk cId="2704834836" sldId="310"/>
            <ac:grpSpMk id="32" creationId="{D718BEAD-0591-3B88-6F73-5CC0E1B3A971}"/>
          </ac:grpSpMkLst>
        </pc:grpChg>
        <pc:grpChg chg="del">
          <ac:chgData name="Filippo Acconcia" userId="844af49c-a8a0-47ac-a7dd-14a44b60cd18" providerId="ADAL" clId="{F95F0201-6B3C-479C-9473-CC4C485F19A1}" dt="2022-09-04T09:44:47.686" v="1815" actId="478"/>
          <ac:grpSpMkLst>
            <pc:docMk/>
            <pc:sldMk cId="2704834836" sldId="310"/>
            <ac:grpSpMk id="48" creationId="{0FB0106D-8B39-BD2D-B29F-3345378FE827}"/>
          </ac:grpSpMkLst>
        </pc:grpChg>
        <pc:grpChg chg="del">
          <ac:chgData name="Filippo Acconcia" userId="844af49c-a8a0-47ac-a7dd-14a44b60cd18" providerId="ADAL" clId="{F95F0201-6B3C-479C-9473-CC4C485F19A1}" dt="2022-09-04T09:44:46.985" v="1814" actId="478"/>
          <ac:grpSpMkLst>
            <pc:docMk/>
            <pc:sldMk cId="2704834836" sldId="310"/>
            <ac:grpSpMk id="49" creationId="{E54CFE2B-9801-0EE7-13AF-849FE52CF44E}"/>
          </ac:grpSpMkLst>
        </pc:grpChg>
        <pc:grpChg chg="del mod topLvl">
          <ac:chgData name="Filippo Acconcia" userId="844af49c-a8a0-47ac-a7dd-14a44b60cd18" providerId="ADAL" clId="{F95F0201-6B3C-479C-9473-CC4C485F19A1}" dt="2022-08-22T14:23:05.169" v="1801" actId="165"/>
          <ac:grpSpMkLst>
            <pc:docMk/>
            <pc:sldMk cId="2704834836" sldId="310"/>
            <ac:grpSpMk id="58" creationId="{4D832EF0-CFA7-3ED2-9895-B9FD7C6ED9C4}"/>
          </ac:grpSpMkLst>
        </pc:grpChg>
        <pc:grpChg chg="del mod topLvl">
          <ac:chgData name="Filippo Acconcia" userId="844af49c-a8a0-47ac-a7dd-14a44b60cd18" providerId="ADAL" clId="{F95F0201-6B3C-479C-9473-CC4C485F19A1}" dt="2022-08-22T14:23:05.169" v="1801" actId="165"/>
          <ac:grpSpMkLst>
            <pc:docMk/>
            <pc:sldMk cId="2704834836" sldId="310"/>
            <ac:grpSpMk id="62" creationId="{D4FF0776-6FB0-552B-BCD0-36DE3681E12C}"/>
          </ac:grpSpMkLst>
        </pc:grpChg>
        <pc:grpChg chg="del mod topLvl">
          <ac:chgData name="Filippo Acconcia" userId="844af49c-a8a0-47ac-a7dd-14a44b60cd18" providerId="ADAL" clId="{F95F0201-6B3C-479C-9473-CC4C485F19A1}" dt="2022-08-22T14:23:09.271" v="1802" actId="165"/>
          <ac:grpSpMkLst>
            <pc:docMk/>
            <pc:sldMk cId="2704834836" sldId="310"/>
            <ac:grpSpMk id="65" creationId="{E4899C6F-12C5-5F44-BF19-B1BEF76964A0}"/>
          </ac:grpSpMkLst>
        </pc:grpChg>
        <pc:grpChg chg="del mod topLvl">
          <ac:chgData name="Filippo Acconcia" userId="844af49c-a8a0-47ac-a7dd-14a44b60cd18" providerId="ADAL" clId="{F95F0201-6B3C-479C-9473-CC4C485F19A1}" dt="2022-08-22T14:23:21.990" v="1805" actId="165"/>
          <ac:grpSpMkLst>
            <pc:docMk/>
            <pc:sldMk cId="2704834836" sldId="310"/>
            <ac:grpSpMk id="69" creationId="{5575DF58-1350-9E2F-F809-02F874D7947D}"/>
          </ac:grpSpMkLst>
        </pc:grpChg>
        <pc:grpChg chg="del mod topLvl">
          <ac:chgData name="Filippo Acconcia" userId="844af49c-a8a0-47ac-a7dd-14a44b60cd18" providerId="ADAL" clId="{F95F0201-6B3C-479C-9473-CC4C485F19A1}" dt="2022-08-22T14:23:17.351" v="1804" actId="165"/>
          <ac:grpSpMkLst>
            <pc:docMk/>
            <pc:sldMk cId="2704834836" sldId="310"/>
            <ac:grpSpMk id="73" creationId="{8423FBE3-2A32-8C3B-7FA5-C8692933A632}"/>
          </ac:grpSpMkLst>
        </pc:grpChg>
        <pc:grpChg chg="del mod topLvl">
          <ac:chgData name="Filippo Acconcia" userId="844af49c-a8a0-47ac-a7dd-14a44b60cd18" providerId="ADAL" clId="{F95F0201-6B3C-479C-9473-CC4C485F19A1}" dt="2022-08-22T14:23:13.501" v="1803" actId="165"/>
          <ac:grpSpMkLst>
            <pc:docMk/>
            <pc:sldMk cId="2704834836" sldId="310"/>
            <ac:grpSpMk id="77" creationId="{AA9F190F-408A-962E-9B64-25AD04C83BB7}"/>
          </ac:grpSpMkLst>
        </pc:grpChg>
        <pc:grpChg chg="mod">
          <ac:chgData name="Filippo Acconcia" userId="844af49c-a8a0-47ac-a7dd-14a44b60cd18" providerId="ADAL" clId="{F95F0201-6B3C-479C-9473-CC4C485F19A1}" dt="2022-09-04T09:57:23.972" v="1893" actId="1035"/>
          <ac:grpSpMkLst>
            <pc:docMk/>
            <pc:sldMk cId="2704834836" sldId="310"/>
            <ac:grpSpMk id="84" creationId="{B84FF955-B7A0-CD9E-A403-E5B26F81563F}"/>
          </ac:grpSpMkLst>
        </pc:grpChg>
        <pc:grpChg chg="del mod topLvl">
          <ac:chgData name="Filippo Acconcia" userId="844af49c-a8a0-47ac-a7dd-14a44b60cd18" providerId="ADAL" clId="{F95F0201-6B3C-479C-9473-CC4C485F19A1}" dt="2022-09-04T09:44:53.375" v="1817" actId="478"/>
          <ac:grpSpMkLst>
            <pc:docMk/>
            <pc:sldMk cId="2704834836" sldId="310"/>
            <ac:grpSpMk id="96" creationId="{E9567ECA-4262-8813-556C-62AF559AE161}"/>
          </ac:grpSpMkLst>
        </pc:grpChg>
        <pc:grpChg chg="del mod topLvl">
          <ac:chgData name="Filippo Acconcia" userId="844af49c-a8a0-47ac-a7dd-14a44b60cd18" providerId="ADAL" clId="{F95F0201-6B3C-479C-9473-CC4C485F19A1}" dt="2022-09-04T09:44:52.639" v="1816" actId="478"/>
          <ac:grpSpMkLst>
            <pc:docMk/>
            <pc:sldMk cId="2704834836" sldId="310"/>
            <ac:grpSpMk id="97" creationId="{3846BACA-6DC6-A659-95E8-6665CA5B97E7}"/>
          </ac:grpSpMkLst>
        </pc:grpChg>
        <pc:grpChg chg="mod topLvl">
          <ac:chgData name="Filippo Acconcia" userId="844af49c-a8a0-47ac-a7dd-14a44b60cd18" providerId="ADAL" clId="{F95F0201-6B3C-479C-9473-CC4C485F19A1}" dt="2022-09-04T09:45:00.696" v="1834" actId="1035"/>
          <ac:grpSpMkLst>
            <pc:docMk/>
            <pc:sldMk cId="2704834836" sldId="310"/>
            <ac:grpSpMk id="127" creationId="{62FD30BC-80F8-A5FA-A772-670CEF170456}"/>
          </ac:grpSpMkLst>
        </pc:grpChg>
        <pc:grpChg chg="mod topLvl">
          <ac:chgData name="Filippo Acconcia" userId="844af49c-a8a0-47ac-a7dd-14a44b60cd18" providerId="ADAL" clId="{F95F0201-6B3C-479C-9473-CC4C485F19A1}" dt="2022-09-04T09:45:00.696" v="1834" actId="1035"/>
          <ac:grpSpMkLst>
            <pc:docMk/>
            <pc:sldMk cId="2704834836" sldId="310"/>
            <ac:grpSpMk id="129" creationId="{BC6B3257-95C6-9988-4066-22E862DC7D41}"/>
          </ac:grpSpMkLst>
        </pc:grpChg>
        <pc:grpChg chg="del">
          <ac:chgData name="Filippo Acconcia" userId="844af49c-a8a0-47ac-a7dd-14a44b60cd18" providerId="ADAL" clId="{F95F0201-6B3C-479C-9473-CC4C485F19A1}" dt="2022-09-04T09:38:36.385" v="1813" actId="165"/>
          <ac:grpSpMkLst>
            <pc:docMk/>
            <pc:sldMk cId="2704834836" sldId="310"/>
            <ac:grpSpMk id="130" creationId="{B253C0EA-9F6D-EBED-3932-0AD5BCC977E3}"/>
          </ac:grpSpMkLst>
        </pc:grpChg>
        <pc:grpChg chg="del">
          <ac:chgData name="Filippo Acconcia" userId="844af49c-a8a0-47ac-a7dd-14a44b60cd18" providerId="ADAL" clId="{F95F0201-6B3C-479C-9473-CC4C485F19A1}" dt="2022-09-04T09:38:36.385" v="1813" actId="165"/>
          <ac:grpSpMkLst>
            <pc:docMk/>
            <pc:sldMk cId="2704834836" sldId="310"/>
            <ac:grpSpMk id="131" creationId="{D4C50718-A47B-449D-DFDD-1F40F96FE439}"/>
          </ac:grpSpMkLst>
        </pc:grpChg>
        <pc:grpChg chg="add mod">
          <ac:chgData name="Filippo Acconcia" userId="844af49c-a8a0-47ac-a7dd-14a44b60cd18" providerId="ADAL" clId="{F95F0201-6B3C-479C-9473-CC4C485F19A1}" dt="2022-09-04T09:57:23.972" v="1893" actId="1035"/>
          <ac:grpSpMkLst>
            <pc:docMk/>
            <pc:sldMk cId="2704834836" sldId="310"/>
            <ac:grpSpMk id="146" creationId="{86B6BB0E-9F81-316C-9A5D-A503C0EB95B4}"/>
          </ac:grpSpMkLst>
        </pc:grpChg>
        <pc:picChg chg="mod topLvl">
          <ac:chgData name="Filippo Acconcia" userId="844af49c-a8a0-47ac-a7dd-14a44b60cd18" providerId="ADAL" clId="{F95F0201-6B3C-479C-9473-CC4C485F19A1}" dt="2022-08-22T14:23:57.433" v="1812" actId="164"/>
          <ac:picMkLst>
            <pc:docMk/>
            <pc:sldMk cId="2704834836" sldId="310"/>
            <ac:picMk id="63" creationId="{96704F1D-5AA0-255B-6680-4EC04021E8E7}"/>
          </ac:picMkLst>
        </pc:picChg>
        <pc:picChg chg="mod topLvl">
          <ac:chgData name="Filippo Acconcia" userId="844af49c-a8a0-47ac-a7dd-14a44b60cd18" providerId="ADAL" clId="{F95F0201-6B3C-479C-9473-CC4C485F19A1}" dt="2022-08-22T14:23:57.433" v="1812" actId="164"/>
          <ac:picMkLst>
            <pc:docMk/>
            <pc:sldMk cId="2704834836" sldId="310"/>
            <ac:picMk id="68" creationId="{2A7906AF-18A7-6717-2F3F-886F13C3FEAA}"/>
          </ac:picMkLst>
        </pc:picChg>
        <pc:picChg chg="mod topLvl">
          <ac:chgData name="Filippo Acconcia" userId="844af49c-a8a0-47ac-a7dd-14a44b60cd18" providerId="ADAL" clId="{F95F0201-6B3C-479C-9473-CC4C485F19A1}" dt="2022-08-22T14:23:57.433" v="1812" actId="164"/>
          <ac:picMkLst>
            <pc:docMk/>
            <pc:sldMk cId="2704834836" sldId="310"/>
            <ac:picMk id="72" creationId="{D2BFC0DB-8070-1E22-CE20-2A9C2F875DE6}"/>
          </ac:picMkLst>
        </pc:picChg>
        <pc:picChg chg="mod topLvl">
          <ac:chgData name="Filippo Acconcia" userId="844af49c-a8a0-47ac-a7dd-14a44b60cd18" providerId="ADAL" clId="{F95F0201-6B3C-479C-9473-CC4C485F19A1}" dt="2022-08-22T14:23:57.433" v="1812" actId="164"/>
          <ac:picMkLst>
            <pc:docMk/>
            <pc:sldMk cId="2704834836" sldId="310"/>
            <ac:picMk id="76" creationId="{CA51F316-5455-1556-B1AB-5F2708AD3BE6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79" creationId="{3A6BA00A-502C-63B2-EEE8-271C22A00249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80" creationId="{A8C5F064-8EFC-513A-9090-0CD4D5EAF37B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81" creationId="{218DFA09-98F7-02F9-1AD7-C4D3CC76ED7C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83" creationId="{598C6FB1-3CEA-224B-43CE-E1270A001CF0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111" creationId="{6A6010A8-75CB-1214-98EA-CF9CD0A80261}"/>
          </ac:picMkLst>
        </pc:picChg>
        <pc:picChg chg="mod">
          <ac:chgData name="Filippo Acconcia" userId="844af49c-a8a0-47ac-a7dd-14a44b60cd18" providerId="ADAL" clId="{F95F0201-6B3C-479C-9473-CC4C485F19A1}" dt="2022-09-04T09:38:36.385" v="1813" actId="165"/>
          <ac:picMkLst>
            <pc:docMk/>
            <pc:sldMk cId="2704834836" sldId="310"/>
            <ac:picMk id="128" creationId="{D1F17F05-A42C-77E9-3854-305004E9DDF5}"/>
          </ac:picMkLst>
        </pc:picChg>
        <pc:cxnChg chg="mod">
          <ac:chgData name="Filippo Acconcia" userId="844af49c-a8a0-47ac-a7dd-14a44b60cd18" providerId="ADAL" clId="{F95F0201-6B3C-479C-9473-CC4C485F19A1}" dt="2022-09-04T09:38:36.385" v="1813" actId="165"/>
          <ac:cxnSpMkLst>
            <pc:docMk/>
            <pc:sldMk cId="2704834836" sldId="310"/>
            <ac:cxnSpMk id="54" creationId="{0AB0FC07-A946-588B-DB97-BF9CA247A543}"/>
          </ac:cxnSpMkLst>
        </pc:cxnChg>
        <pc:cxnChg chg="mod topLvl">
          <ac:chgData name="Filippo Acconcia" userId="844af49c-a8a0-47ac-a7dd-14a44b60cd18" providerId="ADAL" clId="{F95F0201-6B3C-479C-9473-CC4C485F19A1}" dt="2022-08-22T14:23:57.433" v="1812" actId="164"/>
          <ac:cxnSpMkLst>
            <pc:docMk/>
            <pc:sldMk cId="2704834836" sldId="310"/>
            <ac:cxnSpMk id="66" creationId="{3856A466-0A61-E19F-A039-2E819ACD7800}"/>
          </ac:cxnSpMkLst>
        </pc:cxnChg>
        <pc:cxnChg chg="mod topLvl">
          <ac:chgData name="Filippo Acconcia" userId="844af49c-a8a0-47ac-a7dd-14a44b60cd18" providerId="ADAL" clId="{F95F0201-6B3C-479C-9473-CC4C485F19A1}" dt="2022-08-22T14:23:57.433" v="1812" actId="164"/>
          <ac:cxnSpMkLst>
            <pc:docMk/>
            <pc:sldMk cId="2704834836" sldId="310"/>
            <ac:cxnSpMk id="70" creationId="{FD70B302-86AC-157F-E91E-FE417FFB1A64}"/>
          </ac:cxnSpMkLst>
        </pc:cxnChg>
        <pc:cxnChg chg="mod topLvl">
          <ac:chgData name="Filippo Acconcia" userId="844af49c-a8a0-47ac-a7dd-14a44b60cd18" providerId="ADAL" clId="{F95F0201-6B3C-479C-9473-CC4C485F19A1}" dt="2022-08-22T14:23:57.433" v="1812" actId="164"/>
          <ac:cxnSpMkLst>
            <pc:docMk/>
            <pc:sldMk cId="2704834836" sldId="310"/>
            <ac:cxnSpMk id="74" creationId="{B410677C-948D-2C83-FEE2-CFD7F416D44C}"/>
          </ac:cxnSpMkLst>
        </pc:cxnChg>
        <pc:cxnChg chg="mod topLvl">
          <ac:chgData name="Filippo Acconcia" userId="844af49c-a8a0-47ac-a7dd-14a44b60cd18" providerId="ADAL" clId="{F95F0201-6B3C-479C-9473-CC4C485F19A1}" dt="2022-08-22T14:23:57.433" v="1812" actId="164"/>
          <ac:cxnSpMkLst>
            <pc:docMk/>
            <pc:sldMk cId="2704834836" sldId="310"/>
            <ac:cxnSpMk id="78" creationId="{C2E1E017-71A5-8E39-5B8E-763C3112BA29}"/>
          </ac:cxnSpMkLst>
        </pc:cxnChg>
        <pc:cxnChg chg="mod">
          <ac:chgData name="Filippo Acconcia" userId="844af49c-a8a0-47ac-a7dd-14a44b60cd18" providerId="ADAL" clId="{F95F0201-6B3C-479C-9473-CC4C485F19A1}" dt="2022-09-04T09:38:36.385" v="1813" actId="165"/>
          <ac:cxnSpMkLst>
            <pc:docMk/>
            <pc:sldMk cId="2704834836" sldId="310"/>
            <ac:cxnSpMk id="87" creationId="{B2A85B56-849F-DB8B-DE24-1E78ED942E82}"/>
          </ac:cxnSpMkLst>
        </pc:cxnChg>
        <pc:cxnChg chg="mod">
          <ac:chgData name="Filippo Acconcia" userId="844af49c-a8a0-47ac-a7dd-14a44b60cd18" providerId="ADAL" clId="{F95F0201-6B3C-479C-9473-CC4C485F19A1}" dt="2022-09-04T09:38:36.385" v="1813" actId="165"/>
          <ac:cxnSpMkLst>
            <pc:docMk/>
            <pc:sldMk cId="2704834836" sldId="310"/>
            <ac:cxnSpMk id="110" creationId="{6857CBEA-9D8D-AF89-F4B3-9BA10AB6CDB2}"/>
          </ac:cxnSpMkLst>
        </pc:cxnChg>
        <pc:cxnChg chg="mod">
          <ac:chgData name="Filippo Acconcia" userId="844af49c-a8a0-47ac-a7dd-14a44b60cd18" providerId="ADAL" clId="{F95F0201-6B3C-479C-9473-CC4C485F19A1}" dt="2022-09-04T09:38:36.385" v="1813" actId="165"/>
          <ac:cxnSpMkLst>
            <pc:docMk/>
            <pc:sldMk cId="2704834836" sldId="310"/>
            <ac:cxnSpMk id="124" creationId="{62CA3027-EE23-B68C-93E3-EEB53BD9ACFB}"/>
          </ac:cxnSpMkLst>
        </pc:cxnChg>
      </pc:sldChg>
      <pc:sldChg chg="addSp delSp modSp new mod">
        <pc:chgData name="Filippo Acconcia" userId="844af49c-a8a0-47ac-a7dd-14a44b60cd18" providerId="ADAL" clId="{F95F0201-6B3C-479C-9473-CC4C485F19A1}" dt="2022-07-30T15:31:18.690" v="1151" actId="164"/>
        <pc:sldMkLst>
          <pc:docMk/>
          <pc:sldMk cId="3174756778" sldId="311"/>
        </pc:sldMkLst>
        <pc:spChg chg="add mod">
          <ac:chgData name="Filippo Acconcia" userId="844af49c-a8a0-47ac-a7dd-14a44b60cd18" providerId="ADAL" clId="{F95F0201-6B3C-479C-9473-CC4C485F19A1}" dt="2022-07-30T15:09:37" v="794" actId="20577"/>
          <ac:spMkLst>
            <pc:docMk/>
            <pc:sldMk cId="3174756778" sldId="311"/>
            <ac:spMk id="2" creationId="{D32F19C5-789A-E9D2-6AC1-7FCF0D64FB11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7" creationId="{6B7742B2-A5AE-7FEA-243F-7128AF7FAB30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8" creationId="{765C5D92-F10A-4BDA-1CAE-50FEA7619D9A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9" creationId="{0C166466-E17C-9A4C-A0E2-7C4CDFDB3065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0" creationId="{1CC4439B-5F96-9FB5-2BDA-5C0AEBFC667F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1" creationId="{635E6387-13D1-7CF5-B3CB-D987FBFA2563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2" creationId="{D0728CCE-3D4E-C4F2-A85F-2E09537706D5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3" creationId="{F33202FD-3E58-B255-1152-E610D8EDAF5F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4" creationId="{6D2C04AF-3BDF-19C9-9977-1D7C94803102}"/>
          </ac:spMkLst>
        </pc:spChg>
        <pc:spChg chg="mod topLvl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15" creationId="{CFA3A488-F81B-DB30-A928-1C3A47F770E6}"/>
          </ac:spMkLst>
        </pc:spChg>
        <pc:spChg chg="del mod topLvl">
          <ac:chgData name="Filippo Acconcia" userId="844af49c-a8a0-47ac-a7dd-14a44b60cd18" providerId="ADAL" clId="{F95F0201-6B3C-479C-9473-CC4C485F19A1}" dt="2022-07-30T15:14:09.976" v="819" actId="478"/>
          <ac:spMkLst>
            <pc:docMk/>
            <pc:sldMk cId="3174756778" sldId="311"/>
            <ac:spMk id="17" creationId="{8595BD7F-B409-9A72-DBD5-C10493717994}"/>
          </ac:spMkLst>
        </pc:spChg>
        <pc:spChg chg="del mod topLvl">
          <ac:chgData name="Filippo Acconcia" userId="844af49c-a8a0-47ac-a7dd-14a44b60cd18" providerId="ADAL" clId="{F95F0201-6B3C-479C-9473-CC4C485F19A1}" dt="2022-07-30T15:14:09.976" v="819" actId="478"/>
          <ac:spMkLst>
            <pc:docMk/>
            <pc:sldMk cId="3174756778" sldId="311"/>
            <ac:spMk id="18" creationId="{437D7F15-F148-3DB9-3FC4-BFCE263E91BD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0" creationId="{907D010A-0D5B-2BC3-3157-7618AE7F8396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1" creationId="{502C8A4A-807A-0607-B9A4-C91628B443EC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3" creationId="{38959D6F-9EB2-F3AC-400F-0E91AF7AA70C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4" creationId="{AA549293-3167-2F07-46A5-F4455A6A278A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5" creationId="{128C135D-D130-C793-E361-14B9532C9311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6" creationId="{C30D2FB2-28A2-D67A-CB75-990C160E22E6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7" creationId="{54950C76-6F78-3130-AB97-DF632AA4B876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8" creationId="{1CD089D4-E08A-E7E9-CB98-EA59B0FB1C4F}"/>
          </ac:spMkLst>
        </pc:spChg>
        <pc:spChg chg="mod">
          <ac:chgData name="Filippo Acconcia" userId="844af49c-a8a0-47ac-a7dd-14a44b60cd18" providerId="ADAL" clId="{F95F0201-6B3C-479C-9473-CC4C485F19A1}" dt="2022-07-30T15:12:59.652" v="797" actId="165"/>
          <ac:spMkLst>
            <pc:docMk/>
            <pc:sldMk cId="3174756778" sldId="311"/>
            <ac:spMk id="29" creationId="{4F4A99AD-5AC7-6897-4E10-F0A7A3C5A0B2}"/>
          </ac:spMkLst>
        </pc:spChg>
        <pc:spChg chg="add mod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33" creationId="{07AE722B-B4EA-AA1C-158B-B83FC4D8A6EF}"/>
          </ac:spMkLst>
        </pc:spChg>
        <pc:spChg chg="add mod">
          <ac:chgData name="Filippo Acconcia" userId="844af49c-a8a0-47ac-a7dd-14a44b60cd18" providerId="ADAL" clId="{F95F0201-6B3C-479C-9473-CC4C485F19A1}" dt="2022-07-30T15:19:34.158" v="1000" actId="164"/>
          <ac:spMkLst>
            <pc:docMk/>
            <pc:sldMk cId="3174756778" sldId="311"/>
            <ac:spMk id="34" creationId="{DC9ED4B6-90FC-D7BE-A136-9B43F6C6E728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37" creationId="{8DB3061F-F03C-5247-315A-FC48DEA34B38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38" creationId="{E0C38E90-4CB5-EDA9-F3F8-75E1DFC4CDCB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39" creationId="{69CBF8BD-1445-AE8E-494F-F829E07DDA3E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40" creationId="{4E003D6B-1A1F-E8B8-5781-0A201F5B2EF9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41" creationId="{E188271A-DC38-1437-8FEF-EB82C64E9212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42" creationId="{0FB3BE10-5250-A63F-C636-1A4B05461082}"/>
          </ac:spMkLst>
        </pc:spChg>
        <pc:spChg chg="add mod">
          <ac:chgData name="Filippo Acconcia" userId="844af49c-a8a0-47ac-a7dd-14a44b60cd18" providerId="ADAL" clId="{F95F0201-6B3C-479C-9473-CC4C485F19A1}" dt="2022-07-30T15:18:57.325" v="974" actId="164"/>
          <ac:spMkLst>
            <pc:docMk/>
            <pc:sldMk cId="3174756778" sldId="311"/>
            <ac:spMk id="43" creationId="{237F9393-7D83-84A7-A038-543BC3C84F69}"/>
          </ac:spMkLst>
        </pc:spChg>
        <pc:spChg chg="del mod topLvl">
          <ac:chgData name="Filippo Acconcia" userId="844af49c-a8a0-47ac-a7dd-14a44b60cd18" providerId="ADAL" clId="{F95F0201-6B3C-479C-9473-CC4C485F19A1}" dt="2022-07-30T15:27:33.378" v="1027" actId="478"/>
          <ac:spMkLst>
            <pc:docMk/>
            <pc:sldMk cId="3174756778" sldId="311"/>
            <ac:spMk id="48" creationId="{ACCD223B-E533-3FDF-CA06-06F92747C1D9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49" creationId="{05D6AAB4-99D6-F7C5-FDF8-421486660A3C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0" creationId="{C549B55A-FDCB-962D-BFD9-222962E5E690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1" creationId="{ADF073FF-A89E-D749-955C-580D40015220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2" creationId="{91BBD907-1250-C1DB-831E-384C865D1A06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3" creationId="{014AB04B-B783-1EBD-A370-B7962694CE8F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4" creationId="{157CB351-8907-91DD-969B-B94280EF507C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5" creationId="{9C37A9E9-6A74-EDD7-F8C8-A88168E75BF3}"/>
          </ac:spMkLst>
        </pc:spChg>
        <pc:spChg chg="mod topLvl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6" creationId="{D8ED4ABC-BD84-4325-749B-A269436E5F9F}"/>
          </ac:spMkLst>
        </pc:spChg>
        <pc:spChg chg="mod topLvl">
          <ac:chgData name="Filippo Acconcia" userId="844af49c-a8a0-47ac-a7dd-14a44b60cd18" providerId="ADAL" clId="{F95F0201-6B3C-479C-9473-CC4C485F19A1}" dt="2022-07-30T15:31:18.690" v="1151" actId="164"/>
          <ac:spMkLst>
            <pc:docMk/>
            <pc:sldMk cId="3174756778" sldId="311"/>
            <ac:spMk id="57" creationId="{7D871B02-34F2-340E-35B8-D380AF458700}"/>
          </ac:spMkLst>
        </pc:spChg>
        <pc:spChg chg="add mod">
          <ac:chgData name="Filippo Acconcia" userId="844af49c-a8a0-47ac-a7dd-14a44b60cd18" providerId="ADAL" clId="{F95F0201-6B3C-479C-9473-CC4C485F19A1}" dt="2022-07-30T15:30:34.377" v="1126" actId="164"/>
          <ac:spMkLst>
            <pc:docMk/>
            <pc:sldMk cId="3174756778" sldId="311"/>
            <ac:spMk id="58" creationId="{DF6B2258-2433-8E49-5593-EDF65CBA5854}"/>
          </ac:spMkLst>
        </pc:spChg>
        <pc:spChg chg="add mod">
          <ac:chgData name="Filippo Acconcia" userId="844af49c-a8a0-47ac-a7dd-14a44b60cd18" providerId="ADAL" clId="{F95F0201-6B3C-479C-9473-CC4C485F19A1}" dt="2022-07-30T15:30:51.961" v="1147" actId="1038"/>
          <ac:spMkLst>
            <pc:docMk/>
            <pc:sldMk cId="3174756778" sldId="311"/>
            <ac:spMk id="61" creationId="{B086FAD5-80E0-0251-13B8-8EFC02065511}"/>
          </ac:spMkLst>
        </pc:spChg>
        <pc:spChg chg="add mod">
          <ac:chgData name="Filippo Acconcia" userId="844af49c-a8a0-47ac-a7dd-14a44b60cd18" providerId="ADAL" clId="{F95F0201-6B3C-479C-9473-CC4C485F19A1}" dt="2022-07-30T15:30:47.406" v="1132" actId="1037"/>
          <ac:spMkLst>
            <pc:docMk/>
            <pc:sldMk cId="3174756778" sldId="311"/>
            <ac:spMk id="62" creationId="{7135C369-C402-746F-FD3E-ED6209372D94}"/>
          </ac:spMkLst>
        </pc:spChg>
        <pc:grpChg chg="add del mod">
          <ac:chgData name="Filippo Acconcia" userId="844af49c-a8a0-47ac-a7dd-14a44b60cd18" providerId="ADAL" clId="{F95F0201-6B3C-479C-9473-CC4C485F19A1}" dt="2022-07-30T15:12:59.652" v="797" actId="165"/>
          <ac:grpSpMkLst>
            <pc:docMk/>
            <pc:sldMk cId="3174756778" sldId="311"/>
            <ac:grpSpMk id="3" creationId="{55FB77A4-C15E-1409-FF60-D90F87E3C584}"/>
          </ac:grpSpMkLst>
        </pc:grpChg>
        <pc:grpChg chg="del mod topLvl">
          <ac:chgData name="Filippo Acconcia" userId="844af49c-a8a0-47ac-a7dd-14a44b60cd18" providerId="ADAL" clId="{F95F0201-6B3C-479C-9473-CC4C485F19A1}" dt="2022-07-30T15:13:06.049" v="799" actId="478"/>
          <ac:grpSpMkLst>
            <pc:docMk/>
            <pc:sldMk cId="3174756778" sldId="311"/>
            <ac:grpSpMk id="4" creationId="{451598B4-55B9-0A6F-0B2F-0D05982963D8}"/>
          </ac:grpSpMkLst>
        </pc:grpChg>
        <pc:grpChg chg="del mod topLvl">
          <ac:chgData name="Filippo Acconcia" userId="844af49c-a8a0-47ac-a7dd-14a44b60cd18" providerId="ADAL" clId="{F95F0201-6B3C-479C-9473-CC4C485F19A1}" dt="2022-07-30T15:13:12.178" v="801" actId="165"/>
          <ac:grpSpMkLst>
            <pc:docMk/>
            <pc:sldMk cId="3174756778" sldId="311"/>
            <ac:grpSpMk id="5" creationId="{52842BAF-9BD1-46FD-5451-97F58ABE3500}"/>
          </ac:grpSpMkLst>
        </pc:grpChg>
        <pc:grpChg chg="add mod">
          <ac:chgData name="Filippo Acconcia" userId="844af49c-a8a0-47ac-a7dd-14a44b60cd18" providerId="ADAL" clId="{F95F0201-6B3C-479C-9473-CC4C485F19A1}" dt="2022-07-30T15:19:34.158" v="1000" actId="164"/>
          <ac:grpSpMkLst>
            <pc:docMk/>
            <pc:sldMk cId="3174756778" sldId="311"/>
            <ac:grpSpMk id="44" creationId="{F0FCCA48-C6BE-6470-BC67-81B2C137DAB5}"/>
          </ac:grpSpMkLst>
        </pc:grpChg>
        <pc:grpChg chg="add mod">
          <ac:chgData name="Filippo Acconcia" userId="844af49c-a8a0-47ac-a7dd-14a44b60cd18" providerId="ADAL" clId="{F95F0201-6B3C-479C-9473-CC4C485F19A1}" dt="2022-07-30T15:19:38.338" v="1001" actId="1076"/>
          <ac:grpSpMkLst>
            <pc:docMk/>
            <pc:sldMk cId="3174756778" sldId="311"/>
            <ac:grpSpMk id="45" creationId="{8739A73D-9DA9-B3B3-8EAD-845846874495}"/>
          </ac:grpSpMkLst>
        </pc:grpChg>
        <pc:grpChg chg="add del mod">
          <ac:chgData name="Filippo Acconcia" userId="844af49c-a8a0-47ac-a7dd-14a44b60cd18" providerId="ADAL" clId="{F95F0201-6B3C-479C-9473-CC4C485F19A1}" dt="2022-07-30T15:27:14.224" v="1004" actId="165"/>
          <ac:grpSpMkLst>
            <pc:docMk/>
            <pc:sldMk cId="3174756778" sldId="311"/>
            <ac:grpSpMk id="46" creationId="{4B8EB9D9-F76F-6D84-1313-A5C55DD1C9AF}"/>
          </ac:grpSpMkLst>
        </pc:grpChg>
        <pc:grpChg chg="add mod">
          <ac:chgData name="Filippo Acconcia" userId="844af49c-a8a0-47ac-a7dd-14a44b60cd18" providerId="ADAL" clId="{F95F0201-6B3C-479C-9473-CC4C485F19A1}" dt="2022-07-30T15:31:18.690" v="1151" actId="164"/>
          <ac:grpSpMkLst>
            <pc:docMk/>
            <pc:sldMk cId="3174756778" sldId="311"/>
            <ac:grpSpMk id="60" creationId="{23359F62-6526-7379-8CFA-EDBDA9F66894}"/>
          </ac:grpSpMkLst>
        </pc:grpChg>
        <pc:grpChg chg="add mod">
          <ac:chgData name="Filippo Acconcia" userId="844af49c-a8a0-47ac-a7dd-14a44b60cd18" providerId="ADAL" clId="{F95F0201-6B3C-479C-9473-CC4C485F19A1}" dt="2022-07-30T15:31:18.690" v="1151" actId="164"/>
          <ac:grpSpMkLst>
            <pc:docMk/>
            <pc:sldMk cId="3174756778" sldId="311"/>
            <ac:grpSpMk id="63" creationId="{0D31C916-3E2A-E1FB-477C-0198B1C871F0}"/>
          </ac:grpSpMkLst>
        </pc:grpChg>
        <pc:picChg chg="del mod topLvl">
          <ac:chgData name="Filippo Acconcia" userId="844af49c-a8a0-47ac-a7dd-14a44b60cd18" providerId="ADAL" clId="{F95F0201-6B3C-479C-9473-CC4C485F19A1}" dt="2022-07-30T15:14:41.240" v="825" actId="478"/>
          <ac:picMkLst>
            <pc:docMk/>
            <pc:sldMk cId="3174756778" sldId="311"/>
            <ac:picMk id="6" creationId="{FA8F60D7-9064-0356-E623-6433C93D8543}"/>
          </ac:picMkLst>
        </pc:picChg>
        <pc:picChg chg="mod">
          <ac:chgData name="Filippo Acconcia" userId="844af49c-a8a0-47ac-a7dd-14a44b60cd18" providerId="ADAL" clId="{F95F0201-6B3C-479C-9473-CC4C485F19A1}" dt="2022-07-30T15:12:59.652" v="797" actId="165"/>
          <ac:picMkLst>
            <pc:docMk/>
            <pc:sldMk cId="3174756778" sldId="311"/>
            <ac:picMk id="19" creationId="{2591DCAF-88C7-C3BE-CF05-2586523B8952}"/>
          </ac:picMkLst>
        </pc:picChg>
        <pc:picChg chg="mod">
          <ac:chgData name="Filippo Acconcia" userId="844af49c-a8a0-47ac-a7dd-14a44b60cd18" providerId="ADAL" clId="{F95F0201-6B3C-479C-9473-CC4C485F19A1}" dt="2022-07-30T15:12:59.652" v="797" actId="165"/>
          <ac:picMkLst>
            <pc:docMk/>
            <pc:sldMk cId="3174756778" sldId="311"/>
            <ac:picMk id="30" creationId="{8C81BB75-F207-4892-E2D2-15AC6C1EBE22}"/>
          </ac:picMkLst>
        </pc:picChg>
        <pc:picChg chg="mod ord">
          <ac:chgData name="Filippo Acconcia" userId="844af49c-a8a0-47ac-a7dd-14a44b60cd18" providerId="ADAL" clId="{F95F0201-6B3C-479C-9473-CC4C485F19A1}" dt="2022-07-30T15:19:34.158" v="1000" actId="164"/>
          <ac:picMkLst>
            <pc:docMk/>
            <pc:sldMk cId="3174756778" sldId="311"/>
            <ac:picMk id="31" creationId="{0CABB75A-6F88-A979-B0F5-060E495D2263}"/>
          </ac:picMkLst>
        </pc:picChg>
        <pc:picChg chg="mod">
          <ac:chgData name="Filippo Acconcia" userId="844af49c-a8a0-47ac-a7dd-14a44b60cd18" providerId="ADAL" clId="{F95F0201-6B3C-479C-9473-CC4C485F19A1}" dt="2022-07-30T15:18:57.325" v="974" actId="164"/>
          <ac:picMkLst>
            <pc:docMk/>
            <pc:sldMk cId="3174756778" sldId="311"/>
            <ac:picMk id="32" creationId="{EA521B2B-9A27-0625-2812-213DBAC3221F}"/>
          </ac:picMkLst>
        </pc:picChg>
        <pc:picChg chg="del mod topLvl">
          <ac:chgData name="Filippo Acconcia" userId="844af49c-a8a0-47ac-a7dd-14a44b60cd18" providerId="ADAL" clId="{F95F0201-6B3C-479C-9473-CC4C485F19A1}" dt="2022-07-30T15:30:29.409" v="1125" actId="478"/>
          <ac:picMkLst>
            <pc:docMk/>
            <pc:sldMk cId="3174756778" sldId="311"/>
            <ac:picMk id="47" creationId="{4C0E6AA9-2247-02AC-FE75-6571C40526B8}"/>
          </ac:picMkLst>
        </pc:picChg>
        <pc:picChg chg="mod ord">
          <ac:chgData name="Filippo Acconcia" userId="844af49c-a8a0-47ac-a7dd-14a44b60cd18" providerId="ADAL" clId="{F95F0201-6B3C-479C-9473-CC4C485F19A1}" dt="2022-07-30T15:30:34.377" v="1126" actId="164"/>
          <ac:picMkLst>
            <pc:docMk/>
            <pc:sldMk cId="3174756778" sldId="311"/>
            <ac:picMk id="59" creationId="{D3E09387-F362-B111-EB3D-EBB94D3C07A2}"/>
          </ac:picMkLst>
        </pc:picChg>
        <pc:cxnChg chg="del mod topLvl">
          <ac:chgData name="Filippo Acconcia" userId="844af49c-a8a0-47ac-a7dd-14a44b60cd18" providerId="ADAL" clId="{F95F0201-6B3C-479C-9473-CC4C485F19A1}" dt="2022-07-30T15:16:59.949" v="906" actId="478"/>
          <ac:cxnSpMkLst>
            <pc:docMk/>
            <pc:sldMk cId="3174756778" sldId="311"/>
            <ac:cxnSpMk id="16" creationId="{7D424594-9A22-6B17-B137-61669E7BCA51}"/>
          </ac:cxnSpMkLst>
        </pc:cxnChg>
        <pc:cxnChg chg="mod">
          <ac:chgData name="Filippo Acconcia" userId="844af49c-a8a0-47ac-a7dd-14a44b60cd18" providerId="ADAL" clId="{F95F0201-6B3C-479C-9473-CC4C485F19A1}" dt="2022-07-30T15:12:59.652" v="797" actId="165"/>
          <ac:cxnSpMkLst>
            <pc:docMk/>
            <pc:sldMk cId="3174756778" sldId="311"/>
            <ac:cxnSpMk id="22" creationId="{840F0783-FD5D-CB3C-48F3-D1276CA9609E}"/>
          </ac:cxnSpMkLst>
        </pc:cxnChg>
        <pc:cxnChg chg="add mod">
          <ac:chgData name="Filippo Acconcia" userId="844af49c-a8a0-47ac-a7dd-14a44b60cd18" providerId="ADAL" clId="{F95F0201-6B3C-479C-9473-CC4C485F19A1}" dt="2022-07-30T15:19:34.158" v="1000" actId="164"/>
          <ac:cxnSpMkLst>
            <pc:docMk/>
            <pc:sldMk cId="3174756778" sldId="311"/>
            <ac:cxnSpMk id="36" creationId="{BF197A0E-A983-D45F-863F-F8D15B9ABCBE}"/>
          </ac:cxnSpMkLst>
        </pc:cxnChg>
      </pc:sldChg>
    </pc:docChg>
  </pc:docChgLst>
  <pc:docChgLst>
    <pc:chgData name="Filippo Acconcia" userId="844af49c-a8a0-47ac-a7dd-14a44b60cd18" providerId="ADAL" clId="{048DD00B-03E5-43EF-A8F4-38DD4BCCA11C}"/>
    <pc:docChg chg="custSel modSld">
      <pc:chgData name="Filippo Acconcia" userId="844af49c-a8a0-47ac-a7dd-14a44b60cd18" providerId="ADAL" clId="{048DD00B-03E5-43EF-A8F4-38DD4BCCA11C}" dt="2022-10-29T13:58:43.443" v="0" actId="21"/>
      <pc:docMkLst>
        <pc:docMk/>
      </pc:docMkLst>
      <pc:sldChg chg="delSp mod">
        <pc:chgData name="Filippo Acconcia" userId="844af49c-a8a0-47ac-a7dd-14a44b60cd18" providerId="ADAL" clId="{048DD00B-03E5-43EF-A8F4-38DD4BCCA11C}" dt="2022-10-29T13:58:43.443" v="0" actId="21"/>
        <pc:sldMkLst>
          <pc:docMk/>
          <pc:sldMk cId="2704834836" sldId="310"/>
        </pc:sldMkLst>
        <pc:spChg chg="del">
          <ac:chgData name="Filippo Acconcia" userId="844af49c-a8a0-47ac-a7dd-14a44b60cd18" providerId="ADAL" clId="{048DD00B-03E5-43EF-A8F4-38DD4BCCA11C}" dt="2022-10-29T13:58:43.443" v="0" actId="21"/>
          <ac:spMkLst>
            <pc:docMk/>
            <pc:sldMk cId="2704834836" sldId="310"/>
            <ac:spMk id="113" creationId="{E20A8941-A9B2-3A6C-1DFC-87417B0FD181}"/>
          </ac:spMkLst>
        </pc:spChg>
        <pc:spChg chg="del">
          <ac:chgData name="Filippo Acconcia" userId="844af49c-a8a0-47ac-a7dd-14a44b60cd18" providerId="ADAL" clId="{048DD00B-03E5-43EF-A8F4-38DD4BCCA11C}" dt="2022-10-29T13:58:43.443" v="0" actId="21"/>
          <ac:spMkLst>
            <pc:docMk/>
            <pc:sldMk cId="2704834836" sldId="310"/>
            <ac:spMk id="114" creationId="{37B624DC-BD1C-9BC9-A8D5-067E1D729D88}"/>
          </ac:spMkLst>
        </pc:spChg>
        <pc:grpChg chg="del">
          <ac:chgData name="Filippo Acconcia" userId="844af49c-a8a0-47ac-a7dd-14a44b60cd18" providerId="ADAL" clId="{048DD00B-03E5-43EF-A8F4-38DD4BCCA11C}" dt="2022-10-29T13:58:43.443" v="0" actId="21"/>
          <ac:grpSpMkLst>
            <pc:docMk/>
            <pc:sldMk cId="2704834836" sldId="310"/>
            <ac:grpSpMk id="84" creationId="{B84FF955-B7A0-CD9E-A403-E5B26F81563F}"/>
          </ac:grpSpMkLst>
        </pc:grpChg>
        <pc:grpChg chg="del">
          <ac:chgData name="Filippo Acconcia" userId="844af49c-a8a0-47ac-a7dd-14a44b60cd18" providerId="ADAL" clId="{048DD00B-03E5-43EF-A8F4-38DD4BCCA11C}" dt="2022-10-29T13:58:43.443" v="0" actId="21"/>
          <ac:grpSpMkLst>
            <pc:docMk/>
            <pc:sldMk cId="2704834836" sldId="310"/>
            <ac:grpSpMk id="146" creationId="{86B6BB0E-9F81-316C-9A5D-A503C0EB95B4}"/>
          </ac:grpSpMkLst>
        </pc:grpChg>
      </pc:sldChg>
    </pc:docChg>
  </pc:docChgLst>
  <pc:docChgLst>
    <pc:chgData name="Filippo" userId="844af49c-a8a0-47ac-a7dd-14a44b60cd18" providerId="ADAL" clId="{F95F0201-6B3C-479C-9473-CC4C485F19A1}"/>
    <pc:docChg chg="modSld">
      <pc:chgData name="Filippo" userId="844af49c-a8a0-47ac-a7dd-14a44b60cd18" providerId="ADAL" clId="{F95F0201-6B3C-479C-9473-CC4C485F19A1}" dt="2022-08-20T13:04:33.595" v="24" actId="12788"/>
      <pc:docMkLst>
        <pc:docMk/>
      </pc:docMkLst>
      <pc:sldChg chg="addSp modSp mod">
        <pc:chgData name="Filippo" userId="844af49c-a8a0-47ac-a7dd-14a44b60cd18" providerId="ADAL" clId="{F95F0201-6B3C-479C-9473-CC4C485F19A1}" dt="2022-08-20T13:04:33.595" v="24" actId="12788"/>
        <pc:sldMkLst>
          <pc:docMk/>
          <pc:sldMk cId="2704834836" sldId="310"/>
        </pc:sldMkLst>
        <pc:spChg chg="add mod">
          <ac:chgData name="Filippo" userId="844af49c-a8a0-47ac-a7dd-14a44b60cd18" providerId="ADAL" clId="{F95F0201-6B3C-479C-9473-CC4C485F19A1}" dt="2022-08-20T13:04:23.705" v="22" actId="552"/>
          <ac:spMkLst>
            <pc:docMk/>
            <pc:sldMk cId="2704834836" sldId="310"/>
            <ac:spMk id="3" creationId="{F41A731C-6E8D-393E-FB71-31BFCB8C8FE3}"/>
          </ac:spMkLst>
        </pc:spChg>
        <pc:spChg chg="add mod">
          <ac:chgData name="Filippo" userId="844af49c-a8a0-47ac-a7dd-14a44b60cd18" providerId="ADAL" clId="{F95F0201-6B3C-479C-9473-CC4C485F19A1}" dt="2022-08-20T13:04:33.595" v="24" actId="12788"/>
          <ac:spMkLst>
            <pc:docMk/>
            <pc:sldMk cId="2704834836" sldId="310"/>
            <ac:spMk id="4" creationId="{CCD08066-56ED-9E19-00A1-D98CE0480997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25" creationId="{579CB955-14D0-BE95-559B-F8E4331A1A2A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33" creationId="{16F8AD99-5F9F-A8C4-8B53-9C992EF10DCF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50" creationId="{D01F96FF-2238-4F3C-5479-05ED4B774E3F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51" creationId="{C9C66DBA-D58A-3389-7BB7-BC86DA1D4226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67" creationId="{267476A2-359A-0169-DF4B-5992960EF5DD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71" creationId="{9014A181-03D6-E444-3BD4-6CF17CBDA78F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75" creationId="{DE340F2A-30C4-3E6F-DA80-54D6D751F269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82" creationId="{036E8F84-3990-E2B6-F803-41FC59A01EEC}"/>
          </ac:spMkLst>
        </pc:spChg>
        <pc:spChg chg="mod">
          <ac:chgData name="Filippo" userId="844af49c-a8a0-47ac-a7dd-14a44b60cd18" providerId="ADAL" clId="{F95F0201-6B3C-479C-9473-CC4C485F19A1}" dt="2022-08-20T13:04:33.595" v="24" actId="12788"/>
          <ac:spMkLst>
            <pc:docMk/>
            <pc:sldMk cId="2704834836" sldId="310"/>
            <ac:spMk id="98" creationId="{D6A32688-DEC5-E854-8AF4-D41402392DCD}"/>
          </ac:spMkLst>
        </pc:spChg>
        <pc:spChg chg="mod">
          <ac:chgData name="Filippo" userId="844af49c-a8a0-47ac-a7dd-14a44b60cd18" providerId="ADAL" clId="{F95F0201-6B3C-479C-9473-CC4C485F19A1}" dt="2022-08-20T13:04:23.705" v="22" actId="552"/>
          <ac:spMkLst>
            <pc:docMk/>
            <pc:sldMk cId="2704834836" sldId="310"/>
            <ac:spMk id="99" creationId="{EB0BBE12-353E-601E-87EA-79CF0A9E61BB}"/>
          </ac:spMkLst>
        </pc:spChg>
        <pc:spChg chg="mod">
          <ac:chgData name="Filippo" userId="844af49c-a8a0-47ac-a7dd-14a44b60cd18" providerId="ADAL" clId="{F95F0201-6B3C-479C-9473-CC4C485F19A1}" dt="2022-08-20T13:04:33.595" v="24" actId="12788"/>
          <ac:spMkLst>
            <pc:docMk/>
            <pc:sldMk cId="2704834836" sldId="310"/>
            <ac:spMk id="105" creationId="{B4BC129B-DF4E-5BFA-62DF-B430AE1C991B}"/>
          </ac:spMkLst>
        </pc:spChg>
        <pc:spChg chg="mod">
          <ac:chgData name="Filippo" userId="844af49c-a8a0-47ac-a7dd-14a44b60cd18" providerId="ADAL" clId="{F95F0201-6B3C-479C-9473-CC4C485F19A1}" dt="2022-08-20T13:04:23.705" v="22" actId="552"/>
          <ac:spMkLst>
            <pc:docMk/>
            <pc:sldMk cId="2704834836" sldId="310"/>
            <ac:spMk id="112" creationId="{E80BAFBF-AB11-F7A2-BE9E-58CFC92229E9}"/>
          </ac:spMkLst>
        </pc:spChg>
        <pc:spChg chg="mod">
          <ac:chgData name="Filippo" userId="844af49c-a8a0-47ac-a7dd-14a44b60cd18" providerId="ADAL" clId="{F95F0201-6B3C-479C-9473-CC4C485F19A1}" dt="2022-08-20T13:04:33.595" v="24" actId="12788"/>
          <ac:spMkLst>
            <pc:docMk/>
            <pc:sldMk cId="2704834836" sldId="310"/>
            <ac:spMk id="113" creationId="{E20A8941-A9B2-3A6C-1DFC-87417B0FD181}"/>
          </ac:spMkLst>
        </pc:spChg>
        <pc:spChg chg="mod">
          <ac:chgData name="Filippo" userId="844af49c-a8a0-47ac-a7dd-14a44b60cd18" providerId="ADAL" clId="{F95F0201-6B3C-479C-9473-CC4C485F19A1}" dt="2022-08-20T13:04:23.705" v="22" actId="552"/>
          <ac:spMkLst>
            <pc:docMk/>
            <pc:sldMk cId="2704834836" sldId="310"/>
            <ac:spMk id="114" creationId="{37B624DC-BD1C-9BC9-A8D5-067E1D729D88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2" creationId="{8DCA1C86-84CA-426D-6D18-E02D7F728945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3" creationId="{F1512577-D94A-F690-0B7D-63E3F74705A9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4" creationId="{813A9313-D3D0-31B5-A4ED-91A13342D777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5" creationId="{91CFB882-1E99-C938-5954-B74994FE473E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6" creationId="{C9900155-A1A7-8EB9-1621-0B511E838421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7" creationId="{E431668A-1F46-5A63-BECE-BDD502A3C638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8" creationId="{EE8E1092-6939-B2B4-6FDE-BF7E861434E1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39" creationId="{3AA33AE0-CB60-2616-4645-64514C09ADDF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40" creationId="{4A36A7CD-D6BA-0B8C-73FD-98B34BA1FDAE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41" creationId="{99021294-6D0F-A1C9-FCA7-ADB2277ADA80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44" creationId="{F8F0D48E-5250-ED13-7881-0A797AF64D92}"/>
          </ac:spMkLst>
        </pc:spChg>
        <pc:spChg chg="mod">
          <ac:chgData name="Filippo" userId="844af49c-a8a0-47ac-a7dd-14a44b60cd18" providerId="ADAL" clId="{F95F0201-6B3C-479C-9473-CC4C485F19A1}" dt="2022-08-20T13:03:52.214" v="0"/>
          <ac:spMkLst>
            <pc:docMk/>
            <pc:sldMk cId="2704834836" sldId="310"/>
            <ac:spMk id="145" creationId="{B45F5C10-5335-1A02-14D3-558E695D52B4}"/>
          </ac:spMkLst>
        </pc:spChg>
        <pc:grpChg chg="add mod">
          <ac:chgData name="Filippo" userId="844af49c-a8a0-47ac-a7dd-14a44b60cd18" providerId="ADAL" clId="{F95F0201-6B3C-479C-9473-CC4C485F19A1}" dt="2022-08-20T13:04:13.003" v="10" actId="1037"/>
          <ac:grpSpMkLst>
            <pc:docMk/>
            <pc:sldMk cId="2704834836" sldId="310"/>
            <ac:grpSpMk id="5" creationId="{3A088B93-8A8D-8C9A-F3AD-C18EFB1C6C6A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27" creationId="{829B2ED9-A561-1FAA-9A7A-9F7488C4CFA6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32" creationId="{D718BEAD-0591-3B88-6F73-5CC0E1B3A971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58" creationId="{4D832EF0-CFA7-3ED2-9895-B9FD7C6ED9C4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62" creationId="{D4FF0776-6FB0-552B-BCD0-36DE3681E12C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65" creationId="{E4899C6F-12C5-5F44-BF19-B1BEF76964A0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69" creationId="{5575DF58-1350-9E2F-F809-02F874D7947D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73" creationId="{8423FBE3-2A32-8C3B-7FA5-C8692933A632}"/>
          </ac:grpSpMkLst>
        </pc:grpChg>
        <pc:grpChg chg="mod">
          <ac:chgData name="Filippo" userId="844af49c-a8a0-47ac-a7dd-14a44b60cd18" providerId="ADAL" clId="{F95F0201-6B3C-479C-9473-CC4C485F19A1}" dt="2022-08-20T13:03:52.214" v="0"/>
          <ac:grpSpMkLst>
            <pc:docMk/>
            <pc:sldMk cId="2704834836" sldId="310"/>
            <ac:grpSpMk id="77" creationId="{AA9F190F-408A-962E-9B64-25AD04C83BB7}"/>
          </ac:grpSpMkLst>
        </pc:grpChg>
        <pc:grpChg chg="add mod">
          <ac:chgData name="Filippo" userId="844af49c-a8a0-47ac-a7dd-14a44b60cd18" providerId="ADAL" clId="{F95F0201-6B3C-479C-9473-CC4C485F19A1}" dt="2022-08-20T13:04:18.044" v="21" actId="1038"/>
          <ac:grpSpMkLst>
            <pc:docMk/>
            <pc:sldMk cId="2704834836" sldId="310"/>
            <ac:grpSpMk id="84" creationId="{B84FF955-B7A0-CD9E-A403-E5B26F81563F}"/>
          </ac:grpSpMkLst>
        </pc:grpChg>
        <pc:picChg chg="mod">
          <ac:chgData name="Filippo" userId="844af49c-a8a0-47ac-a7dd-14a44b60cd18" providerId="ADAL" clId="{F95F0201-6B3C-479C-9473-CC4C485F19A1}" dt="2022-08-20T13:03:52.214" v="0"/>
          <ac:picMkLst>
            <pc:docMk/>
            <pc:sldMk cId="2704834836" sldId="310"/>
            <ac:picMk id="63" creationId="{96704F1D-5AA0-255B-6680-4EC04021E8E7}"/>
          </ac:picMkLst>
        </pc:picChg>
        <pc:picChg chg="mod">
          <ac:chgData name="Filippo" userId="844af49c-a8a0-47ac-a7dd-14a44b60cd18" providerId="ADAL" clId="{F95F0201-6B3C-479C-9473-CC4C485F19A1}" dt="2022-08-20T13:03:52.214" v="0"/>
          <ac:picMkLst>
            <pc:docMk/>
            <pc:sldMk cId="2704834836" sldId="310"/>
            <ac:picMk id="68" creationId="{2A7906AF-18A7-6717-2F3F-886F13C3FEAA}"/>
          </ac:picMkLst>
        </pc:picChg>
        <pc:picChg chg="mod">
          <ac:chgData name="Filippo" userId="844af49c-a8a0-47ac-a7dd-14a44b60cd18" providerId="ADAL" clId="{F95F0201-6B3C-479C-9473-CC4C485F19A1}" dt="2022-08-20T13:03:52.214" v="0"/>
          <ac:picMkLst>
            <pc:docMk/>
            <pc:sldMk cId="2704834836" sldId="310"/>
            <ac:picMk id="72" creationId="{D2BFC0DB-8070-1E22-CE20-2A9C2F875DE6}"/>
          </ac:picMkLst>
        </pc:picChg>
        <pc:picChg chg="mod">
          <ac:chgData name="Filippo" userId="844af49c-a8a0-47ac-a7dd-14a44b60cd18" providerId="ADAL" clId="{F95F0201-6B3C-479C-9473-CC4C485F19A1}" dt="2022-08-20T13:03:52.214" v="0"/>
          <ac:picMkLst>
            <pc:docMk/>
            <pc:sldMk cId="2704834836" sldId="310"/>
            <ac:picMk id="76" creationId="{CA51F316-5455-1556-B1AB-5F2708AD3BE6}"/>
          </ac:picMkLst>
        </pc:picChg>
        <pc:picChg chg="mod">
          <ac:chgData name="Filippo" userId="844af49c-a8a0-47ac-a7dd-14a44b60cd18" providerId="ADAL" clId="{F95F0201-6B3C-479C-9473-CC4C485F19A1}" dt="2022-08-20T13:03:52.214" v="0"/>
          <ac:picMkLst>
            <pc:docMk/>
            <pc:sldMk cId="2704834836" sldId="310"/>
            <ac:picMk id="95" creationId="{660105EB-325A-CFC9-6CEA-966F896D344D}"/>
          </ac:picMkLst>
        </pc:pic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66" creationId="{3856A466-0A61-E19F-A039-2E819ACD7800}"/>
          </ac:cxnSpMkLst>
        </pc:cxn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70" creationId="{FD70B302-86AC-157F-E91E-FE417FFB1A64}"/>
          </ac:cxnSpMkLst>
        </pc:cxn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74" creationId="{B410677C-948D-2C83-FEE2-CFD7F416D44C}"/>
          </ac:cxnSpMkLst>
        </pc:cxn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78" creationId="{C2E1E017-71A5-8E39-5B8E-763C3112BA29}"/>
          </ac:cxnSpMkLst>
        </pc:cxn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142" creationId="{58FBD7B3-A353-8348-57EF-15502CFAC5AC}"/>
          </ac:cxnSpMkLst>
        </pc:cxnChg>
        <pc:cxnChg chg="mod">
          <ac:chgData name="Filippo" userId="844af49c-a8a0-47ac-a7dd-14a44b60cd18" providerId="ADAL" clId="{F95F0201-6B3C-479C-9473-CC4C485F19A1}" dt="2022-08-20T13:03:52.214" v="0"/>
          <ac:cxnSpMkLst>
            <pc:docMk/>
            <pc:sldMk cId="2704834836" sldId="310"/>
            <ac:cxnSpMk id="143" creationId="{6C7EABE8-6C44-1E13-BA34-B3DECB3229FB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>
            <a:extLst>
              <a:ext uri="{FF2B5EF4-FFF2-40B4-BE49-F238E27FC236}">
                <a16:creationId xmlns:a16="http://schemas.microsoft.com/office/drawing/2014/main" id="{3021E025-0A0C-48B1-8E0F-284826AC1F7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AD1D041-419B-4C71-976A-1EB4D9DD3D2E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616DD4C-8BBB-49EC-A3AB-1185B6705009}" type="datetimeFigureOut">
              <a:rPr lang="it-IT"/>
              <a:pPr>
                <a:defRPr/>
              </a:pPr>
              <a:t>29/10/2022</a:t>
            </a:fld>
            <a:endParaRPr lang="it-IT"/>
          </a:p>
        </p:txBody>
      </p:sp>
      <p:sp>
        <p:nvSpPr>
          <p:cNvPr id="4" name="Segnaposto immagine diapositiva 3">
            <a:extLst>
              <a:ext uri="{FF2B5EF4-FFF2-40B4-BE49-F238E27FC236}">
                <a16:creationId xmlns:a16="http://schemas.microsoft.com/office/drawing/2014/main" id="{181F25FA-92D7-42AA-9C47-5338B3E177A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>
            <a:extLst>
              <a:ext uri="{FF2B5EF4-FFF2-40B4-BE49-F238E27FC236}">
                <a16:creationId xmlns:a16="http://schemas.microsoft.com/office/drawing/2014/main" id="{D253DCF8-DC00-4CCA-9F21-635E20B52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noProof="0"/>
              <a:t>Fare clic per modificare stili del testo dello schema</a:t>
            </a:r>
          </a:p>
          <a:p>
            <a:pPr lvl="1"/>
            <a:r>
              <a:rPr lang="it-IT" noProof="0"/>
              <a:t>Secondo livello</a:t>
            </a:r>
          </a:p>
          <a:p>
            <a:pPr lvl="2"/>
            <a:r>
              <a:rPr lang="it-IT" noProof="0"/>
              <a:t>Terzo livello</a:t>
            </a:r>
          </a:p>
          <a:p>
            <a:pPr lvl="3"/>
            <a:r>
              <a:rPr lang="it-IT" noProof="0"/>
              <a:t>Quarto livello</a:t>
            </a:r>
          </a:p>
          <a:p>
            <a:pPr lvl="4"/>
            <a:r>
              <a:rPr lang="it-IT" noProof="0"/>
              <a:t>Quinto livello</a:t>
            </a:r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663B98-C022-4041-A89C-ADAC415DE94B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3C8DE6C-8A0F-4705-92AC-76234166F35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FE68639-4BBA-40F2-9C3B-4084CA34D622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9514660-86CD-45DB-AE8B-5936BAE4F4D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561FFAD-9379-43FC-8B78-5BE4691C310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65D37CF-48F9-4387-BE7B-8D8E8E51578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05632C-C3F3-40E4-891C-4DC6F92A814C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49588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946567F-0E2E-4B5C-958A-3D53B583358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D3E5FFC9-0B25-4466-9999-63B21477654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EF991A3-A697-4C39-A6E6-8354B3B3FE8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94CCE1-A803-48EA-BFEE-3D7A5711F6E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93924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E9F3A0E-DFA2-414F-AACC-C757146D015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9F83E6D-FD47-4333-9BB4-C2B2D047A1E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9936280-C49D-4499-9FFE-C0454B0286B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FE9A32-FE2A-4B66-8D75-A677DFC6383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71506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A29C7EE-9B73-4F54-BBF8-C0FCDADCAC2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A952E95-410A-48E8-896C-C93ADE225EF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FF7DBB3-CC8C-4E74-B25F-23BEC850F3E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227B1C-6EA9-4CD5-B734-4F445F38124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848185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E0F3FD4-97DC-4B24-868F-4403FB4296D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3B1F413-F51B-456A-9C65-206961954B5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A4CF9C0-DB95-4226-BB0B-D9E351636CF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A725DB-3DF0-4651-B7BB-BBA5C8B96229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17560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2CD04F2-D219-4F1C-80F6-C60A38DE0A5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E2A8EBF-9C18-45C9-898C-BB9C6F4980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41DDE6E-7044-4DEF-B417-ED24CFE1E51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D94E8F-0893-4B89-A039-83D6207FA328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54847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52F4CB-6E78-4124-A8BC-4B727BA671E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E93D6CB8-A271-4419-99EF-111E8414FE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0365CF9C-13E7-4EF5-993B-DDEE96F4D66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7DC509-43C6-42C8-8B00-7FC1D3BBAAF1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070500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B549663A-ED8E-47D3-9994-4EEFB2A162B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DD9171D5-9A3F-4700-B673-A340A1ED03D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9091EDA-4D73-4D4F-8B8A-73230ADDA96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21F5FC-7CD5-4C74-B005-AC914435E9B5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87033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DA164BC1-5526-41A8-9B70-6F5D8D27314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40EE2281-3A74-4E0E-8AD9-6CBA9BB6158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64654261-B3DA-4AC5-8612-2C8A45C3BA2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8DBB4F-6C17-46DF-AC1F-34A58AE0D79A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50979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017F993-B2FD-4B42-976B-BB9A6B7814D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490F29C-94BE-4CA0-BADF-B3FB5A11C56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D7BD6B2-B19A-4C8A-AEDF-75A67352B30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2D5634-6A9B-4AD9-9E89-39A494A56E90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71618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4507C6C-8193-43E9-B046-32D9A06F73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9996A1-173E-42B1-9422-1D0A6CE95D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B81C91-7131-46FE-B01D-F4B79EE15A1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A1B89-A8B4-44B5-B159-1D3CD701084F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46633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6A8808E6-C826-4A67-94F4-C5574BC7716A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itle styl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E73F13FC-927E-4931-9B85-E5FB1205E75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ext styles</a:t>
            </a:r>
          </a:p>
          <a:p>
            <a:pPr lvl="1"/>
            <a:r>
              <a:rPr lang="it-IT" altLang="en-US"/>
              <a:t>Second level</a:t>
            </a:r>
          </a:p>
          <a:p>
            <a:pPr lvl="2"/>
            <a:r>
              <a:rPr lang="it-IT" altLang="en-US"/>
              <a:t>Third level</a:t>
            </a:r>
          </a:p>
          <a:p>
            <a:pPr lvl="3"/>
            <a:r>
              <a:rPr lang="it-IT" altLang="en-US"/>
              <a:t>Fourth level</a:t>
            </a:r>
          </a:p>
          <a:p>
            <a:pPr lvl="4"/>
            <a:r>
              <a:rPr lang="it-IT" altLang="en-US"/>
              <a:t>Fifth le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C5DCBBBD-636D-4787-976F-47E1021DA95E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9B981123-E30F-4283-BC00-9D52238C8899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613F572F-7760-4F0B-A0FC-0581F94A2778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FE7A969-CF52-4352-B69C-73B19C67AF77}" type="slidenum">
              <a:rPr lang="it-IT" altLang="en-US"/>
              <a:pPr>
                <a:defRPr/>
              </a:pPr>
              <a:t>‹N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BFD6BFD1-3D4E-35A7-1E9A-8043425ADD79}"/>
              </a:ext>
            </a:extLst>
          </p:cNvPr>
          <p:cNvSpPr txBox="1"/>
          <p:nvPr/>
        </p:nvSpPr>
        <p:spPr>
          <a:xfrm>
            <a:off x="1990145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it-IT" b="1" dirty="0" err="1"/>
              <a:t>Supplementary</a:t>
            </a:r>
            <a:r>
              <a:rPr lang="it-IT" b="1" dirty="0"/>
              <a:t> Figure 1 </a:t>
            </a:r>
            <a:endParaRPr lang="en-US" b="1" dirty="0"/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0E0B81DE-450D-F5EA-E35E-DEC4D45AAF7F}"/>
              </a:ext>
            </a:extLst>
          </p:cNvPr>
          <p:cNvSpPr txBox="1"/>
          <p:nvPr/>
        </p:nvSpPr>
        <p:spPr>
          <a:xfrm>
            <a:off x="3388798" y="5060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D65105B2-D63B-C863-901B-6C5DB63CFCB6}"/>
              </a:ext>
            </a:extLst>
          </p:cNvPr>
          <p:cNvSpPr txBox="1"/>
          <p:nvPr/>
        </p:nvSpPr>
        <p:spPr>
          <a:xfrm>
            <a:off x="764704" y="5060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0F2ACBBC-E116-803E-AA50-7F515E1F7507}"/>
              </a:ext>
            </a:extLst>
          </p:cNvPr>
          <p:cNvGrpSpPr/>
          <p:nvPr/>
        </p:nvGrpSpPr>
        <p:grpSpPr>
          <a:xfrm>
            <a:off x="1054265" y="769769"/>
            <a:ext cx="1862327" cy="1618802"/>
            <a:chOff x="1054265" y="769769"/>
            <a:chExt cx="1862327" cy="1618802"/>
          </a:xfrm>
        </p:grpSpPr>
        <p:grpSp>
          <p:nvGrpSpPr>
            <p:cNvPr id="25" name="Gruppo 24">
              <a:extLst>
                <a:ext uri="{FF2B5EF4-FFF2-40B4-BE49-F238E27FC236}">
                  <a16:creationId xmlns:a16="http://schemas.microsoft.com/office/drawing/2014/main" id="{DA0DA6EC-6138-78E1-86AD-890037E86759}"/>
                </a:ext>
              </a:extLst>
            </p:cNvPr>
            <p:cNvGrpSpPr/>
            <p:nvPr/>
          </p:nvGrpSpPr>
          <p:grpSpPr>
            <a:xfrm>
              <a:off x="1054265" y="769769"/>
              <a:ext cx="1820822" cy="1618802"/>
              <a:chOff x="8312100" y="641616"/>
              <a:chExt cx="1820822" cy="1618802"/>
            </a:xfrm>
          </p:grpSpPr>
          <p:pic>
            <p:nvPicPr>
              <p:cNvPr id="26" name="Immagine 25">
                <a:extLst>
                  <a:ext uri="{FF2B5EF4-FFF2-40B4-BE49-F238E27FC236}">
                    <a16:creationId xmlns:a16="http://schemas.microsoft.com/office/drawing/2014/main" id="{56F648FC-C3BB-B0F8-A82B-36958BD5FB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909640" y="740722"/>
                <a:ext cx="1223282" cy="1231200"/>
              </a:xfrm>
              <a:prstGeom prst="rect">
                <a:avLst/>
              </a:prstGeom>
            </p:spPr>
          </p:pic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1BAC3EA1-49A2-CF23-504E-2C33979F3E0A}"/>
                  </a:ext>
                </a:extLst>
              </p:cNvPr>
              <p:cNvSpPr txBox="1"/>
              <p:nvPr/>
            </p:nvSpPr>
            <p:spPr>
              <a:xfrm>
                <a:off x="8634108" y="120560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41CB09F7-C740-9D47-C15A-1DF8F5087C40}"/>
                  </a:ext>
                </a:extLst>
              </p:cNvPr>
              <p:cNvSpPr txBox="1"/>
              <p:nvPr/>
            </p:nvSpPr>
            <p:spPr>
              <a:xfrm>
                <a:off x="8634108" y="177045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F33E5F43-FCA2-B1F4-957B-B89AEDB2A769}"/>
                  </a:ext>
                </a:extLst>
              </p:cNvPr>
              <p:cNvSpPr txBox="1"/>
              <p:nvPr/>
            </p:nvSpPr>
            <p:spPr>
              <a:xfrm>
                <a:off x="8634108" y="64161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754E9084-07A0-2FFF-A595-E6B49BF03EF8}"/>
                  </a:ext>
                </a:extLst>
              </p:cNvPr>
              <p:cNvSpPr txBox="1"/>
              <p:nvPr/>
            </p:nvSpPr>
            <p:spPr>
              <a:xfrm rot="16200000">
                <a:off x="8014262" y="1128165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852636AA-DAFB-0780-0E38-4810C4460916}"/>
                  </a:ext>
                </a:extLst>
              </p:cNvPr>
              <p:cNvSpPr txBox="1"/>
              <p:nvPr/>
            </p:nvSpPr>
            <p:spPr>
              <a:xfrm>
                <a:off x="8984170" y="18935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7DB86996-7378-60B9-B13A-0D16F7C5A324}"/>
                  </a:ext>
                </a:extLst>
              </p:cNvPr>
              <p:cNvSpPr txBox="1"/>
              <p:nvPr/>
            </p:nvSpPr>
            <p:spPr>
              <a:xfrm>
                <a:off x="9192534" y="18935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0A9C1C4E-1EB2-4217-E078-061DFFFAA468}"/>
                  </a:ext>
                </a:extLst>
              </p:cNvPr>
              <p:cNvSpPr txBox="1"/>
              <p:nvPr/>
            </p:nvSpPr>
            <p:spPr>
              <a:xfrm>
                <a:off x="9407530" y="18935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B5FE0C0B-F83D-6870-1E3F-EB8F0F276E13}"/>
                  </a:ext>
                </a:extLst>
              </p:cNvPr>
              <p:cNvSpPr txBox="1"/>
              <p:nvPr/>
            </p:nvSpPr>
            <p:spPr>
              <a:xfrm>
                <a:off x="9623400" y="18935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AE6A92F9-D2AC-C9B5-CC9C-C1B354697F46}"/>
                  </a:ext>
                </a:extLst>
              </p:cNvPr>
              <p:cNvSpPr txBox="1"/>
              <p:nvPr/>
            </p:nvSpPr>
            <p:spPr>
              <a:xfrm>
                <a:off x="9842132" y="18935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36" name="CasellaDiTesto 35">
                <a:extLst>
                  <a:ext uri="{FF2B5EF4-FFF2-40B4-BE49-F238E27FC236}">
                    <a16:creationId xmlns:a16="http://schemas.microsoft.com/office/drawing/2014/main" id="{B8E31364-967F-841F-77B6-014CE6F0A698}"/>
                  </a:ext>
                </a:extLst>
              </p:cNvPr>
              <p:cNvSpPr txBox="1"/>
              <p:nvPr/>
            </p:nvSpPr>
            <p:spPr>
              <a:xfrm>
                <a:off x="9095894" y="2014197"/>
                <a:ext cx="8835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Days)</a:t>
                </a:r>
              </a:p>
            </p:txBody>
          </p:sp>
        </p:grpSp>
        <p:sp>
          <p:nvSpPr>
            <p:cNvPr id="52" name="CasellaDiTesto 198">
              <a:extLst>
                <a:ext uri="{FF2B5EF4-FFF2-40B4-BE49-F238E27FC236}">
                  <a16:creationId xmlns:a16="http://schemas.microsoft.com/office/drawing/2014/main" id="{74429B4B-8440-93C5-7FB3-CEB389A9383D}"/>
                </a:ext>
              </a:extLst>
            </p:cNvPr>
            <p:cNvSpPr txBox="1"/>
            <p:nvPr/>
          </p:nvSpPr>
          <p:spPr>
            <a:xfrm>
              <a:off x="2116218" y="1187624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**</a:t>
              </a:r>
            </a:p>
          </p:txBody>
        </p:sp>
        <p:sp>
          <p:nvSpPr>
            <p:cNvPr id="53" name="CasellaDiTesto 198">
              <a:extLst>
                <a:ext uri="{FF2B5EF4-FFF2-40B4-BE49-F238E27FC236}">
                  <a16:creationId xmlns:a16="http://schemas.microsoft.com/office/drawing/2014/main" id="{81AD984E-17B4-C477-836F-9AC80E59738B}"/>
                </a:ext>
              </a:extLst>
            </p:cNvPr>
            <p:cNvSpPr txBox="1"/>
            <p:nvPr/>
          </p:nvSpPr>
          <p:spPr>
            <a:xfrm>
              <a:off x="2319418" y="134002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***</a:t>
              </a:r>
            </a:p>
          </p:txBody>
        </p:sp>
        <p:sp>
          <p:nvSpPr>
            <p:cNvPr id="54" name="CasellaDiTesto 198">
              <a:extLst>
                <a:ext uri="{FF2B5EF4-FFF2-40B4-BE49-F238E27FC236}">
                  <a16:creationId xmlns:a16="http://schemas.microsoft.com/office/drawing/2014/main" id="{912BDF3F-3B53-EE34-D6DD-C189A25F9B48}"/>
                </a:ext>
              </a:extLst>
            </p:cNvPr>
            <p:cNvSpPr txBox="1"/>
            <p:nvPr/>
          </p:nvSpPr>
          <p:spPr>
            <a:xfrm>
              <a:off x="2533154" y="1187624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***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32C6D7C6-26BE-9B1F-00A1-B51CF80FE24B}"/>
              </a:ext>
            </a:extLst>
          </p:cNvPr>
          <p:cNvGrpSpPr/>
          <p:nvPr/>
        </p:nvGrpSpPr>
        <p:grpSpPr>
          <a:xfrm>
            <a:off x="3783195" y="760243"/>
            <a:ext cx="1847176" cy="1637854"/>
            <a:chOff x="3783195" y="760243"/>
            <a:chExt cx="1847176" cy="1637854"/>
          </a:xfrm>
        </p:grpSpPr>
        <p:grpSp>
          <p:nvGrpSpPr>
            <p:cNvPr id="37" name="Gruppo 36">
              <a:extLst>
                <a:ext uri="{FF2B5EF4-FFF2-40B4-BE49-F238E27FC236}">
                  <a16:creationId xmlns:a16="http://schemas.microsoft.com/office/drawing/2014/main" id="{68488E12-958F-9D95-24C4-0C4DD20BF883}"/>
                </a:ext>
              </a:extLst>
            </p:cNvPr>
            <p:cNvGrpSpPr/>
            <p:nvPr/>
          </p:nvGrpSpPr>
          <p:grpSpPr>
            <a:xfrm>
              <a:off x="3783195" y="760243"/>
              <a:ext cx="1806045" cy="1637854"/>
              <a:chOff x="8382445" y="2427977"/>
              <a:chExt cx="1806045" cy="1637854"/>
            </a:xfrm>
          </p:grpSpPr>
          <p:pic>
            <p:nvPicPr>
              <p:cNvPr id="38" name="Immagine 37">
                <a:extLst>
                  <a:ext uri="{FF2B5EF4-FFF2-40B4-BE49-F238E27FC236}">
                    <a16:creationId xmlns:a16="http://schemas.microsoft.com/office/drawing/2014/main" id="{3E464F29-B29B-E391-A8A1-451A423A39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979985" y="2527083"/>
                <a:ext cx="1208505" cy="1231200"/>
              </a:xfrm>
              <a:prstGeom prst="rect">
                <a:avLst/>
              </a:prstGeom>
            </p:spPr>
          </p:pic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FCCCDFA6-F13F-A686-E570-A298F574262A}"/>
                  </a:ext>
                </a:extLst>
              </p:cNvPr>
              <p:cNvSpPr txBox="1"/>
              <p:nvPr/>
            </p:nvSpPr>
            <p:spPr>
              <a:xfrm>
                <a:off x="8704453" y="299196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6855B785-EB74-7B52-993D-06ADF18DCC51}"/>
                  </a:ext>
                </a:extLst>
              </p:cNvPr>
              <p:cNvSpPr txBox="1"/>
              <p:nvPr/>
            </p:nvSpPr>
            <p:spPr>
              <a:xfrm>
                <a:off x="8704453" y="355681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26A0950F-F12E-4560-3D4C-AC9AB1D2D866}"/>
                  </a:ext>
                </a:extLst>
              </p:cNvPr>
              <p:cNvSpPr txBox="1"/>
              <p:nvPr/>
            </p:nvSpPr>
            <p:spPr>
              <a:xfrm>
                <a:off x="8704453" y="242797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623D2942-A268-FE39-A776-C6088C49336F}"/>
                  </a:ext>
                </a:extLst>
              </p:cNvPr>
              <p:cNvSpPr txBox="1"/>
              <p:nvPr/>
            </p:nvSpPr>
            <p:spPr>
              <a:xfrm rot="16200000">
                <a:off x="8084607" y="2914526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B29E77C8-134D-3A26-80EA-C33745AB0836}"/>
                  </a:ext>
                </a:extLst>
              </p:cNvPr>
              <p:cNvSpPr txBox="1"/>
              <p:nvPr/>
            </p:nvSpPr>
            <p:spPr>
              <a:xfrm>
                <a:off x="9054515" y="367992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30C89E26-BABB-FE4C-F847-2F539039F879}"/>
                  </a:ext>
                </a:extLst>
              </p:cNvPr>
              <p:cNvSpPr txBox="1"/>
              <p:nvPr/>
            </p:nvSpPr>
            <p:spPr>
              <a:xfrm>
                <a:off x="9243827" y="3679926"/>
                <a:ext cx="2984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8</a:t>
                </a:r>
              </a:p>
            </p:txBody>
          </p:sp>
          <p:sp>
            <p:nvSpPr>
              <p:cNvPr id="45" name="CasellaDiTesto 44">
                <a:extLst>
                  <a:ext uri="{FF2B5EF4-FFF2-40B4-BE49-F238E27FC236}">
                    <a16:creationId xmlns:a16="http://schemas.microsoft.com/office/drawing/2014/main" id="{B2A1A62B-F3E5-0671-213C-F142651B57A3}"/>
                  </a:ext>
                </a:extLst>
              </p:cNvPr>
              <p:cNvSpPr txBox="1"/>
              <p:nvPr/>
            </p:nvSpPr>
            <p:spPr>
              <a:xfrm>
                <a:off x="9454060" y="3679926"/>
                <a:ext cx="2984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7</a:t>
                </a:r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23895D2D-0329-2815-0096-8601348330E4}"/>
                  </a:ext>
                </a:extLst>
              </p:cNvPr>
              <p:cNvSpPr txBox="1"/>
              <p:nvPr/>
            </p:nvSpPr>
            <p:spPr>
              <a:xfrm>
                <a:off x="9679456" y="3679926"/>
                <a:ext cx="2984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6</a:t>
                </a:r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212D59F9-7625-949F-119B-CE38BD50CEFB}"/>
                  </a:ext>
                </a:extLst>
              </p:cNvPr>
              <p:cNvSpPr txBox="1"/>
              <p:nvPr/>
            </p:nvSpPr>
            <p:spPr>
              <a:xfrm>
                <a:off x="9888662" y="3679926"/>
                <a:ext cx="2984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C0B7EB7C-5DBA-6938-4B14-BB744E355C4F}"/>
                  </a:ext>
                </a:extLst>
              </p:cNvPr>
              <p:cNvSpPr txBox="1"/>
              <p:nvPr/>
            </p:nvSpPr>
            <p:spPr>
              <a:xfrm>
                <a:off x="9338663" y="3819610"/>
                <a:ext cx="7649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g [LMX]</a:t>
                </a:r>
              </a:p>
            </p:txBody>
          </p:sp>
          <p:cxnSp>
            <p:nvCxnSpPr>
              <p:cNvPr id="49" name="Connettore diritto 48">
                <a:extLst>
                  <a:ext uri="{FF2B5EF4-FFF2-40B4-BE49-F238E27FC236}">
                    <a16:creationId xmlns:a16="http://schemas.microsoft.com/office/drawing/2014/main" id="{0C34C6B1-FFD3-0108-E5A5-2F6D1333B3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372679" y="3869497"/>
                <a:ext cx="696921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5" name="CasellaDiTesto 198">
              <a:extLst>
                <a:ext uri="{FF2B5EF4-FFF2-40B4-BE49-F238E27FC236}">
                  <a16:creationId xmlns:a16="http://schemas.microsoft.com/office/drawing/2014/main" id="{DC114B67-5341-846A-C5C8-A8AB4E8574B7}"/>
                </a:ext>
              </a:extLst>
            </p:cNvPr>
            <p:cNvSpPr txBox="1"/>
            <p:nvPr/>
          </p:nvSpPr>
          <p:spPr>
            <a:xfrm>
              <a:off x="5246933" y="1200626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***</a:t>
              </a:r>
            </a:p>
          </p:txBody>
        </p:sp>
        <p:sp>
          <p:nvSpPr>
            <p:cNvPr id="56" name="CasellaDiTesto 198">
              <a:extLst>
                <a:ext uri="{FF2B5EF4-FFF2-40B4-BE49-F238E27FC236}">
                  <a16:creationId xmlns:a16="http://schemas.microsoft.com/office/drawing/2014/main" id="{69726699-FCD4-636B-819D-6340F5831230}"/>
                </a:ext>
              </a:extLst>
            </p:cNvPr>
            <p:cNvSpPr txBox="1"/>
            <p:nvPr/>
          </p:nvSpPr>
          <p:spPr>
            <a:xfrm>
              <a:off x="5053135" y="1027963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**</a:t>
              </a:r>
            </a:p>
          </p:txBody>
        </p:sp>
        <p:sp>
          <p:nvSpPr>
            <p:cNvPr id="57" name="CasellaDiTesto 198">
              <a:extLst>
                <a:ext uri="{FF2B5EF4-FFF2-40B4-BE49-F238E27FC236}">
                  <a16:creationId xmlns:a16="http://schemas.microsoft.com/office/drawing/2014/main" id="{9887D3B5-EA77-5424-8C55-7B10B9B3F5CC}"/>
                </a:ext>
              </a:extLst>
            </p:cNvPr>
            <p:cNvSpPr txBox="1"/>
            <p:nvPr/>
          </p:nvSpPr>
          <p:spPr>
            <a:xfrm>
              <a:off x="4889581" y="958480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it-IT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lvl9pPr>
            </a:lstStyle>
            <a:p>
              <a:r>
                <a:rPr lang="it-IT" sz="1000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560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05BA7DE3-DBDB-B99A-4446-7FBCD138B40B}"/>
              </a:ext>
            </a:extLst>
          </p:cNvPr>
          <p:cNvSpPr txBox="1"/>
          <p:nvPr/>
        </p:nvSpPr>
        <p:spPr>
          <a:xfrm>
            <a:off x="1990145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2 </a:t>
            </a:r>
            <a:endParaRPr lang="en-US" b="1" dirty="0"/>
          </a:p>
        </p:txBody>
      </p:sp>
      <p:grpSp>
        <p:nvGrpSpPr>
          <p:cNvPr id="129" name="Gruppo 128">
            <a:extLst>
              <a:ext uri="{FF2B5EF4-FFF2-40B4-BE49-F238E27FC236}">
                <a16:creationId xmlns:a16="http://schemas.microsoft.com/office/drawing/2014/main" id="{BC6B3257-95C6-9988-4066-22E862DC7D41}"/>
              </a:ext>
            </a:extLst>
          </p:cNvPr>
          <p:cNvGrpSpPr/>
          <p:nvPr/>
        </p:nvGrpSpPr>
        <p:grpSpPr>
          <a:xfrm>
            <a:off x="3990998" y="827584"/>
            <a:ext cx="1817341" cy="1630234"/>
            <a:chOff x="3693756" y="1731319"/>
            <a:chExt cx="1817341" cy="1630234"/>
          </a:xfrm>
        </p:grpSpPr>
        <p:pic>
          <p:nvPicPr>
            <p:cNvPr id="128" name="Immagine 127">
              <a:extLst>
                <a:ext uri="{FF2B5EF4-FFF2-40B4-BE49-F238E27FC236}">
                  <a16:creationId xmlns:a16="http://schemas.microsoft.com/office/drawing/2014/main" id="{D1F17F05-A42C-77E9-3854-305004E9DD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91297" y="1830425"/>
              <a:ext cx="1219800" cy="1231200"/>
            </a:xfrm>
            <a:prstGeom prst="rect">
              <a:avLst/>
            </a:prstGeom>
          </p:spPr>
        </p:pic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E7F07299-EEF9-9622-CE56-C1B4380A1EFD}"/>
                </a:ext>
              </a:extLst>
            </p:cNvPr>
            <p:cNvSpPr txBox="1"/>
            <p:nvPr/>
          </p:nvSpPr>
          <p:spPr>
            <a:xfrm>
              <a:off x="4015765" y="229530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20701049-F4E6-D72A-602E-C32BFE1A7B0F}"/>
                </a:ext>
              </a:extLst>
            </p:cNvPr>
            <p:cNvSpPr txBox="1"/>
            <p:nvPr/>
          </p:nvSpPr>
          <p:spPr>
            <a:xfrm>
              <a:off x="4015765" y="2860158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AC7828E3-AC17-9371-EB8C-B17EC37E0EFC}"/>
                </a:ext>
              </a:extLst>
            </p:cNvPr>
            <p:cNvSpPr txBox="1"/>
            <p:nvPr/>
          </p:nvSpPr>
          <p:spPr>
            <a:xfrm>
              <a:off x="4015765" y="173131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/>
                <a:t>2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.0</a:t>
              </a:r>
            </a:p>
          </p:txBody>
        </p: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8391248F-2875-5711-B6EC-E73AE6F8C6B9}"/>
                </a:ext>
              </a:extLst>
            </p:cNvPr>
            <p:cNvSpPr txBox="1"/>
            <p:nvPr/>
          </p:nvSpPr>
          <p:spPr>
            <a:xfrm rot="16200000">
              <a:off x="3473664" y="2217868"/>
              <a:ext cx="84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evel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on 0)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A919F5AC-66A7-419F-6C26-518118BE0E52}"/>
                </a:ext>
              </a:extLst>
            </p:cNvPr>
            <p:cNvSpPr txBox="1"/>
            <p:nvPr/>
          </p:nvSpPr>
          <p:spPr>
            <a:xfrm>
              <a:off x="4403927" y="298326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64042756-28B9-A6A9-F458-F754796FC2DA}"/>
                </a:ext>
              </a:extLst>
            </p:cNvPr>
            <p:cNvSpPr txBox="1"/>
            <p:nvPr/>
          </p:nvSpPr>
          <p:spPr>
            <a:xfrm>
              <a:off x="4643452" y="2983268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</a:p>
          </p:txBody>
        </p:sp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88FB43B0-C88A-EABD-B35D-C12814209B48}"/>
                </a:ext>
              </a:extLst>
            </p:cNvPr>
            <p:cNvSpPr txBox="1"/>
            <p:nvPr/>
          </p:nvSpPr>
          <p:spPr>
            <a:xfrm>
              <a:off x="4898336" y="2983268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9309D04B-48CA-765D-7792-1942E37110E4}"/>
                </a:ext>
              </a:extLst>
            </p:cNvPr>
            <p:cNvSpPr txBox="1"/>
            <p:nvPr/>
          </p:nvSpPr>
          <p:spPr>
            <a:xfrm>
              <a:off x="5175920" y="2983268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DE164F92-CDDE-CFAB-0E03-C4AD9D28729E}"/>
                </a:ext>
              </a:extLst>
            </p:cNvPr>
            <p:cNvSpPr txBox="1"/>
            <p:nvPr/>
          </p:nvSpPr>
          <p:spPr>
            <a:xfrm>
              <a:off x="4672835" y="3115332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og [LMX]</a:t>
              </a:r>
            </a:p>
          </p:txBody>
        </p:sp>
        <p:cxnSp>
          <p:nvCxnSpPr>
            <p:cNvPr id="124" name="Connettore diritto 123">
              <a:extLst>
                <a:ext uri="{FF2B5EF4-FFF2-40B4-BE49-F238E27FC236}">
                  <a16:creationId xmlns:a16="http://schemas.microsoft.com/office/drawing/2014/main" id="{62CA3027-EE23-B68C-93E3-EEB53BD9ACFB}"/>
                </a:ext>
              </a:extLst>
            </p:cNvPr>
            <p:cNvCxnSpPr>
              <a:cxnSpLocks/>
            </p:cNvCxnSpPr>
            <p:nvPr/>
          </p:nvCxnSpPr>
          <p:spPr>
            <a:xfrm>
              <a:off x="4706851" y="3165989"/>
              <a:ext cx="69692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7" name="Gruppo 126">
            <a:extLst>
              <a:ext uri="{FF2B5EF4-FFF2-40B4-BE49-F238E27FC236}">
                <a16:creationId xmlns:a16="http://schemas.microsoft.com/office/drawing/2014/main" id="{62FD30BC-80F8-A5FA-A772-670CEF170456}"/>
              </a:ext>
            </a:extLst>
          </p:cNvPr>
          <p:cNvGrpSpPr/>
          <p:nvPr/>
        </p:nvGrpSpPr>
        <p:grpSpPr>
          <a:xfrm>
            <a:off x="393186" y="827584"/>
            <a:ext cx="1828741" cy="1630234"/>
            <a:chOff x="408980" y="1669567"/>
            <a:chExt cx="1828741" cy="1630234"/>
          </a:xfrm>
        </p:grpSpPr>
        <p:pic>
          <p:nvPicPr>
            <p:cNvPr id="111" name="Immagine 110">
              <a:extLst>
                <a:ext uri="{FF2B5EF4-FFF2-40B4-BE49-F238E27FC236}">
                  <a16:creationId xmlns:a16="http://schemas.microsoft.com/office/drawing/2014/main" id="{6A6010A8-75CB-1214-98EA-CF9CD0A8026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06521" y="1768673"/>
              <a:ext cx="1231200" cy="1231200"/>
            </a:xfrm>
            <a:prstGeom prst="rect">
              <a:avLst/>
            </a:prstGeom>
          </p:spPr>
        </p:pic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2803EE5A-FDFD-A7F8-BA4C-FEF37C7A4EC2}"/>
                </a:ext>
              </a:extLst>
            </p:cNvPr>
            <p:cNvSpPr txBox="1"/>
            <p:nvPr/>
          </p:nvSpPr>
          <p:spPr>
            <a:xfrm>
              <a:off x="730989" y="223355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id="{40CB97CE-D31A-2550-9203-AB2AA953C65F}"/>
                </a:ext>
              </a:extLst>
            </p:cNvPr>
            <p:cNvSpPr txBox="1"/>
            <p:nvPr/>
          </p:nvSpPr>
          <p:spPr>
            <a:xfrm>
              <a:off x="730989" y="279840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DCE384BE-1730-8CE3-D2D1-2C53C504FB9E}"/>
                </a:ext>
              </a:extLst>
            </p:cNvPr>
            <p:cNvSpPr txBox="1"/>
            <p:nvPr/>
          </p:nvSpPr>
          <p:spPr>
            <a:xfrm>
              <a:off x="730989" y="166956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.4</a:t>
              </a:r>
            </a:p>
          </p:txBody>
        </p: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id="{6F09AD7A-F282-F428-BA4A-F5F101ADDA6D}"/>
                </a:ext>
              </a:extLst>
            </p:cNvPr>
            <p:cNvSpPr txBox="1"/>
            <p:nvPr/>
          </p:nvSpPr>
          <p:spPr>
            <a:xfrm rot="16200000">
              <a:off x="188888" y="2156116"/>
              <a:ext cx="84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Levels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 on 0)</a:t>
              </a:r>
            </a:p>
          </p:txBody>
        </p:sp>
        <p:sp>
          <p:nvSpPr>
            <p:cNvPr id="104" name="CasellaDiTesto 103">
              <a:extLst>
                <a:ext uri="{FF2B5EF4-FFF2-40B4-BE49-F238E27FC236}">
                  <a16:creationId xmlns:a16="http://schemas.microsoft.com/office/drawing/2014/main" id="{A5A837A4-AAB5-7B12-5BFD-A992DDC2FFCD}"/>
                </a:ext>
              </a:extLst>
            </p:cNvPr>
            <p:cNvSpPr txBox="1"/>
            <p:nvPr/>
          </p:nvSpPr>
          <p:spPr>
            <a:xfrm>
              <a:off x="1119151" y="292151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35F9FDE0-4D13-CCA9-3CC4-13412050C61F}"/>
                </a:ext>
              </a:extLst>
            </p:cNvPr>
            <p:cNvSpPr txBox="1"/>
            <p:nvPr/>
          </p:nvSpPr>
          <p:spPr>
            <a:xfrm>
              <a:off x="1358676" y="292151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7</a:t>
              </a:r>
            </a:p>
          </p:txBody>
        </p:sp>
        <p:sp>
          <p:nvSpPr>
            <p:cNvPr id="107" name="CasellaDiTesto 106">
              <a:extLst>
                <a:ext uri="{FF2B5EF4-FFF2-40B4-BE49-F238E27FC236}">
                  <a16:creationId xmlns:a16="http://schemas.microsoft.com/office/drawing/2014/main" id="{865717D7-1D4D-58A5-06CD-2F249854C96E}"/>
                </a:ext>
              </a:extLst>
            </p:cNvPr>
            <p:cNvSpPr txBox="1"/>
            <p:nvPr/>
          </p:nvSpPr>
          <p:spPr>
            <a:xfrm>
              <a:off x="1613560" y="292151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F316DA25-E7EC-4245-85FA-F2DED56D67B7}"/>
                </a:ext>
              </a:extLst>
            </p:cNvPr>
            <p:cNvSpPr txBox="1"/>
            <p:nvPr/>
          </p:nvSpPr>
          <p:spPr>
            <a:xfrm>
              <a:off x="1891144" y="292151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D8E5DF12-73FC-4A0A-945D-029DD637F695}"/>
                </a:ext>
              </a:extLst>
            </p:cNvPr>
            <p:cNvSpPr txBox="1"/>
            <p:nvPr/>
          </p:nvSpPr>
          <p:spPr>
            <a:xfrm>
              <a:off x="1388059" y="3053580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og [LMX]</a:t>
              </a:r>
            </a:p>
          </p:txBody>
        </p:sp>
        <p:cxnSp>
          <p:nvCxnSpPr>
            <p:cNvPr id="110" name="Connettore diritto 109">
              <a:extLst>
                <a:ext uri="{FF2B5EF4-FFF2-40B4-BE49-F238E27FC236}">
                  <a16:creationId xmlns:a16="http://schemas.microsoft.com/office/drawing/2014/main" id="{6857CBEA-9D8D-AF89-F4B3-9BA10AB6CDB2}"/>
                </a:ext>
              </a:extLst>
            </p:cNvPr>
            <p:cNvCxnSpPr>
              <a:cxnSpLocks/>
            </p:cNvCxnSpPr>
            <p:nvPr/>
          </p:nvCxnSpPr>
          <p:spPr>
            <a:xfrm>
              <a:off x="1422075" y="3104237"/>
              <a:ext cx="69692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5" name="CasellaDiTesto 124">
              <a:extLst>
                <a:ext uri="{FF2B5EF4-FFF2-40B4-BE49-F238E27FC236}">
                  <a16:creationId xmlns:a16="http://schemas.microsoft.com/office/drawing/2014/main" id="{E36E78FE-15AE-E1CC-9CD7-0AC3558E88A9}"/>
                </a:ext>
              </a:extLst>
            </p:cNvPr>
            <p:cNvSpPr txBox="1"/>
            <p:nvPr/>
          </p:nvSpPr>
          <p:spPr>
            <a:xfrm>
              <a:off x="1630332" y="1944961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18D0F4A4-B78C-1BDD-6D8E-5FB279E2DC00}"/>
                </a:ext>
              </a:extLst>
            </p:cNvPr>
            <p:cNvSpPr txBox="1"/>
            <p:nvPr/>
          </p:nvSpPr>
          <p:spPr>
            <a:xfrm>
              <a:off x="1905572" y="1835696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D6A32688-DEC5-E854-8AF4-D41402392DCD}"/>
              </a:ext>
            </a:extLst>
          </p:cNvPr>
          <p:cNvSpPr txBox="1"/>
          <p:nvPr/>
        </p:nvSpPr>
        <p:spPr>
          <a:xfrm>
            <a:off x="3229008" y="6225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EB0BBE12-353E-601E-87EA-79CF0A9E61BB}"/>
              </a:ext>
            </a:extLst>
          </p:cNvPr>
          <p:cNvSpPr txBox="1"/>
          <p:nvPr/>
        </p:nvSpPr>
        <p:spPr>
          <a:xfrm>
            <a:off x="116632" y="62259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04834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CasellaDiTesto 157">
            <a:extLst>
              <a:ext uri="{FF2B5EF4-FFF2-40B4-BE49-F238E27FC236}">
                <a16:creationId xmlns:a16="http://schemas.microsoft.com/office/drawing/2014/main" id="{64C87A1B-968C-036D-0268-9B6A7784BA52}"/>
              </a:ext>
            </a:extLst>
          </p:cNvPr>
          <p:cNvSpPr txBox="1"/>
          <p:nvPr/>
        </p:nvSpPr>
        <p:spPr>
          <a:xfrm>
            <a:off x="1990145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3 </a:t>
            </a:r>
            <a:endParaRPr lang="en-US" b="1" dirty="0"/>
          </a:p>
        </p:txBody>
      </p:sp>
      <p:sp>
        <p:nvSpPr>
          <p:cNvPr id="159" name="CasellaDiTesto 158">
            <a:extLst>
              <a:ext uri="{FF2B5EF4-FFF2-40B4-BE49-F238E27FC236}">
                <a16:creationId xmlns:a16="http://schemas.microsoft.com/office/drawing/2014/main" id="{E11C2CA5-10D7-FC4A-0F1D-A63F3A4AB720}"/>
              </a:ext>
            </a:extLst>
          </p:cNvPr>
          <p:cNvSpPr txBox="1"/>
          <p:nvPr/>
        </p:nvSpPr>
        <p:spPr>
          <a:xfrm>
            <a:off x="3289793" y="3935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id="{2B758461-EF77-4FA0-09C8-358155873DA3}"/>
              </a:ext>
            </a:extLst>
          </p:cNvPr>
          <p:cNvSpPr txBox="1"/>
          <p:nvPr/>
        </p:nvSpPr>
        <p:spPr>
          <a:xfrm>
            <a:off x="963897" y="3935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161" name="CasellaDiTesto 160">
            <a:extLst>
              <a:ext uri="{FF2B5EF4-FFF2-40B4-BE49-F238E27FC236}">
                <a16:creationId xmlns:a16="http://schemas.microsoft.com/office/drawing/2014/main" id="{C17DF0D6-4F62-8443-944F-B5FC4E409780}"/>
              </a:ext>
            </a:extLst>
          </p:cNvPr>
          <p:cNvSpPr txBox="1"/>
          <p:nvPr/>
        </p:nvSpPr>
        <p:spPr>
          <a:xfrm>
            <a:off x="2276872" y="24837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D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id="{0E4588E4-57A3-7C46-954F-4E33C786B610}"/>
              </a:ext>
            </a:extLst>
          </p:cNvPr>
          <p:cNvSpPr txBox="1"/>
          <p:nvPr/>
        </p:nvSpPr>
        <p:spPr>
          <a:xfrm>
            <a:off x="44624" y="24837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id="{65DE1AD6-4E12-9DC9-BEC1-0BB4F32BF1A2}"/>
              </a:ext>
            </a:extLst>
          </p:cNvPr>
          <p:cNvSpPr txBox="1"/>
          <p:nvPr/>
        </p:nvSpPr>
        <p:spPr>
          <a:xfrm>
            <a:off x="4305360" y="248376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E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id="{7335B171-C705-2AB6-4619-FD8E85690C0B}"/>
              </a:ext>
            </a:extLst>
          </p:cNvPr>
          <p:cNvSpPr txBox="1"/>
          <p:nvPr/>
        </p:nvSpPr>
        <p:spPr>
          <a:xfrm>
            <a:off x="3284984" y="4943073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G</a:t>
            </a:r>
          </a:p>
        </p:txBody>
      </p:sp>
      <p:sp>
        <p:nvSpPr>
          <p:cNvPr id="166" name="CasellaDiTesto 165">
            <a:extLst>
              <a:ext uri="{FF2B5EF4-FFF2-40B4-BE49-F238E27FC236}">
                <a16:creationId xmlns:a16="http://schemas.microsoft.com/office/drawing/2014/main" id="{F9BFE31A-60D4-A916-0AA3-D45441A66596}"/>
              </a:ext>
            </a:extLst>
          </p:cNvPr>
          <p:cNvSpPr txBox="1"/>
          <p:nvPr/>
        </p:nvSpPr>
        <p:spPr>
          <a:xfrm>
            <a:off x="971912" y="494307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F</a:t>
            </a:r>
          </a:p>
        </p:txBody>
      </p:sp>
      <p:sp>
        <p:nvSpPr>
          <p:cNvPr id="167" name="CasellaDiTesto 166">
            <a:extLst>
              <a:ext uri="{FF2B5EF4-FFF2-40B4-BE49-F238E27FC236}">
                <a16:creationId xmlns:a16="http://schemas.microsoft.com/office/drawing/2014/main" id="{9D9E3D6C-04F7-1F65-5F91-C11202728B70}"/>
              </a:ext>
            </a:extLst>
          </p:cNvPr>
          <p:cNvSpPr txBox="1"/>
          <p:nvPr/>
        </p:nvSpPr>
        <p:spPr>
          <a:xfrm>
            <a:off x="3323456" y="6887289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I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id="{D094C953-4EAC-EA93-8FBB-B3B5A58F3F54}"/>
              </a:ext>
            </a:extLst>
          </p:cNvPr>
          <p:cNvSpPr txBox="1"/>
          <p:nvPr/>
        </p:nvSpPr>
        <p:spPr>
          <a:xfrm>
            <a:off x="963897" y="68872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H</a:t>
            </a:r>
          </a:p>
        </p:txBody>
      </p:sp>
      <p:grpSp>
        <p:nvGrpSpPr>
          <p:cNvPr id="53" name="Gruppo 52">
            <a:extLst>
              <a:ext uri="{FF2B5EF4-FFF2-40B4-BE49-F238E27FC236}">
                <a16:creationId xmlns:a16="http://schemas.microsoft.com/office/drawing/2014/main" id="{4CFB67A6-3658-BDD7-AB0B-03722173DF47}"/>
              </a:ext>
            </a:extLst>
          </p:cNvPr>
          <p:cNvGrpSpPr/>
          <p:nvPr/>
        </p:nvGrpSpPr>
        <p:grpSpPr>
          <a:xfrm>
            <a:off x="1268760" y="453422"/>
            <a:ext cx="2049576" cy="1733524"/>
            <a:chOff x="1268760" y="453422"/>
            <a:chExt cx="2049576" cy="1733524"/>
          </a:xfrm>
        </p:grpSpPr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3B354346-6EAE-8047-2081-759A7D74FA00}"/>
                </a:ext>
              </a:extLst>
            </p:cNvPr>
            <p:cNvGrpSpPr/>
            <p:nvPr/>
          </p:nvGrpSpPr>
          <p:grpSpPr>
            <a:xfrm>
              <a:off x="1268760" y="539552"/>
              <a:ext cx="2049576" cy="1647394"/>
              <a:chOff x="382290" y="4188983"/>
              <a:chExt cx="2049576" cy="1647394"/>
            </a:xfrm>
          </p:grpSpPr>
          <p:pic>
            <p:nvPicPr>
              <p:cNvPr id="3" name="Immagine 2">
                <a:extLst>
                  <a:ext uri="{FF2B5EF4-FFF2-40B4-BE49-F238E27FC236}">
                    <a16:creationId xmlns:a16="http://schemas.microsoft.com/office/drawing/2014/main" id="{ADCEA855-1EC6-5990-AB6F-8471846539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79830" y="4288089"/>
                <a:ext cx="1219905" cy="1231200"/>
              </a:xfrm>
              <a:prstGeom prst="rect">
                <a:avLst/>
              </a:prstGeom>
            </p:spPr>
          </p:pic>
          <p:sp>
            <p:nvSpPr>
              <p:cNvPr id="4" name="CasellaDiTesto 3">
                <a:extLst>
                  <a:ext uri="{FF2B5EF4-FFF2-40B4-BE49-F238E27FC236}">
                    <a16:creationId xmlns:a16="http://schemas.microsoft.com/office/drawing/2014/main" id="{C4F10F82-A11D-2430-6152-4F3CC3C230AC}"/>
                  </a:ext>
                </a:extLst>
              </p:cNvPr>
              <p:cNvSpPr txBox="1"/>
              <p:nvPr/>
            </p:nvSpPr>
            <p:spPr>
              <a:xfrm>
                <a:off x="704298" y="475297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A2A5FC7A-F6EE-6469-925C-C7DFDE2E6239}"/>
                  </a:ext>
                </a:extLst>
              </p:cNvPr>
              <p:cNvSpPr txBox="1"/>
              <p:nvPr/>
            </p:nvSpPr>
            <p:spPr>
              <a:xfrm>
                <a:off x="704298" y="531782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2FF46EBB-0BDC-30E2-0FB3-52087EE86D04}"/>
                  </a:ext>
                </a:extLst>
              </p:cNvPr>
              <p:cNvSpPr txBox="1"/>
              <p:nvPr/>
            </p:nvSpPr>
            <p:spPr>
              <a:xfrm>
                <a:off x="704298" y="418898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.0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BED49814-434D-5109-E2A0-26794C3B57CD}"/>
                  </a:ext>
                </a:extLst>
              </p:cNvPr>
              <p:cNvSpPr txBox="1"/>
              <p:nvPr/>
            </p:nvSpPr>
            <p:spPr>
              <a:xfrm rot="16200000">
                <a:off x="84452" y="4675532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S2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4E14624D-9EF7-7A6A-818D-3549329E5720}"/>
                  </a:ext>
                </a:extLst>
              </p:cNvPr>
              <p:cNvSpPr txBox="1"/>
              <p:nvPr/>
            </p:nvSpPr>
            <p:spPr>
              <a:xfrm>
                <a:off x="1044835" y="544093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586F9DB3-22C8-1CD1-D285-77DF6376E37E}"/>
                  </a:ext>
                </a:extLst>
              </p:cNvPr>
              <p:cNvSpPr txBox="1"/>
              <p:nvPr/>
            </p:nvSpPr>
            <p:spPr>
              <a:xfrm>
                <a:off x="1211924" y="544093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E56E7F0C-D478-8BC6-311B-86D09AAE203F}"/>
                  </a:ext>
                </a:extLst>
              </p:cNvPr>
              <p:cNvSpPr txBox="1"/>
              <p:nvPr/>
            </p:nvSpPr>
            <p:spPr>
              <a:xfrm>
                <a:off x="1407870" y="5440932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2EAC61EB-DD39-92F6-45B4-1A5C7EE3EC48}"/>
                  </a:ext>
                </a:extLst>
              </p:cNvPr>
              <p:cNvSpPr txBox="1"/>
              <p:nvPr/>
            </p:nvSpPr>
            <p:spPr>
              <a:xfrm>
                <a:off x="1569765" y="544093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44E9E1F8-FADB-E20A-74B1-76A09B6DBF79}"/>
                  </a:ext>
                </a:extLst>
              </p:cNvPr>
              <p:cNvSpPr txBox="1"/>
              <p:nvPr/>
            </p:nvSpPr>
            <p:spPr>
              <a:xfrm>
                <a:off x="1759922" y="544093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627B4EAD-CEFB-CA19-2545-759407E79010}"/>
                  </a:ext>
                </a:extLst>
              </p:cNvPr>
              <p:cNvSpPr txBox="1"/>
              <p:nvPr/>
            </p:nvSpPr>
            <p:spPr>
              <a:xfrm>
                <a:off x="2091708" y="5440931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91DE5DFF-3175-5B56-6E5B-B4FAD4ACB0D6}"/>
                  </a:ext>
                </a:extLst>
              </p:cNvPr>
              <p:cNvSpPr txBox="1"/>
              <p:nvPr/>
            </p:nvSpPr>
            <p:spPr>
              <a:xfrm>
                <a:off x="1925684" y="544093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15" name="Connettore diritto 14">
                <a:extLst>
                  <a:ext uri="{FF2B5EF4-FFF2-40B4-BE49-F238E27FC236}">
                    <a16:creationId xmlns:a16="http://schemas.microsoft.com/office/drawing/2014/main" id="{99597471-7A3E-A583-359C-78C67D4157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21844" y="5630003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Connettore diritto 15">
                <a:extLst>
                  <a:ext uri="{FF2B5EF4-FFF2-40B4-BE49-F238E27FC236}">
                    <a16:creationId xmlns:a16="http://schemas.microsoft.com/office/drawing/2014/main" id="{B33B7BF5-AF10-8836-4099-4F9A5ACDF0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73896" y="5630003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2671CF46-877E-9DE1-20AE-4DB67EB04045}"/>
                  </a:ext>
                </a:extLst>
              </p:cNvPr>
              <p:cNvSpPr txBox="1"/>
              <p:nvPr/>
            </p:nvSpPr>
            <p:spPr>
              <a:xfrm>
                <a:off x="1433098" y="5590156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46269A4A-B861-EF41-4501-3CEC9DD9100C}"/>
                  </a:ext>
                </a:extLst>
              </p:cNvPr>
              <p:cNvSpPr txBox="1"/>
              <p:nvPr/>
            </p:nvSpPr>
            <p:spPr>
              <a:xfrm>
                <a:off x="1749324" y="5590156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</p:grp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id="{AA4361D6-8C73-FC12-7963-AE9A8E0DF535}"/>
                </a:ext>
              </a:extLst>
            </p:cNvPr>
            <p:cNvSpPr txBox="1"/>
            <p:nvPr/>
          </p:nvSpPr>
          <p:spPr>
            <a:xfrm>
              <a:off x="2087310" y="45342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64" name="CasellaDiTesto 163">
              <a:extLst>
                <a:ext uri="{FF2B5EF4-FFF2-40B4-BE49-F238E27FC236}">
                  <a16:creationId xmlns:a16="http://schemas.microsoft.com/office/drawing/2014/main" id="{7030109A-1EE3-5708-015E-F895CE68DEEB}"/>
                </a:ext>
              </a:extLst>
            </p:cNvPr>
            <p:cNvSpPr txBox="1"/>
            <p:nvPr/>
          </p:nvSpPr>
          <p:spPr>
            <a:xfrm>
              <a:off x="2271460" y="45342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69" name="CasellaDiTesto 168">
              <a:extLst>
                <a:ext uri="{FF2B5EF4-FFF2-40B4-BE49-F238E27FC236}">
                  <a16:creationId xmlns:a16="http://schemas.microsoft.com/office/drawing/2014/main" id="{5EC5C797-850E-A53A-4A8E-D4BA8CAD9136}"/>
                </a:ext>
              </a:extLst>
            </p:cNvPr>
            <p:cNvSpPr txBox="1"/>
            <p:nvPr/>
          </p:nvSpPr>
          <p:spPr>
            <a:xfrm>
              <a:off x="2420888" y="45342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70" name="CasellaDiTesto 169">
              <a:extLst>
                <a:ext uri="{FF2B5EF4-FFF2-40B4-BE49-F238E27FC236}">
                  <a16:creationId xmlns:a16="http://schemas.microsoft.com/office/drawing/2014/main" id="{4F41EEB1-EEE2-61DA-B115-1D6B4EF254BF}"/>
                </a:ext>
              </a:extLst>
            </p:cNvPr>
            <p:cNvSpPr txBox="1"/>
            <p:nvPr/>
          </p:nvSpPr>
          <p:spPr>
            <a:xfrm>
              <a:off x="2564904" y="45342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71" name="CasellaDiTesto 170">
              <a:extLst>
                <a:ext uri="{FF2B5EF4-FFF2-40B4-BE49-F238E27FC236}">
                  <a16:creationId xmlns:a16="http://schemas.microsoft.com/office/drawing/2014/main" id="{113A81E0-FBEB-64DA-8FA5-1B36AAAF181F}"/>
                </a:ext>
              </a:extLst>
            </p:cNvPr>
            <p:cNvSpPr txBox="1"/>
            <p:nvPr/>
          </p:nvSpPr>
          <p:spPr>
            <a:xfrm>
              <a:off x="2431218" y="817230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CasellaDiTesto 171">
              <a:extLst>
                <a:ext uri="{FF2B5EF4-FFF2-40B4-BE49-F238E27FC236}">
                  <a16:creationId xmlns:a16="http://schemas.microsoft.com/office/drawing/2014/main" id="{CB361518-300E-662A-ACD2-570EE64C2B1A}"/>
                </a:ext>
              </a:extLst>
            </p:cNvPr>
            <p:cNvSpPr txBox="1"/>
            <p:nvPr/>
          </p:nvSpPr>
          <p:spPr>
            <a:xfrm>
              <a:off x="2794402" y="817230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CasellaDiTesto 172">
              <a:extLst>
                <a:ext uri="{FF2B5EF4-FFF2-40B4-BE49-F238E27FC236}">
                  <a16:creationId xmlns:a16="http://schemas.microsoft.com/office/drawing/2014/main" id="{2C02AF4A-9D97-ADD5-D83E-58A2F5636E28}"/>
                </a:ext>
              </a:extLst>
            </p:cNvPr>
            <p:cNvSpPr txBox="1"/>
            <p:nvPr/>
          </p:nvSpPr>
          <p:spPr>
            <a:xfrm>
              <a:off x="2812553" y="1223421"/>
              <a:ext cx="2455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^</a:t>
              </a:r>
            </a:p>
          </p:txBody>
        </p:sp>
      </p:grpSp>
      <p:grpSp>
        <p:nvGrpSpPr>
          <p:cNvPr id="54" name="Gruppo 53">
            <a:extLst>
              <a:ext uri="{FF2B5EF4-FFF2-40B4-BE49-F238E27FC236}">
                <a16:creationId xmlns:a16="http://schemas.microsoft.com/office/drawing/2014/main" id="{468B3F36-5B1D-5381-ECB5-46E172C3AC9D}"/>
              </a:ext>
            </a:extLst>
          </p:cNvPr>
          <p:cNvGrpSpPr/>
          <p:nvPr/>
        </p:nvGrpSpPr>
        <p:grpSpPr>
          <a:xfrm>
            <a:off x="3433975" y="535972"/>
            <a:ext cx="2049576" cy="1659764"/>
            <a:chOff x="3433975" y="535972"/>
            <a:chExt cx="2049576" cy="1659764"/>
          </a:xfrm>
        </p:grpSpPr>
        <p:grpSp>
          <p:nvGrpSpPr>
            <p:cNvPr id="19" name="Gruppo 18">
              <a:extLst>
                <a:ext uri="{FF2B5EF4-FFF2-40B4-BE49-F238E27FC236}">
                  <a16:creationId xmlns:a16="http://schemas.microsoft.com/office/drawing/2014/main" id="{54C4EDFE-2C47-2663-C4A3-E84F9D14A153}"/>
                </a:ext>
              </a:extLst>
            </p:cNvPr>
            <p:cNvGrpSpPr/>
            <p:nvPr/>
          </p:nvGrpSpPr>
          <p:grpSpPr>
            <a:xfrm>
              <a:off x="3433975" y="548342"/>
              <a:ext cx="2049576" cy="1647394"/>
              <a:chOff x="2813077" y="4159297"/>
              <a:chExt cx="2049576" cy="1647394"/>
            </a:xfrm>
          </p:grpSpPr>
          <p:pic>
            <p:nvPicPr>
              <p:cNvPr id="20" name="Immagine 19">
                <a:extLst>
                  <a:ext uri="{FF2B5EF4-FFF2-40B4-BE49-F238E27FC236}">
                    <a16:creationId xmlns:a16="http://schemas.microsoft.com/office/drawing/2014/main" id="{15D2D7DE-923A-29E2-DC94-EA2C93EE14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10617" y="4258403"/>
                <a:ext cx="1208712" cy="1231200"/>
              </a:xfrm>
              <a:prstGeom prst="rect">
                <a:avLst/>
              </a:prstGeom>
            </p:spPr>
          </p:pic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A8958E52-5256-CD64-A51A-0AB8A5F5CF1C}"/>
                  </a:ext>
                </a:extLst>
              </p:cNvPr>
              <p:cNvSpPr txBox="1"/>
              <p:nvPr/>
            </p:nvSpPr>
            <p:spPr>
              <a:xfrm>
                <a:off x="3135085" y="472328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3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CD633855-45F2-1563-B53A-D0277FF4DC87}"/>
                  </a:ext>
                </a:extLst>
              </p:cNvPr>
              <p:cNvSpPr txBox="1"/>
              <p:nvPr/>
            </p:nvSpPr>
            <p:spPr>
              <a:xfrm>
                <a:off x="3135085" y="528813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DC11FE23-B997-3FDA-021B-EFF29642DAFA}"/>
                  </a:ext>
                </a:extLst>
              </p:cNvPr>
              <p:cNvSpPr txBox="1"/>
              <p:nvPr/>
            </p:nvSpPr>
            <p:spPr>
              <a:xfrm>
                <a:off x="3135085" y="415929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6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12D59357-32BC-CAF9-843A-B0F2E4AB7031}"/>
                  </a:ext>
                </a:extLst>
              </p:cNvPr>
              <p:cNvSpPr txBox="1"/>
              <p:nvPr/>
            </p:nvSpPr>
            <p:spPr>
              <a:xfrm rot="16200000">
                <a:off x="2515239" y="4645846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t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2D33DB95-785A-C30C-D96B-587EC026EBA4}"/>
                  </a:ext>
                </a:extLst>
              </p:cNvPr>
              <p:cNvSpPr txBox="1"/>
              <p:nvPr/>
            </p:nvSpPr>
            <p:spPr>
              <a:xfrm>
                <a:off x="3475622" y="5411246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9E2061A6-BAB4-B764-D7DD-3B61428168F9}"/>
                  </a:ext>
                </a:extLst>
              </p:cNvPr>
              <p:cNvSpPr txBox="1"/>
              <p:nvPr/>
            </p:nvSpPr>
            <p:spPr>
              <a:xfrm>
                <a:off x="3642711" y="5411246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C12ED2EF-E696-00E7-7EC0-C2A4532B7FD4}"/>
                  </a:ext>
                </a:extLst>
              </p:cNvPr>
              <p:cNvSpPr txBox="1"/>
              <p:nvPr/>
            </p:nvSpPr>
            <p:spPr>
              <a:xfrm>
                <a:off x="3838657" y="5411246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3A35097C-424B-7AA3-60D1-7329DFF35DBD}"/>
                  </a:ext>
                </a:extLst>
              </p:cNvPr>
              <p:cNvSpPr txBox="1"/>
              <p:nvPr/>
            </p:nvSpPr>
            <p:spPr>
              <a:xfrm>
                <a:off x="4000552" y="5411246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ED8841FF-D088-F3DC-8278-0CCFD756A33E}"/>
                  </a:ext>
                </a:extLst>
              </p:cNvPr>
              <p:cNvSpPr txBox="1"/>
              <p:nvPr/>
            </p:nvSpPr>
            <p:spPr>
              <a:xfrm>
                <a:off x="4190709" y="5411246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8AD4EB3A-A34B-1277-69DC-B651C887F7BF}"/>
                  </a:ext>
                </a:extLst>
              </p:cNvPr>
              <p:cNvSpPr txBox="1"/>
              <p:nvPr/>
            </p:nvSpPr>
            <p:spPr>
              <a:xfrm>
                <a:off x="4522495" y="5411245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6C1AD159-DAF0-CFB4-9A06-4665FB1F56B0}"/>
                  </a:ext>
                </a:extLst>
              </p:cNvPr>
              <p:cNvSpPr txBox="1"/>
              <p:nvPr/>
            </p:nvSpPr>
            <p:spPr>
              <a:xfrm>
                <a:off x="4356471" y="5411246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32" name="Connettore diritto 31">
                <a:extLst>
                  <a:ext uri="{FF2B5EF4-FFF2-40B4-BE49-F238E27FC236}">
                    <a16:creationId xmlns:a16="http://schemas.microsoft.com/office/drawing/2014/main" id="{56AB8DF6-76AB-64C1-E020-CE40DF1CCF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52631" y="5600317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Connettore diritto 32">
                <a:extLst>
                  <a:ext uri="{FF2B5EF4-FFF2-40B4-BE49-F238E27FC236}">
                    <a16:creationId xmlns:a16="http://schemas.microsoft.com/office/drawing/2014/main" id="{BA02BAB4-AC69-D779-044A-6A5BD063A8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04683" y="5600317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AA83A60B-FB35-ADB5-C8D0-FB23C22178B7}"/>
                  </a:ext>
                </a:extLst>
              </p:cNvPr>
              <p:cNvSpPr txBox="1"/>
              <p:nvPr/>
            </p:nvSpPr>
            <p:spPr>
              <a:xfrm>
                <a:off x="3863885" y="5560470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9606B830-AFA6-615B-6726-F0F1F2E09997}"/>
                  </a:ext>
                </a:extLst>
              </p:cNvPr>
              <p:cNvSpPr txBox="1"/>
              <p:nvPr/>
            </p:nvSpPr>
            <p:spPr>
              <a:xfrm>
                <a:off x="4180111" y="5560470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</p:grpSp>
        <p:sp>
          <p:nvSpPr>
            <p:cNvPr id="174" name="CasellaDiTesto 173">
              <a:extLst>
                <a:ext uri="{FF2B5EF4-FFF2-40B4-BE49-F238E27FC236}">
                  <a16:creationId xmlns:a16="http://schemas.microsoft.com/office/drawing/2014/main" id="{EE433E3C-9431-53A1-9E95-2FAF0EFEC5A7}"/>
                </a:ext>
              </a:extLst>
            </p:cNvPr>
            <p:cNvSpPr txBox="1"/>
            <p:nvPr/>
          </p:nvSpPr>
          <p:spPr>
            <a:xfrm>
              <a:off x="4244118" y="53597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75" name="CasellaDiTesto 174">
              <a:extLst>
                <a:ext uri="{FF2B5EF4-FFF2-40B4-BE49-F238E27FC236}">
                  <a16:creationId xmlns:a16="http://schemas.microsoft.com/office/drawing/2014/main" id="{19B73D97-25C5-DDD7-6CD6-921134EF3F48}"/>
                </a:ext>
              </a:extLst>
            </p:cNvPr>
            <p:cNvSpPr txBox="1"/>
            <p:nvPr/>
          </p:nvSpPr>
          <p:spPr>
            <a:xfrm>
              <a:off x="4434229" y="576581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it-IT" sz="1000" dirty="0"/>
                <a:t>*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CasellaDiTesto 175">
              <a:extLst>
                <a:ext uri="{FF2B5EF4-FFF2-40B4-BE49-F238E27FC236}">
                  <a16:creationId xmlns:a16="http://schemas.microsoft.com/office/drawing/2014/main" id="{4FBA3FCA-9927-D165-EF19-EF2468F8CA8B}"/>
                </a:ext>
              </a:extLst>
            </p:cNvPr>
            <p:cNvSpPr txBox="1"/>
            <p:nvPr/>
          </p:nvSpPr>
          <p:spPr>
            <a:xfrm>
              <a:off x="4586629" y="728981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it-IT" sz="1000" dirty="0"/>
                <a:t>*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CasellaDiTesto 176">
              <a:extLst>
                <a:ext uri="{FF2B5EF4-FFF2-40B4-BE49-F238E27FC236}">
                  <a16:creationId xmlns:a16="http://schemas.microsoft.com/office/drawing/2014/main" id="{9816F464-DABC-8DBB-949F-45D2028DECCC}"/>
                </a:ext>
              </a:extLst>
            </p:cNvPr>
            <p:cNvSpPr txBox="1"/>
            <p:nvPr/>
          </p:nvSpPr>
          <p:spPr>
            <a:xfrm>
              <a:off x="4763453" y="538441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it-IT" sz="1000" dirty="0"/>
                <a:t>*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CasellaDiTesto 177">
              <a:extLst>
                <a:ext uri="{FF2B5EF4-FFF2-40B4-BE49-F238E27FC236}">
                  <a16:creationId xmlns:a16="http://schemas.microsoft.com/office/drawing/2014/main" id="{BF1790D3-A0F9-6307-AE2C-4849B97FD971}"/>
                </a:ext>
              </a:extLst>
            </p:cNvPr>
            <p:cNvSpPr txBox="1"/>
            <p:nvPr/>
          </p:nvSpPr>
          <p:spPr>
            <a:xfrm>
              <a:off x="4979796" y="586483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9" name="CasellaDiTesto 178">
              <a:extLst>
                <a:ext uri="{FF2B5EF4-FFF2-40B4-BE49-F238E27FC236}">
                  <a16:creationId xmlns:a16="http://schemas.microsoft.com/office/drawing/2014/main" id="{78A4BB4B-7E38-4508-F1DD-98E4BAD76041}"/>
                </a:ext>
              </a:extLst>
            </p:cNvPr>
            <p:cNvSpPr txBox="1"/>
            <p:nvPr/>
          </p:nvSpPr>
          <p:spPr>
            <a:xfrm>
              <a:off x="4607825" y="887058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CasellaDiTesto 179">
              <a:extLst>
                <a:ext uri="{FF2B5EF4-FFF2-40B4-BE49-F238E27FC236}">
                  <a16:creationId xmlns:a16="http://schemas.microsoft.com/office/drawing/2014/main" id="{E5C6C19B-43C3-7D81-D608-3853F6F5F0C1}"/>
                </a:ext>
              </a:extLst>
            </p:cNvPr>
            <p:cNvSpPr txBox="1"/>
            <p:nvPr/>
          </p:nvSpPr>
          <p:spPr>
            <a:xfrm>
              <a:off x="4906002" y="728263"/>
              <a:ext cx="3898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CasellaDiTesto 180">
              <a:extLst>
                <a:ext uri="{FF2B5EF4-FFF2-40B4-BE49-F238E27FC236}">
                  <a16:creationId xmlns:a16="http://schemas.microsoft.com/office/drawing/2014/main" id="{F401DAB6-630F-F565-DF1A-1FD016D56E49}"/>
                </a:ext>
              </a:extLst>
            </p:cNvPr>
            <p:cNvSpPr txBox="1"/>
            <p:nvPr/>
          </p:nvSpPr>
          <p:spPr>
            <a:xfrm>
              <a:off x="4954126" y="838266"/>
              <a:ext cx="3064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^^</a:t>
              </a:r>
            </a:p>
            <a:p>
              <a:r>
                <a:rPr lang="it-IT" sz="1000" dirty="0"/>
                <a:t>^^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uppo 54">
            <a:extLst>
              <a:ext uri="{FF2B5EF4-FFF2-40B4-BE49-F238E27FC236}">
                <a16:creationId xmlns:a16="http://schemas.microsoft.com/office/drawing/2014/main" id="{5A06061E-351A-E4A8-B1B0-ED7362E878A8}"/>
              </a:ext>
            </a:extLst>
          </p:cNvPr>
          <p:cNvGrpSpPr/>
          <p:nvPr/>
        </p:nvGrpSpPr>
        <p:grpSpPr>
          <a:xfrm>
            <a:off x="260648" y="2843808"/>
            <a:ext cx="2049576" cy="1647394"/>
            <a:chOff x="260648" y="2843808"/>
            <a:chExt cx="2049576" cy="1647394"/>
          </a:xfrm>
        </p:grpSpPr>
        <p:grpSp>
          <p:nvGrpSpPr>
            <p:cNvPr id="70" name="Gruppo 69">
              <a:extLst>
                <a:ext uri="{FF2B5EF4-FFF2-40B4-BE49-F238E27FC236}">
                  <a16:creationId xmlns:a16="http://schemas.microsoft.com/office/drawing/2014/main" id="{E2DD7F69-BAA9-C637-542E-CF9DF0870285}"/>
                </a:ext>
              </a:extLst>
            </p:cNvPr>
            <p:cNvGrpSpPr/>
            <p:nvPr/>
          </p:nvGrpSpPr>
          <p:grpSpPr>
            <a:xfrm>
              <a:off x="260648" y="2843808"/>
              <a:ext cx="2049576" cy="1647394"/>
              <a:chOff x="4532677" y="3400456"/>
              <a:chExt cx="2049576" cy="1647394"/>
            </a:xfrm>
          </p:grpSpPr>
          <p:pic>
            <p:nvPicPr>
              <p:cNvPr id="71" name="Immagine 70">
                <a:extLst>
                  <a:ext uri="{FF2B5EF4-FFF2-40B4-BE49-F238E27FC236}">
                    <a16:creationId xmlns:a16="http://schemas.microsoft.com/office/drawing/2014/main" id="{AEC15CA0-C24B-4F82-523F-5EC2B1CB2D1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124751" y="3499562"/>
                <a:ext cx="1242600" cy="1231200"/>
              </a:xfrm>
              <a:prstGeom prst="rect">
                <a:avLst/>
              </a:prstGeom>
            </p:spPr>
          </p:pic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742EEB1C-1FDD-07D3-D841-427AB09EBF9B}"/>
                  </a:ext>
                </a:extLst>
              </p:cNvPr>
              <p:cNvSpPr txBox="1"/>
              <p:nvPr/>
            </p:nvSpPr>
            <p:spPr>
              <a:xfrm>
                <a:off x="4854685" y="396444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53E46C40-DCF0-D2E9-4A82-B04B82E52925}"/>
                  </a:ext>
                </a:extLst>
              </p:cNvPr>
              <p:cNvSpPr txBox="1"/>
              <p:nvPr/>
            </p:nvSpPr>
            <p:spPr>
              <a:xfrm>
                <a:off x="4854685" y="452929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74" name="CasellaDiTesto 73">
                <a:extLst>
                  <a:ext uri="{FF2B5EF4-FFF2-40B4-BE49-F238E27FC236}">
                    <a16:creationId xmlns:a16="http://schemas.microsoft.com/office/drawing/2014/main" id="{B7E11F3B-ACC4-700E-D292-800F30D1CE63}"/>
                  </a:ext>
                </a:extLst>
              </p:cNvPr>
              <p:cNvSpPr txBox="1"/>
              <p:nvPr/>
            </p:nvSpPr>
            <p:spPr>
              <a:xfrm>
                <a:off x="4854685" y="340045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75" name="CasellaDiTesto 74">
                <a:extLst>
                  <a:ext uri="{FF2B5EF4-FFF2-40B4-BE49-F238E27FC236}">
                    <a16:creationId xmlns:a16="http://schemas.microsoft.com/office/drawing/2014/main" id="{DE6B2C9D-61C0-D2E9-1E06-58E8EBABFC00}"/>
                  </a:ext>
                </a:extLst>
              </p:cNvPr>
              <p:cNvSpPr txBox="1"/>
              <p:nvPr/>
            </p:nvSpPr>
            <p:spPr>
              <a:xfrm rot="16200000">
                <a:off x="4234839" y="3887005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cl-2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76" name="CasellaDiTesto 75">
                <a:extLst>
                  <a:ext uri="{FF2B5EF4-FFF2-40B4-BE49-F238E27FC236}">
                    <a16:creationId xmlns:a16="http://schemas.microsoft.com/office/drawing/2014/main" id="{1E64D47D-7F50-D3B1-5116-015D0782196F}"/>
                  </a:ext>
                </a:extLst>
              </p:cNvPr>
              <p:cNvSpPr txBox="1"/>
              <p:nvPr/>
            </p:nvSpPr>
            <p:spPr>
              <a:xfrm>
                <a:off x="5195222" y="4652405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A7B9F38D-A716-8B6E-07D5-FC93E6A4CB5E}"/>
                  </a:ext>
                </a:extLst>
              </p:cNvPr>
              <p:cNvSpPr txBox="1"/>
              <p:nvPr/>
            </p:nvSpPr>
            <p:spPr>
              <a:xfrm>
                <a:off x="5362311" y="465240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5EF3FA1D-68B7-83ED-C0CA-B77B0842C966}"/>
                  </a:ext>
                </a:extLst>
              </p:cNvPr>
              <p:cNvSpPr txBox="1"/>
              <p:nvPr/>
            </p:nvSpPr>
            <p:spPr>
              <a:xfrm>
                <a:off x="5558257" y="4652405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9" name="CasellaDiTesto 78">
                <a:extLst>
                  <a:ext uri="{FF2B5EF4-FFF2-40B4-BE49-F238E27FC236}">
                    <a16:creationId xmlns:a16="http://schemas.microsoft.com/office/drawing/2014/main" id="{62AD42AE-91D6-D7B7-C752-F20410980037}"/>
                  </a:ext>
                </a:extLst>
              </p:cNvPr>
              <p:cNvSpPr txBox="1"/>
              <p:nvPr/>
            </p:nvSpPr>
            <p:spPr>
              <a:xfrm>
                <a:off x="5720152" y="465240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80" name="CasellaDiTesto 79">
                <a:extLst>
                  <a:ext uri="{FF2B5EF4-FFF2-40B4-BE49-F238E27FC236}">
                    <a16:creationId xmlns:a16="http://schemas.microsoft.com/office/drawing/2014/main" id="{362B65D3-7503-CFD6-678C-2F206A0ADB27}"/>
                  </a:ext>
                </a:extLst>
              </p:cNvPr>
              <p:cNvSpPr txBox="1"/>
              <p:nvPr/>
            </p:nvSpPr>
            <p:spPr>
              <a:xfrm>
                <a:off x="5910309" y="4652405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2C7BE5D0-BDAD-3BD7-9863-13B59BED4A4F}"/>
                  </a:ext>
                </a:extLst>
              </p:cNvPr>
              <p:cNvSpPr txBox="1"/>
              <p:nvPr/>
            </p:nvSpPr>
            <p:spPr>
              <a:xfrm>
                <a:off x="6242095" y="4652404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282E4ACE-0DB5-8110-8809-7DCBEC0513AD}"/>
                  </a:ext>
                </a:extLst>
              </p:cNvPr>
              <p:cNvSpPr txBox="1"/>
              <p:nvPr/>
            </p:nvSpPr>
            <p:spPr>
              <a:xfrm>
                <a:off x="6076071" y="465240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83" name="Connettore diritto 82">
                <a:extLst>
                  <a:ext uri="{FF2B5EF4-FFF2-40B4-BE49-F238E27FC236}">
                    <a16:creationId xmlns:a16="http://schemas.microsoft.com/office/drawing/2014/main" id="{E58F3121-9334-80F3-BA34-98E1F5A7BA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72231" y="4841476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Connettore diritto 83">
                <a:extLst>
                  <a:ext uri="{FF2B5EF4-FFF2-40B4-BE49-F238E27FC236}">
                    <a16:creationId xmlns:a16="http://schemas.microsoft.com/office/drawing/2014/main" id="{0D81BC22-1773-BE85-E16D-63442B4081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24283" y="4841476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C73C20FA-6C1C-9B58-0463-A1672A261D34}"/>
                  </a:ext>
                </a:extLst>
              </p:cNvPr>
              <p:cNvSpPr txBox="1"/>
              <p:nvPr/>
            </p:nvSpPr>
            <p:spPr>
              <a:xfrm>
                <a:off x="5583485" y="4801629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86" name="CasellaDiTesto 85">
                <a:extLst>
                  <a:ext uri="{FF2B5EF4-FFF2-40B4-BE49-F238E27FC236}">
                    <a16:creationId xmlns:a16="http://schemas.microsoft.com/office/drawing/2014/main" id="{1ACE2A73-7B33-B97A-8E99-889A754F52CB}"/>
                  </a:ext>
                </a:extLst>
              </p:cNvPr>
              <p:cNvSpPr txBox="1"/>
              <p:nvPr/>
            </p:nvSpPr>
            <p:spPr>
              <a:xfrm>
                <a:off x="5899711" y="4801629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</p:grpSp>
        <p:sp>
          <p:nvSpPr>
            <p:cNvPr id="182" name="CasellaDiTesto 181">
              <a:extLst>
                <a:ext uri="{FF2B5EF4-FFF2-40B4-BE49-F238E27FC236}">
                  <a16:creationId xmlns:a16="http://schemas.microsoft.com/office/drawing/2014/main" id="{CA592A86-A466-2550-D461-43029AA22878}"/>
                </a:ext>
              </a:extLst>
            </p:cNvPr>
            <p:cNvSpPr txBox="1"/>
            <p:nvPr/>
          </p:nvSpPr>
          <p:spPr>
            <a:xfrm>
              <a:off x="1102260" y="286630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3" name="CasellaDiTesto 182">
              <a:extLst>
                <a:ext uri="{FF2B5EF4-FFF2-40B4-BE49-F238E27FC236}">
                  <a16:creationId xmlns:a16="http://schemas.microsoft.com/office/drawing/2014/main" id="{54486052-8190-07D7-7845-90E8D9D6131C}"/>
                </a:ext>
              </a:extLst>
            </p:cNvPr>
            <p:cNvSpPr txBox="1"/>
            <p:nvPr/>
          </p:nvSpPr>
          <p:spPr>
            <a:xfrm>
              <a:off x="1259171" y="286630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84" name="CasellaDiTesto 183">
              <a:extLst>
                <a:ext uri="{FF2B5EF4-FFF2-40B4-BE49-F238E27FC236}">
                  <a16:creationId xmlns:a16="http://schemas.microsoft.com/office/drawing/2014/main" id="{EB22C0B8-0426-A27A-A940-4014CE96F617}"/>
                </a:ext>
              </a:extLst>
            </p:cNvPr>
            <p:cNvSpPr txBox="1"/>
            <p:nvPr/>
          </p:nvSpPr>
          <p:spPr>
            <a:xfrm>
              <a:off x="1445253" y="286630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id="{BF16472F-AC69-4A36-3302-EE4ABF174EFA}"/>
                </a:ext>
              </a:extLst>
            </p:cNvPr>
            <p:cNvSpPr txBox="1"/>
            <p:nvPr/>
          </p:nvSpPr>
          <p:spPr>
            <a:xfrm>
              <a:off x="1420873" y="3001109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CasellaDiTesto 185">
              <a:extLst>
                <a:ext uri="{FF2B5EF4-FFF2-40B4-BE49-F238E27FC236}">
                  <a16:creationId xmlns:a16="http://schemas.microsoft.com/office/drawing/2014/main" id="{C8D3ACF6-5869-7C02-902B-DDE9BA66DC1C}"/>
                </a:ext>
              </a:extLst>
            </p:cNvPr>
            <p:cNvSpPr txBox="1"/>
            <p:nvPr/>
          </p:nvSpPr>
          <p:spPr>
            <a:xfrm>
              <a:off x="1776431" y="3009519"/>
              <a:ext cx="338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°</a:t>
              </a:r>
            </a:p>
          </p:txBody>
        </p:sp>
      </p:grpSp>
      <p:grpSp>
        <p:nvGrpSpPr>
          <p:cNvPr id="56" name="Gruppo 55">
            <a:extLst>
              <a:ext uri="{FF2B5EF4-FFF2-40B4-BE49-F238E27FC236}">
                <a16:creationId xmlns:a16="http://schemas.microsoft.com/office/drawing/2014/main" id="{47987D7A-24E1-107F-0CA4-2BEA609AA061}"/>
              </a:ext>
            </a:extLst>
          </p:cNvPr>
          <p:cNvGrpSpPr/>
          <p:nvPr/>
        </p:nvGrpSpPr>
        <p:grpSpPr>
          <a:xfrm>
            <a:off x="2425863" y="2812058"/>
            <a:ext cx="2049576" cy="1679144"/>
            <a:chOff x="2425863" y="2812058"/>
            <a:chExt cx="2049576" cy="1679144"/>
          </a:xfrm>
        </p:grpSpPr>
        <p:grpSp>
          <p:nvGrpSpPr>
            <p:cNvPr id="87" name="Gruppo 86">
              <a:extLst>
                <a:ext uri="{FF2B5EF4-FFF2-40B4-BE49-F238E27FC236}">
                  <a16:creationId xmlns:a16="http://schemas.microsoft.com/office/drawing/2014/main" id="{CB5927FD-2CAA-343C-1004-D6CCA916567A}"/>
                </a:ext>
              </a:extLst>
            </p:cNvPr>
            <p:cNvGrpSpPr/>
            <p:nvPr/>
          </p:nvGrpSpPr>
          <p:grpSpPr>
            <a:xfrm>
              <a:off x="2425863" y="2843808"/>
              <a:ext cx="2049576" cy="1647394"/>
              <a:chOff x="4569527" y="5129339"/>
              <a:chExt cx="2049576" cy="1647394"/>
            </a:xfrm>
          </p:grpSpPr>
          <p:pic>
            <p:nvPicPr>
              <p:cNvPr id="88" name="Immagine 87">
                <a:extLst>
                  <a:ext uri="{FF2B5EF4-FFF2-40B4-BE49-F238E27FC236}">
                    <a16:creationId xmlns:a16="http://schemas.microsoft.com/office/drawing/2014/main" id="{28AE9898-4037-DAD0-6E77-86DF52607F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161601" y="5228445"/>
                <a:ext cx="1208294" cy="1231200"/>
              </a:xfrm>
              <a:prstGeom prst="rect">
                <a:avLst/>
              </a:prstGeom>
            </p:spPr>
          </p:pic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7D1DAFFF-168A-3830-8110-16CDF384EDE1}"/>
                  </a:ext>
                </a:extLst>
              </p:cNvPr>
              <p:cNvSpPr txBox="1"/>
              <p:nvPr/>
            </p:nvSpPr>
            <p:spPr>
              <a:xfrm>
                <a:off x="4891535" y="569332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E5A75B71-8A37-F793-725E-D1BB681A985A}"/>
                  </a:ext>
                </a:extLst>
              </p:cNvPr>
              <p:cNvSpPr txBox="1"/>
              <p:nvPr/>
            </p:nvSpPr>
            <p:spPr>
              <a:xfrm>
                <a:off x="4891535" y="625817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91" name="CasellaDiTesto 90">
                <a:extLst>
                  <a:ext uri="{FF2B5EF4-FFF2-40B4-BE49-F238E27FC236}">
                    <a16:creationId xmlns:a16="http://schemas.microsoft.com/office/drawing/2014/main" id="{08C66A2D-5D4F-2EF4-F593-827787A474CD}"/>
                  </a:ext>
                </a:extLst>
              </p:cNvPr>
              <p:cNvSpPr txBox="1"/>
              <p:nvPr/>
            </p:nvSpPr>
            <p:spPr>
              <a:xfrm>
                <a:off x="4891535" y="512933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92" name="CasellaDiTesto 91">
                <a:extLst>
                  <a:ext uri="{FF2B5EF4-FFF2-40B4-BE49-F238E27FC236}">
                    <a16:creationId xmlns:a16="http://schemas.microsoft.com/office/drawing/2014/main" id="{8A919F3D-1A07-D46A-ADD7-864E8936A29B}"/>
                  </a:ext>
                </a:extLst>
              </p:cNvPr>
              <p:cNvSpPr txBox="1"/>
              <p:nvPr/>
            </p:nvSpPr>
            <p:spPr>
              <a:xfrm rot="16200000">
                <a:off x="4265277" y="5615888"/>
                <a:ext cx="100861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yc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D1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56960DF0-212D-11A4-A0CA-281CBF03E553}"/>
                  </a:ext>
                </a:extLst>
              </p:cNvPr>
              <p:cNvSpPr txBox="1"/>
              <p:nvPr/>
            </p:nvSpPr>
            <p:spPr>
              <a:xfrm>
                <a:off x="5232072" y="6381288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52881FFE-339F-CFF0-0535-BF8D1588AB5E}"/>
                  </a:ext>
                </a:extLst>
              </p:cNvPr>
              <p:cNvSpPr txBox="1"/>
              <p:nvPr/>
            </p:nvSpPr>
            <p:spPr>
              <a:xfrm>
                <a:off x="5399161" y="6381288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5" name="CasellaDiTesto 94">
                <a:extLst>
                  <a:ext uri="{FF2B5EF4-FFF2-40B4-BE49-F238E27FC236}">
                    <a16:creationId xmlns:a16="http://schemas.microsoft.com/office/drawing/2014/main" id="{CD4C894F-784B-F98C-3D76-BBF92CE0C000}"/>
                  </a:ext>
                </a:extLst>
              </p:cNvPr>
              <p:cNvSpPr txBox="1"/>
              <p:nvPr/>
            </p:nvSpPr>
            <p:spPr>
              <a:xfrm>
                <a:off x="5595107" y="6381288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64BAD07C-CD84-598F-B215-EAAD3232E573}"/>
                  </a:ext>
                </a:extLst>
              </p:cNvPr>
              <p:cNvSpPr txBox="1"/>
              <p:nvPr/>
            </p:nvSpPr>
            <p:spPr>
              <a:xfrm>
                <a:off x="5757002" y="6381288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97" name="CasellaDiTesto 96">
                <a:extLst>
                  <a:ext uri="{FF2B5EF4-FFF2-40B4-BE49-F238E27FC236}">
                    <a16:creationId xmlns:a16="http://schemas.microsoft.com/office/drawing/2014/main" id="{6E561A39-A343-EAF0-25E8-55BF5CE82A96}"/>
                  </a:ext>
                </a:extLst>
              </p:cNvPr>
              <p:cNvSpPr txBox="1"/>
              <p:nvPr/>
            </p:nvSpPr>
            <p:spPr>
              <a:xfrm>
                <a:off x="5947159" y="6381288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id="{66C717BD-14B9-BE10-57C3-1DBF26FD2344}"/>
                  </a:ext>
                </a:extLst>
              </p:cNvPr>
              <p:cNvSpPr txBox="1"/>
              <p:nvPr/>
            </p:nvSpPr>
            <p:spPr>
              <a:xfrm>
                <a:off x="6278945" y="6381287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D67BBD4B-E830-2455-8191-2211AF8F87B3}"/>
                  </a:ext>
                </a:extLst>
              </p:cNvPr>
              <p:cNvSpPr txBox="1"/>
              <p:nvPr/>
            </p:nvSpPr>
            <p:spPr>
              <a:xfrm>
                <a:off x="6112921" y="6381288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100" name="Connettore diritto 99">
                <a:extLst>
                  <a:ext uri="{FF2B5EF4-FFF2-40B4-BE49-F238E27FC236}">
                    <a16:creationId xmlns:a16="http://schemas.microsoft.com/office/drawing/2014/main" id="{FAFDE9B4-3CED-5745-2061-147A590C34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09081" y="6570359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Connettore diritto 100">
                <a:extLst>
                  <a:ext uri="{FF2B5EF4-FFF2-40B4-BE49-F238E27FC236}">
                    <a16:creationId xmlns:a16="http://schemas.microsoft.com/office/drawing/2014/main" id="{B92804AE-581E-C095-0D98-470B5C3C17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61133" y="6570359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11A4964A-9DED-7129-6277-8F1726C5862E}"/>
                  </a:ext>
                </a:extLst>
              </p:cNvPr>
              <p:cNvSpPr txBox="1"/>
              <p:nvPr/>
            </p:nvSpPr>
            <p:spPr>
              <a:xfrm>
                <a:off x="5620335" y="6530512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82FE9B6C-EDAF-BD41-A312-742CB91701BD}"/>
                  </a:ext>
                </a:extLst>
              </p:cNvPr>
              <p:cNvSpPr txBox="1"/>
              <p:nvPr/>
            </p:nvSpPr>
            <p:spPr>
              <a:xfrm>
                <a:off x="5936561" y="6530512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</p:grp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1152D2B2-8BE4-8B75-3C8F-9AE08C51AA0B}"/>
                </a:ext>
              </a:extLst>
            </p:cNvPr>
            <p:cNvSpPr txBox="1"/>
            <p:nvPr/>
          </p:nvSpPr>
          <p:spPr>
            <a:xfrm>
              <a:off x="3599713" y="3112530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</p:txBody>
        </p:sp>
        <p:sp>
          <p:nvSpPr>
            <p:cNvPr id="188" name="CasellaDiTesto 187">
              <a:extLst>
                <a:ext uri="{FF2B5EF4-FFF2-40B4-BE49-F238E27FC236}">
                  <a16:creationId xmlns:a16="http://schemas.microsoft.com/office/drawing/2014/main" id="{745AFCEC-EDA8-8F06-7D95-3F03E60D3DC0}"/>
                </a:ext>
              </a:extLst>
            </p:cNvPr>
            <p:cNvSpPr txBox="1"/>
            <p:nvPr/>
          </p:nvSpPr>
          <p:spPr>
            <a:xfrm>
              <a:off x="3946530" y="3264930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</p:txBody>
        </p:sp>
        <p:sp>
          <p:nvSpPr>
            <p:cNvPr id="189" name="CasellaDiTesto 188">
              <a:extLst>
                <a:ext uri="{FF2B5EF4-FFF2-40B4-BE49-F238E27FC236}">
                  <a16:creationId xmlns:a16="http://schemas.microsoft.com/office/drawing/2014/main" id="{BF7F8073-6C51-A8D3-983D-55E375D734DB}"/>
                </a:ext>
              </a:extLst>
            </p:cNvPr>
            <p:cNvSpPr txBox="1"/>
            <p:nvPr/>
          </p:nvSpPr>
          <p:spPr>
            <a:xfrm>
              <a:off x="3266708" y="281205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0" name="CasellaDiTesto 189">
              <a:extLst>
                <a:ext uri="{FF2B5EF4-FFF2-40B4-BE49-F238E27FC236}">
                  <a16:creationId xmlns:a16="http://schemas.microsoft.com/office/drawing/2014/main" id="{4D91EF8C-FEEF-AD77-268B-27949009F328}"/>
                </a:ext>
              </a:extLst>
            </p:cNvPr>
            <p:cNvSpPr txBox="1"/>
            <p:nvPr/>
          </p:nvSpPr>
          <p:spPr>
            <a:xfrm>
              <a:off x="3451443" y="311252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7" name="Gruppo 56">
            <a:extLst>
              <a:ext uri="{FF2B5EF4-FFF2-40B4-BE49-F238E27FC236}">
                <a16:creationId xmlns:a16="http://schemas.microsoft.com/office/drawing/2014/main" id="{A0CBE48D-8E0F-B2B3-67EF-FE1E8396A586}"/>
              </a:ext>
            </a:extLst>
          </p:cNvPr>
          <p:cNvGrpSpPr/>
          <p:nvPr/>
        </p:nvGrpSpPr>
        <p:grpSpPr>
          <a:xfrm>
            <a:off x="4619784" y="2843808"/>
            <a:ext cx="2049576" cy="1647394"/>
            <a:chOff x="4619784" y="2843808"/>
            <a:chExt cx="2049576" cy="1647394"/>
          </a:xfrm>
        </p:grpSpPr>
        <p:grpSp>
          <p:nvGrpSpPr>
            <p:cNvPr id="36" name="Gruppo 35">
              <a:extLst>
                <a:ext uri="{FF2B5EF4-FFF2-40B4-BE49-F238E27FC236}">
                  <a16:creationId xmlns:a16="http://schemas.microsoft.com/office/drawing/2014/main" id="{4CCBCED7-1CC4-1B0F-186E-9A01450CD7EF}"/>
                </a:ext>
              </a:extLst>
            </p:cNvPr>
            <p:cNvGrpSpPr/>
            <p:nvPr/>
          </p:nvGrpSpPr>
          <p:grpSpPr>
            <a:xfrm>
              <a:off x="4619784" y="2843808"/>
              <a:ext cx="2049576" cy="1647394"/>
              <a:chOff x="5280502" y="4174118"/>
              <a:chExt cx="2049576" cy="1647394"/>
            </a:xfrm>
          </p:grpSpPr>
          <p:pic>
            <p:nvPicPr>
              <p:cNvPr id="37" name="Immagine 36">
                <a:extLst>
                  <a:ext uri="{FF2B5EF4-FFF2-40B4-BE49-F238E27FC236}">
                    <a16:creationId xmlns:a16="http://schemas.microsoft.com/office/drawing/2014/main" id="{EADFFB06-5CB5-AA2D-438A-014E5F5760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872576" y="4273224"/>
                <a:ext cx="1214178" cy="1231200"/>
              </a:xfrm>
              <a:prstGeom prst="rect">
                <a:avLst/>
              </a:prstGeom>
            </p:spPr>
          </p:pic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13B852F9-67EB-549F-A537-AFB7E147CE06}"/>
                  </a:ext>
                </a:extLst>
              </p:cNvPr>
              <p:cNvSpPr txBox="1"/>
              <p:nvPr/>
            </p:nvSpPr>
            <p:spPr>
              <a:xfrm>
                <a:off x="5602510" y="473810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871D4CB5-26DC-6241-A12B-6A53DABD597E}"/>
                  </a:ext>
                </a:extLst>
              </p:cNvPr>
              <p:cNvSpPr txBox="1"/>
              <p:nvPr/>
            </p:nvSpPr>
            <p:spPr>
              <a:xfrm>
                <a:off x="5602510" y="530295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5AF7BD84-E138-D3A8-CD16-22FDFE06CEDC}"/>
                  </a:ext>
                </a:extLst>
              </p:cNvPr>
              <p:cNvSpPr txBox="1"/>
              <p:nvPr/>
            </p:nvSpPr>
            <p:spPr>
              <a:xfrm>
                <a:off x="5602510" y="417411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5224AB39-2EEF-CE00-DDD7-20C1643C1F66}"/>
                  </a:ext>
                </a:extLst>
              </p:cNvPr>
              <p:cNvSpPr txBox="1"/>
              <p:nvPr/>
            </p:nvSpPr>
            <p:spPr>
              <a:xfrm rot="16200000">
                <a:off x="4982664" y="4660667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3D9AA52D-521B-FE6A-6AEC-75E99FB47E9E}"/>
                  </a:ext>
                </a:extLst>
              </p:cNvPr>
              <p:cNvSpPr txBox="1"/>
              <p:nvPr/>
            </p:nvSpPr>
            <p:spPr>
              <a:xfrm>
                <a:off x="5943047" y="54260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79BBC665-C78F-8311-7575-AF3E5697D370}"/>
                  </a:ext>
                </a:extLst>
              </p:cNvPr>
              <p:cNvSpPr txBox="1"/>
              <p:nvPr/>
            </p:nvSpPr>
            <p:spPr>
              <a:xfrm>
                <a:off x="6110136" y="5426067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4" name="CasellaDiTesto 43">
                <a:extLst>
                  <a:ext uri="{FF2B5EF4-FFF2-40B4-BE49-F238E27FC236}">
                    <a16:creationId xmlns:a16="http://schemas.microsoft.com/office/drawing/2014/main" id="{45CAE275-A656-8852-7A98-A2715DC63C30}"/>
                  </a:ext>
                </a:extLst>
              </p:cNvPr>
              <p:cNvSpPr txBox="1"/>
              <p:nvPr/>
            </p:nvSpPr>
            <p:spPr>
              <a:xfrm>
                <a:off x="6306082" y="5426067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5" name="CasellaDiTesto 44">
                <a:extLst>
                  <a:ext uri="{FF2B5EF4-FFF2-40B4-BE49-F238E27FC236}">
                    <a16:creationId xmlns:a16="http://schemas.microsoft.com/office/drawing/2014/main" id="{6C7608AB-404C-8FC0-FA0E-C126ABCBD55C}"/>
                  </a:ext>
                </a:extLst>
              </p:cNvPr>
              <p:cNvSpPr txBox="1"/>
              <p:nvPr/>
            </p:nvSpPr>
            <p:spPr>
              <a:xfrm>
                <a:off x="6467977" y="5426067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1CD897E8-B78B-793F-2465-62AB5030A4BF}"/>
                  </a:ext>
                </a:extLst>
              </p:cNvPr>
              <p:cNvSpPr txBox="1"/>
              <p:nvPr/>
            </p:nvSpPr>
            <p:spPr>
              <a:xfrm>
                <a:off x="6658134" y="5426067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DF73F9AE-9645-DC70-F254-2182868BC4E4}"/>
                  </a:ext>
                </a:extLst>
              </p:cNvPr>
              <p:cNvSpPr txBox="1"/>
              <p:nvPr/>
            </p:nvSpPr>
            <p:spPr>
              <a:xfrm>
                <a:off x="6989920" y="5426066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88C7C2AA-C0B5-7EA7-D917-4E315D6DDCD8}"/>
                  </a:ext>
                </a:extLst>
              </p:cNvPr>
              <p:cNvSpPr txBox="1"/>
              <p:nvPr/>
            </p:nvSpPr>
            <p:spPr>
              <a:xfrm>
                <a:off x="6823896" y="5426067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49" name="Connettore diritto 48">
                <a:extLst>
                  <a:ext uri="{FF2B5EF4-FFF2-40B4-BE49-F238E27FC236}">
                    <a16:creationId xmlns:a16="http://schemas.microsoft.com/office/drawing/2014/main" id="{6635E252-5641-EE02-F527-13FD7C51A9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20056" y="5615138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nettore diritto 49">
                <a:extLst>
                  <a:ext uri="{FF2B5EF4-FFF2-40B4-BE49-F238E27FC236}">
                    <a16:creationId xmlns:a16="http://schemas.microsoft.com/office/drawing/2014/main" id="{45A75724-E266-ABE1-3082-21FC540227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72108" y="5615138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82F99DA9-E739-72CB-E591-7638375580FE}"/>
                  </a:ext>
                </a:extLst>
              </p:cNvPr>
              <p:cNvSpPr txBox="1"/>
              <p:nvPr/>
            </p:nvSpPr>
            <p:spPr>
              <a:xfrm>
                <a:off x="6331310" y="5575291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274A87A8-C9C8-1322-4C50-A90545E24EA4}"/>
                  </a:ext>
                </a:extLst>
              </p:cNvPr>
              <p:cNvSpPr txBox="1"/>
              <p:nvPr/>
            </p:nvSpPr>
            <p:spPr>
              <a:xfrm>
                <a:off x="6647536" y="5575291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</p:grp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D237AB70-141A-B17E-896B-FA483EBBBDDA}"/>
                </a:ext>
              </a:extLst>
            </p:cNvPr>
            <p:cNvSpPr txBox="1"/>
            <p:nvPr/>
          </p:nvSpPr>
          <p:spPr>
            <a:xfrm>
              <a:off x="5449204" y="28884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2" name="CasellaDiTesto 191">
              <a:extLst>
                <a:ext uri="{FF2B5EF4-FFF2-40B4-BE49-F238E27FC236}">
                  <a16:creationId xmlns:a16="http://schemas.microsoft.com/office/drawing/2014/main" id="{AAF22751-E142-5272-C26A-142F53D1E86E}"/>
                </a:ext>
              </a:extLst>
            </p:cNvPr>
            <p:cNvSpPr txBox="1"/>
            <p:nvPr/>
          </p:nvSpPr>
          <p:spPr>
            <a:xfrm>
              <a:off x="5601604" y="28884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3" name="CasellaDiTesto 192">
              <a:extLst>
                <a:ext uri="{FF2B5EF4-FFF2-40B4-BE49-F238E27FC236}">
                  <a16:creationId xmlns:a16="http://schemas.microsoft.com/office/drawing/2014/main" id="{3404E098-D439-5309-A861-B67CF12C8964}"/>
                </a:ext>
              </a:extLst>
            </p:cNvPr>
            <p:cNvSpPr txBox="1"/>
            <p:nvPr/>
          </p:nvSpPr>
          <p:spPr>
            <a:xfrm>
              <a:off x="5754004" y="28884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4" name="CasellaDiTesto 193">
              <a:extLst>
                <a:ext uri="{FF2B5EF4-FFF2-40B4-BE49-F238E27FC236}">
                  <a16:creationId xmlns:a16="http://schemas.microsoft.com/office/drawing/2014/main" id="{379B2AC4-BE99-1733-4CCB-2A248621A624}"/>
                </a:ext>
              </a:extLst>
            </p:cNvPr>
            <p:cNvSpPr txBox="1"/>
            <p:nvPr/>
          </p:nvSpPr>
          <p:spPr>
            <a:xfrm>
              <a:off x="5963554" y="28884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5" name="CasellaDiTesto 194">
              <a:extLst>
                <a:ext uri="{FF2B5EF4-FFF2-40B4-BE49-F238E27FC236}">
                  <a16:creationId xmlns:a16="http://schemas.microsoft.com/office/drawing/2014/main" id="{373B8C65-9E2B-25B2-A523-9279DE3CBB9B}"/>
                </a:ext>
              </a:extLst>
            </p:cNvPr>
            <p:cNvSpPr txBox="1"/>
            <p:nvPr/>
          </p:nvSpPr>
          <p:spPr>
            <a:xfrm>
              <a:off x="6147704" y="28884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96" name="CasellaDiTesto 195">
              <a:extLst>
                <a:ext uri="{FF2B5EF4-FFF2-40B4-BE49-F238E27FC236}">
                  <a16:creationId xmlns:a16="http://schemas.microsoft.com/office/drawing/2014/main" id="{1AF3BEB0-6EF6-E092-0FFC-F2267E01EE85}"/>
                </a:ext>
              </a:extLst>
            </p:cNvPr>
            <p:cNvSpPr txBox="1"/>
            <p:nvPr/>
          </p:nvSpPr>
          <p:spPr>
            <a:xfrm>
              <a:off x="5754464" y="3176478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CBEB5537-FC20-C05D-9BC4-E4F93D1D6093}"/>
                </a:ext>
              </a:extLst>
            </p:cNvPr>
            <p:cNvSpPr txBox="1"/>
            <p:nvPr/>
          </p:nvSpPr>
          <p:spPr>
            <a:xfrm>
              <a:off x="6160864" y="3176478"/>
              <a:ext cx="2872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  <a:p>
              <a:r>
                <a:rPr lang="it-IT" sz="1000" dirty="0"/>
                <a:t>°°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60AEA678-B86A-3945-E4CB-755D1DD7BDDC}"/>
                </a:ext>
              </a:extLst>
            </p:cNvPr>
            <p:cNvSpPr txBox="1"/>
            <p:nvPr/>
          </p:nvSpPr>
          <p:spPr>
            <a:xfrm>
              <a:off x="6146842" y="3523818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^^</a:t>
              </a:r>
            </a:p>
          </p:txBody>
        </p:sp>
      </p:grpSp>
      <p:grpSp>
        <p:nvGrpSpPr>
          <p:cNvPr id="58" name="Gruppo 57">
            <a:extLst>
              <a:ext uri="{FF2B5EF4-FFF2-40B4-BE49-F238E27FC236}">
                <a16:creationId xmlns:a16="http://schemas.microsoft.com/office/drawing/2014/main" id="{57C0C524-383F-BCAB-4B53-F43E729E9D64}"/>
              </a:ext>
            </a:extLst>
          </p:cNvPr>
          <p:cNvGrpSpPr/>
          <p:nvPr/>
        </p:nvGrpSpPr>
        <p:grpSpPr>
          <a:xfrm>
            <a:off x="1333614" y="5220072"/>
            <a:ext cx="2049576" cy="1671523"/>
            <a:chOff x="1333614" y="5220072"/>
            <a:chExt cx="2049576" cy="1671523"/>
          </a:xfrm>
        </p:grpSpPr>
        <p:grpSp>
          <p:nvGrpSpPr>
            <p:cNvPr id="131" name="Gruppo 130">
              <a:extLst>
                <a:ext uri="{FF2B5EF4-FFF2-40B4-BE49-F238E27FC236}">
                  <a16:creationId xmlns:a16="http://schemas.microsoft.com/office/drawing/2014/main" id="{55BC3A1A-EDF6-044C-48FB-3A64CAA5891E}"/>
                </a:ext>
              </a:extLst>
            </p:cNvPr>
            <p:cNvGrpSpPr/>
            <p:nvPr/>
          </p:nvGrpSpPr>
          <p:grpSpPr>
            <a:xfrm>
              <a:off x="1333614" y="5220072"/>
              <a:ext cx="2049576" cy="1671523"/>
              <a:chOff x="4729040" y="241565"/>
              <a:chExt cx="2049576" cy="1671523"/>
            </a:xfrm>
          </p:grpSpPr>
          <p:pic>
            <p:nvPicPr>
              <p:cNvPr id="132" name="Immagine 131">
                <a:extLst>
                  <a:ext uri="{FF2B5EF4-FFF2-40B4-BE49-F238E27FC236}">
                    <a16:creationId xmlns:a16="http://schemas.microsoft.com/office/drawing/2014/main" id="{3E7C4624-519C-6A16-9DA7-F1B82FE3F4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326580" y="340671"/>
                <a:ext cx="1213940" cy="1231200"/>
              </a:xfrm>
              <a:prstGeom prst="rect">
                <a:avLst/>
              </a:prstGeom>
            </p:spPr>
          </p:pic>
          <p:sp>
            <p:nvSpPr>
              <p:cNvPr id="133" name="CasellaDiTesto 132">
                <a:extLst>
                  <a:ext uri="{FF2B5EF4-FFF2-40B4-BE49-F238E27FC236}">
                    <a16:creationId xmlns:a16="http://schemas.microsoft.com/office/drawing/2014/main" id="{B536A0B9-660D-17CF-28FA-1D1CFDBEABC0}"/>
                  </a:ext>
                </a:extLst>
              </p:cNvPr>
              <p:cNvSpPr txBox="1"/>
              <p:nvPr/>
            </p:nvSpPr>
            <p:spPr>
              <a:xfrm>
                <a:off x="4991968" y="805555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5.0</a:t>
                </a:r>
              </a:p>
            </p:txBody>
          </p:sp>
          <p:sp>
            <p:nvSpPr>
              <p:cNvPr id="134" name="CasellaDiTesto 133">
                <a:extLst>
                  <a:ext uri="{FF2B5EF4-FFF2-40B4-BE49-F238E27FC236}">
                    <a16:creationId xmlns:a16="http://schemas.microsoft.com/office/drawing/2014/main" id="{86606F87-F6DC-5E11-8AF3-B09C6A9FA38B}"/>
                  </a:ext>
                </a:extLst>
              </p:cNvPr>
              <p:cNvSpPr txBox="1"/>
              <p:nvPr/>
            </p:nvSpPr>
            <p:spPr>
              <a:xfrm>
                <a:off x="5051048" y="137040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35" name="CasellaDiTesto 134">
                <a:extLst>
                  <a:ext uri="{FF2B5EF4-FFF2-40B4-BE49-F238E27FC236}">
                    <a16:creationId xmlns:a16="http://schemas.microsoft.com/office/drawing/2014/main" id="{93B9E74D-5A1F-AF2A-51AB-1692A6B0A6BF}"/>
                  </a:ext>
                </a:extLst>
              </p:cNvPr>
              <p:cNvSpPr txBox="1"/>
              <p:nvPr/>
            </p:nvSpPr>
            <p:spPr>
              <a:xfrm>
                <a:off x="5000248" y="241565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0.0</a:t>
                </a:r>
              </a:p>
            </p:txBody>
          </p:sp>
          <p:sp>
            <p:nvSpPr>
              <p:cNvPr id="136" name="CasellaDiTesto 135">
                <a:extLst>
                  <a:ext uri="{FF2B5EF4-FFF2-40B4-BE49-F238E27FC236}">
                    <a16:creationId xmlns:a16="http://schemas.microsoft.com/office/drawing/2014/main" id="{1EC4F34A-3F9E-BD09-03EC-BB16748FFF84}"/>
                  </a:ext>
                </a:extLst>
              </p:cNvPr>
              <p:cNvSpPr txBox="1"/>
              <p:nvPr/>
            </p:nvSpPr>
            <p:spPr>
              <a:xfrm rot="16200000">
                <a:off x="4431202" y="728114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S2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137" name="CasellaDiTesto 136">
                <a:extLst>
                  <a:ext uri="{FF2B5EF4-FFF2-40B4-BE49-F238E27FC236}">
                    <a16:creationId xmlns:a16="http://schemas.microsoft.com/office/drawing/2014/main" id="{DCF5AFF8-4D3C-BB0E-F068-99899F3877AE}"/>
                  </a:ext>
                </a:extLst>
              </p:cNvPr>
              <p:cNvSpPr txBox="1"/>
              <p:nvPr/>
            </p:nvSpPr>
            <p:spPr>
              <a:xfrm>
                <a:off x="5453872" y="149351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38" name="CasellaDiTesto 137">
                <a:extLst>
                  <a:ext uri="{FF2B5EF4-FFF2-40B4-BE49-F238E27FC236}">
                    <a16:creationId xmlns:a16="http://schemas.microsoft.com/office/drawing/2014/main" id="{AD8B62DE-0E11-916F-DC6C-E4C23E333058}"/>
                  </a:ext>
                </a:extLst>
              </p:cNvPr>
              <p:cNvSpPr txBox="1"/>
              <p:nvPr/>
            </p:nvSpPr>
            <p:spPr>
              <a:xfrm>
                <a:off x="5690794" y="149351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9" name="CasellaDiTesto 138">
                <a:extLst>
                  <a:ext uri="{FF2B5EF4-FFF2-40B4-BE49-F238E27FC236}">
                    <a16:creationId xmlns:a16="http://schemas.microsoft.com/office/drawing/2014/main" id="{709F6B65-4079-938D-3796-2F6B6B18110A}"/>
                  </a:ext>
                </a:extLst>
              </p:cNvPr>
              <p:cNvSpPr txBox="1"/>
              <p:nvPr/>
            </p:nvSpPr>
            <p:spPr>
              <a:xfrm>
                <a:off x="5965660" y="149351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40" name="CasellaDiTesto 139">
                <a:extLst>
                  <a:ext uri="{FF2B5EF4-FFF2-40B4-BE49-F238E27FC236}">
                    <a16:creationId xmlns:a16="http://schemas.microsoft.com/office/drawing/2014/main" id="{8AF101B1-C5AD-A189-9D0F-02B158DD91E3}"/>
                  </a:ext>
                </a:extLst>
              </p:cNvPr>
              <p:cNvSpPr txBox="1"/>
              <p:nvPr/>
            </p:nvSpPr>
            <p:spPr>
              <a:xfrm>
                <a:off x="6438458" y="1493513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141" name="CasellaDiTesto 140">
                <a:extLst>
                  <a:ext uri="{FF2B5EF4-FFF2-40B4-BE49-F238E27FC236}">
                    <a16:creationId xmlns:a16="http://schemas.microsoft.com/office/drawing/2014/main" id="{D5424A87-3BA9-CE70-792B-1D781CEF06C6}"/>
                  </a:ext>
                </a:extLst>
              </p:cNvPr>
              <p:cNvSpPr txBox="1"/>
              <p:nvPr/>
            </p:nvSpPr>
            <p:spPr>
              <a:xfrm>
                <a:off x="6221634" y="149351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42" name="CasellaDiTesto 141">
                <a:extLst>
                  <a:ext uri="{FF2B5EF4-FFF2-40B4-BE49-F238E27FC236}">
                    <a16:creationId xmlns:a16="http://schemas.microsoft.com/office/drawing/2014/main" id="{DD5EB163-1498-A6B8-C970-4AFCCC9C4F07}"/>
                  </a:ext>
                </a:extLst>
              </p:cNvPr>
              <p:cNvSpPr txBox="1"/>
              <p:nvPr/>
            </p:nvSpPr>
            <p:spPr>
              <a:xfrm>
                <a:off x="5906059" y="1666867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GART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Connettore diritto 142">
                <a:extLst>
                  <a:ext uri="{FF2B5EF4-FFF2-40B4-BE49-F238E27FC236}">
                    <a16:creationId xmlns:a16="http://schemas.microsoft.com/office/drawing/2014/main" id="{77D460B1-BFB8-577F-A55C-B9B67CCAA4F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79634" y="1697356"/>
                <a:ext cx="27200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36EE16C7-9605-7964-8A32-403F3630653E}"/>
                </a:ext>
              </a:extLst>
            </p:cNvPr>
            <p:cNvSpPr txBox="1"/>
            <p:nvPr/>
          </p:nvSpPr>
          <p:spPr>
            <a:xfrm>
              <a:off x="2271498" y="5275060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2C9A0CB1-25BA-5221-493B-6B9F5C9F57AE}"/>
                </a:ext>
              </a:extLst>
            </p:cNvPr>
            <p:cNvSpPr txBox="1"/>
            <p:nvPr/>
          </p:nvSpPr>
          <p:spPr>
            <a:xfrm>
              <a:off x="2853186" y="5755424"/>
              <a:ext cx="2359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</a:t>
              </a:r>
            </a:p>
          </p:txBody>
        </p:sp>
      </p:grpSp>
      <p:grpSp>
        <p:nvGrpSpPr>
          <p:cNvPr id="59" name="Gruppo 58">
            <a:extLst>
              <a:ext uri="{FF2B5EF4-FFF2-40B4-BE49-F238E27FC236}">
                <a16:creationId xmlns:a16="http://schemas.microsoft.com/office/drawing/2014/main" id="{D013DCB4-B3E3-0209-9AC8-2EEEE5D11CDD}"/>
              </a:ext>
            </a:extLst>
          </p:cNvPr>
          <p:cNvGrpSpPr/>
          <p:nvPr/>
        </p:nvGrpSpPr>
        <p:grpSpPr>
          <a:xfrm>
            <a:off x="3586434" y="5196542"/>
            <a:ext cx="2049576" cy="1695053"/>
            <a:chOff x="3586434" y="5196542"/>
            <a:chExt cx="2049576" cy="1695053"/>
          </a:xfrm>
        </p:grpSpPr>
        <p:grpSp>
          <p:nvGrpSpPr>
            <p:cNvPr id="144" name="Gruppo 143">
              <a:extLst>
                <a:ext uri="{FF2B5EF4-FFF2-40B4-BE49-F238E27FC236}">
                  <a16:creationId xmlns:a16="http://schemas.microsoft.com/office/drawing/2014/main" id="{7F4EC62F-19B7-5A24-B074-B1FE7DA16537}"/>
                </a:ext>
              </a:extLst>
            </p:cNvPr>
            <p:cNvGrpSpPr/>
            <p:nvPr/>
          </p:nvGrpSpPr>
          <p:grpSpPr>
            <a:xfrm>
              <a:off x="3586434" y="5220072"/>
              <a:ext cx="2049576" cy="1671523"/>
              <a:chOff x="4657032" y="1933705"/>
              <a:chExt cx="2049576" cy="1671523"/>
            </a:xfrm>
          </p:grpSpPr>
          <p:pic>
            <p:nvPicPr>
              <p:cNvPr id="145" name="Immagine 144">
                <a:extLst>
                  <a:ext uri="{FF2B5EF4-FFF2-40B4-BE49-F238E27FC236}">
                    <a16:creationId xmlns:a16="http://schemas.microsoft.com/office/drawing/2014/main" id="{CBDAC84F-3280-80AD-0B4E-0E3508D068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260922" y="2007411"/>
                <a:ext cx="1249200" cy="1249200"/>
              </a:xfrm>
              <a:prstGeom prst="rect">
                <a:avLst/>
              </a:prstGeom>
            </p:spPr>
          </p:pic>
          <p:sp>
            <p:nvSpPr>
              <p:cNvPr id="146" name="CasellaDiTesto 145">
                <a:extLst>
                  <a:ext uri="{FF2B5EF4-FFF2-40B4-BE49-F238E27FC236}">
                    <a16:creationId xmlns:a16="http://schemas.microsoft.com/office/drawing/2014/main" id="{9C2023AE-90A4-0F37-8416-42DC44DF0309}"/>
                  </a:ext>
                </a:extLst>
              </p:cNvPr>
              <p:cNvSpPr txBox="1"/>
              <p:nvPr/>
            </p:nvSpPr>
            <p:spPr>
              <a:xfrm>
                <a:off x="4979040" y="249769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147" name="CasellaDiTesto 146">
                <a:extLst>
                  <a:ext uri="{FF2B5EF4-FFF2-40B4-BE49-F238E27FC236}">
                    <a16:creationId xmlns:a16="http://schemas.microsoft.com/office/drawing/2014/main" id="{06CE399D-9C77-A9BD-BE1E-039760BFAEF8}"/>
                  </a:ext>
                </a:extLst>
              </p:cNvPr>
              <p:cNvSpPr txBox="1"/>
              <p:nvPr/>
            </p:nvSpPr>
            <p:spPr>
              <a:xfrm>
                <a:off x="4979040" y="306254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48" name="CasellaDiTesto 147">
                <a:extLst>
                  <a:ext uri="{FF2B5EF4-FFF2-40B4-BE49-F238E27FC236}">
                    <a16:creationId xmlns:a16="http://schemas.microsoft.com/office/drawing/2014/main" id="{4E0E4731-0E31-4B81-B85A-9DCDE966ED20}"/>
                  </a:ext>
                </a:extLst>
              </p:cNvPr>
              <p:cNvSpPr txBox="1"/>
              <p:nvPr/>
            </p:nvSpPr>
            <p:spPr>
              <a:xfrm>
                <a:off x="4979040" y="193370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</a:p>
            </p:txBody>
          </p:sp>
          <p:sp>
            <p:nvSpPr>
              <p:cNvPr id="149" name="CasellaDiTesto 148">
                <a:extLst>
                  <a:ext uri="{FF2B5EF4-FFF2-40B4-BE49-F238E27FC236}">
                    <a16:creationId xmlns:a16="http://schemas.microsoft.com/office/drawing/2014/main" id="{FF62FF98-D928-9E4C-93E7-8C3B8D64176A}"/>
                  </a:ext>
                </a:extLst>
              </p:cNvPr>
              <p:cNvSpPr txBox="1"/>
              <p:nvPr/>
            </p:nvSpPr>
            <p:spPr>
              <a:xfrm rot="16200000">
                <a:off x="4359194" y="2420254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150" name="CasellaDiTesto 149">
                <a:extLst>
                  <a:ext uri="{FF2B5EF4-FFF2-40B4-BE49-F238E27FC236}">
                    <a16:creationId xmlns:a16="http://schemas.microsoft.com/office/drawing/2014/main" id="{B19F8A42-E76E-2043-D7BE-55F0265EF6C3}"/>
                  </a:ext>
                </a:extLst>
              </p:cNvPr>
              <p:cNvSpPr txBox="1"/>
              <p:nvPr/>
            </p:nvSpPr>
            <p:spPr>
              <a:xfrm>
                <a:off x="5381864" y="318565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1" name="CasellaDiTesto 150">
                <a:extLst>
                  <a:ext uri="{FF2B5EF4-FFF2-40B4-BE49-F238E27FC236}">
                    <a16:creationId xmlns:a16="http://schemas.microsoft.com/office/drawing/2014/main" id="{090A74BF-5AC8-B9FB-52F6-9146F2708B49}"/>
                  </a:ext>
                </a:extLst>
              </p:cNvPr>
              <p:cNvSpPr txBox="1"/>
              <p:nvPr/>
            </p:nvSpPr>
            <p:spPr>
              <a:xfrm>
                <a:off x="5618786" y="318565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52" name="CasellaDiTesto 151">
                <a:extLst>
                  <a:ext uri="{FF2B5EF4-FFF2-40B4-BE49-F238E27FC236}">
                    <a16:creationId xmlns:a16="http://schemas.microsoft.com/office/drawing/2014/main" id="{B7FA454A-8D30-F063-39BC-14B87F2A4ED9}"/>
                  </a:ext>
                </a:extLst>
              </p:cNvPr>
              <p:cNvSpPr txBox="1"/>
              <p:nvPr/>
            </p:nvSpPr>
            <p:spPr>
              <a:xfrm>
                <a:off x="5893652" y="3185654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3" name="CasellaDiTesto 152">
                <a:extLst>
                  <a:ext uri="{FF2B5EF4-FFF2-40B4-BE49-F238E27FC236}">
                    <a16:creationId xmlns:a16="http://schemas.microsoft.com/office/drawing/2014/main" id="{A9C83455-137D-7F2D-9903-1D488C563B4D}"/>
                  </a:ext>
                </a:extLst>
              </p:cNvPr>
              <p:cNvSpPr txBox="1"/>
              <p:nvPr/>
            </p:nvSpPr>
            <p:spPr>
              <a:xfrm>
                <a:off x="6366450" y="3185653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154" name="CasellaDiTesto 153">
                <a:extLst>
                  <a:ext uri="{FF2B5EF4-FFF2-40B4-BE49-F238E27FC236}">
                    <a16:creationId xmlns:a16="http://schemas.microsoft.com/office/drawing/2014/main" id="{A4C98995-332F-9F9A-C100-D88E56B1DC39}"/>
                  </a:ext>
                </a:extLst>
              </p:cNvPr>
              <p:cNvSpPr txBox="1"/>
              <p:nvPr/>
            </p:nvSpPr>
            <p:spPr>
              <a:xfrm>
                <a:off x="6149626" y="3185654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55" name="CasellaDiTesto 154">
                <a:extLst>
                  <a:ext uri="{FF2B5EF4-FFF2-40B4-BE49-F238E27FC236}">
                    <a16:creationId xmlns:a16="http://schemas.microsoft.com/office/drawing/2014/main" id="{DEBB4603-0B64-FEFD-8D77-F3BE0A32A2A0}"/>
                  </a:ext>
                </a:extLst>
              </p:cNvPr>
              <p:cNvSpPr txBox="1"/>
              <p:nvPr/>
            </p:nvSpPr>
            <p:spPr>
              <a:xfrm>
                <a:off x="5834051" y="3359007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GART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6" name="Connettore diritto 155">
                <a:extLst>
                  <a:ext uri="{FF2B5EF4-FFF2-40B4-BE49-F238E27FC236}">
                    <a16:creationId xmlns:a16="http://schemas.microsoft.com/office/drawing/2014/main" id="{45B9F9C5-975B-91B4-B05A-4B1C3063F36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07626" y="3389496"/>
                <a:ext cx="27200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A28BDCB5-4302-D3F4-C592-68749F5057E1}"/>
                </a:ext>
              </a:extLst>
            </p:cNvPr>
            <p:cNvSpPr txBox="1"/>
            <p:nvPr/>
          </p:nvSpPr>
          <p:spPr>
            <a:xfrm>
              <a:off x="4526820" y="5196542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202" name="CasellaDiTesto 201">
              <a:extLst>
                <a:ext uri="{FF2B5EF4-FFF2-40B4-BE49-F238E27FC236}">
                  <a16:creationId xmlns:a16="http://schemas.microsoft.com/office/drawing/2014/main" id="{9EE7B063-F8D3-CC15-96F2-265DF4F40D13}"/>
                </a:ext>
              </a:extLst>
            </p:cNvPr>
            <p:cNvSpPr txBox="1"/>
            <p:nvPr/>
          </p:nvSpPr>
          <p:spPr>
            <a:xfrm>
              <a:off x="4840291" y="519654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03" name="CasellaDiTesto 202">
              <a:extLst>
                <a:ext uri="{FF2B5EF4-FFF2-40B4-BE49-F238E27FC236}">
                  <a16:creationId xmlns:a16="http://schemas.microsoft.com/office/drawing/2014/main" id="{B272F1FE-4E18-ED6D-1A7D-9F701ABD3536}"/>
                </a:ext>
              </a:extLst>
            </p:cNvPr>
            <p:cNvSpPr txBox="1"/>
            <p:nvPr/>
          </p:nvSpPr>
          <p:spPr>
            <a:xfrm>
              <a:off x="5085184" y="5196542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2582B475-1B9F-706F-262F-54FB84EACD04}"/>
                </a:ext>
              </a:extLst>
            </p:cNvPr>
            <p:cNvSpPr txBox="1"/>
            <p:nvPr/>
          </p:nvSpPr>
          <p:spPr>
            <a:xfrm>
              <a:off x="5093199" y="5376819"/>
              <a:ext cx="3674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^^^</a:t>
              </a:r>
            </a:p>
          </p:txBody>
        </p:sp>
      </p:grpSp>
      <p:grpSp>
        <p:nvGrpSpPr>
          <p:cNvPr id="61" name="Gruppo 60">
            <a:extLst>
              <a:ext uri="{FF2B5EF4-FFF2-40B4-BE49-F238E27FC236}">
                <a16:creationId xmlns:a16="http://schemas.microsoft.com/office/drawing/2014/main" id="{77C24B0F-E378-42A4-5481-77DEFF5DCFCB}"/>
              </a:ext>
            </a:extLst>
          </p:cNvPr>
          <p:cNvGrpSpPr/>
          <p:nvPr/>
        </p:nvGrpSpPr>
        <p:grpSpPr>
          <a:xfrm>
            <a:off x="1333614" y="7220957"/>
            <a:ext cx="2049576" cy="1671523"/>
            <a:chOff x="1333614" y="7220957"/>
            <a:chExt cx="2049576" cy="1671523"/>
          </a:xfrm>
        </p:grpSpPr>
        <p:grpSp>
          <p:nvGrpSpPr>
            <p:cNvPr id="105" name="Gruppo 104">
              <a:extLst>
                <a:ext uri="{FF2B5EF4-FFF2-40B4-BE49-F238E27FC236}">
                  <a16:creationId xmlns:a16="http://schemas.microsoft.com/office/drawing/2014/main" id="{1931345C-9B1F-8D64-DB71-3AB7D60C8ED0}"/>
                </a:ext>
              </a:extLst>
            </p:cNvPr>
            <p:cNvGrpSpPr/>
            <p:nvPr/>
          </p:nvGrpSpPr>
          <p:grpSpPr>
            <a:xfrm>
              <a:off x="1333614" y="7220957"/>
              <a:ext cx="2049576" cy="1671523"/>
              <a:chOff x="2404212" y="1719133"/>
              <a:chExt cx="2049576" cy="1671523"/>
            </a:xfrm>
          </p:grpSpPr>
          <p:pic>
            <p:nvPicPr>
              <p:cNvPr id="106" name="Immagine 105">
                <a:extLst>
                  <a:ext uri="{FF2B5EF4-FFF2-40B4-BE49-F238E27FC236}">
                    <a16:creationId xmlns:a16="http://schemas.microsoft.com/office/drawing/2014/main" id="{AC9D4F09-7B47-EF1F-7D9E-00B6FED9BE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001752" y="1818239"/>
                <a:ext cx="1208505" cy="1231200"/>
              </a:xfrm>
              <a:prstGeom prst="rect">
                <a:avLst/>
              </a:prstGeom>
            </p:spPr>
          </p:pic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BA56C314-E8A7-04CC-2EE3-9021478885F1}"/>
                  </a:ext>
                </a:extLst>
              </p:cNvPr>
              <p:cNvSpPr txBox="1"/>
              <p:nvPr/>
            </p:nvSpPr>
            <p:spPr>
              <a:xfrm>
                <a:off x="2726220" y="228312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537C382E-7ABA-E248-5B64-74859A68F1C7}"/>
                  </a:ext>
                </a:extLst>
              </p:cNvPr>
              <p:cNvSpPr txBox="1"/>
              <p:nvPr/>
            </p:nvSpPr>
            <p:spPr>
              <a:xfrm>
                <a:off x="2726220" y="284797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09" name="CasellaDiTesto 108">
                <a:extLst>
                  <a:ext uri="{FF2B5EF4-FFF2-40B4-BE49-F238E27FC236}">
                    <a16:creationId xmlns:a16="http://schemas.microsoft.com/office/drawing/2014/main" id="{31A75695-D901-1361-C68B-1A632673AAE1}"/>
                  </a:ext>
                </a:extLst>
              </p:cNvPr>
              <p:cNvSpPr txBox="1"/>
              <p:nvPr/>
            </p:nvSpPr>
            <p:spPr>
              <a:xfrm>
                <a:off x="2726220" y="171913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110" name="CasellaDiTesto 109">
                <a:extLst>
                  <a:ext uri="{FF2B5EF4-FFF2-40B4-BE49-F238E27FC236}">
                    <a16:creationId xmlns:a16="http://schemas.microsoft.com/office/drawing/2014/main" id="{F8DB50C9-52B2-23C1-A94E-5F65721C5463}"/>
                  </a:ext>
                </a:extLst>
              </p:cNvPr>
              <p:cNvSpPr txBox="1"/>
              <p:nvPr/>
            </p:nvSpPr>
            <p:spPr>
              <a:xfrm rot="16200000">
                <a:off x="2106374" y="2205682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ycD1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111" name="CasellaDiTesto 110">
                <a:extLst>
                  <a:ext uri="{FF2B5EF4-FFF2-40B4-BE49-F238E27FC236}">
                    <a16:creationId xmlns:a16="http://schemas.microsoft.com/office/drawing/2014/main" id="{CDB751DC-0CC1-8906-EEAF-994CAD12E196}"/>
                  </a:ext>
                </a:extLst>
              </p:cNvPr>
              <p:cNvSpPr txBox="1"/>
              <p:nvPr/>
            </p:nvSpPr>
            <p:spPr>
              <a:xfrm>
                <a:off x="3129044" y="297108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2" name="CasellaDiTesto 111">
                <a:extLst>
                  <a:ext uri="{FF2B5EF4-FFF2-40B4-BE49-F238E27FC236}">
                    <a16:creationId xmlns:a16="http://schemas.microsoft.com/office/drawing/2014/main" id="{060CF247-ACCB-BFDF-8A6C-CDF18CBE6FDC}"/>
                  </a:ext>
                </a:extLst>
              </p:cNvPr>
              <p:cNvSpPr txBox="1"/>
              <p:nvPr/>
            </p:nvSpPr>
            <p:spPr>
              <a:xfrm>
                <a:off x="3365966" y="297108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3" name="CasellaDiTesto 112">
                <a:extLst>
                  <a:ext uri="{FF2B5EF4-FFF2-40B4-BE49-F238E27FC236}">
                    <a16:creationId xmlns:a16="http://schemas.microsoft.com/office/drawing/2014/main" id="{686D74B6-8B56-5EF8-E780-8A2C12159343}"/>
                  </a:ext>
                </a:extLst>
              </p:cNvPr>
              <p:cNvSpPr txBox="1"/>
              <p:nvPr/>
            </p:nvSpPr>
            <p:spPr>
              <a:xfrm>
                <a:off x="3640832" y="2971082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14" name="CasellaDiTesto 113">
                <a:extLst>
                  <a:ext uri="{FF2B5EF4-FFF2-40B4-BE49-F238E27FC236}">
                    <a16:creationId xmlns:a16="http://schemas.microsoft.com/office/drawing/2014/main" id="{683E01AE-FAD3-BEFA-977B-92CA29D7FFF4}"/>
                  </a:ext>
                </a:extLst>
              </p:cNvPr>
              <p:cNvSpPr txBox="1"/>
              <p:nvPr/>
            </p:nvSpPr>
            <p:spPr>
              <a:xfrm>
                <a:off x="4113630" y="2971081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115" name="CasellaDiTesto 114">
                <a:extLst>
                  <a:ext uri="{FF2B5EF4-FFF2-40B4-BE49-F238E27FC236}">
                    <a16:creationId xmlns:a16="http://schemas.microsoft.com/office/drawing/2014/main" id="{D999C74F-D072-1E09-498B-01E6FD812737}"/>
                  </a:ext>
                </a:extLst>
              </p:cNvPr>
              <p:cNvSpPr txBox="1"/>
              <p:nvPr/>
            </p:nvSpPr>
            <p:spPr>
              <a:xfrm>
                <a:off x="3896806" y="2971082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6" name="CasellaDiTesto 115">
                <a:extLst>
                  <a:ext uri="{FF2B5EF4-FFF2-40B4-BE49-F238E27FC236}">
                    <a16:creationId xmlns:a16="http://schemas.microsoft.com/office/drawing/2014/main" id="{1704AA70-CAD2-C614-CBFF-CEEABE592547}"/>
                  </a:ext>
                </a:extLst>
              </p:cNvPr>
              <p:cNvSpPr txBox="1"/>
              <p:nvPr/>
            </p:nvSpPr>
            <p:spPr>
              <a:xfrm>
                <a:off x="3581231" y="3144435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GART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7" name="Connettore diritto 116">
                <a:extLst>
                  <a:ext uri="{FF2B5EF4-FFF2-40B4-BE49-F238E27FC236}">
                    <a16:creationId xmlns:a16="http://schemas.microsoft.com/office/drawing/2014/main" id="{0A3181B9-E5EC-9AFC-6CB5-99C8F3EED6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54806" y="3174924"/>
                <a:ext cx="27200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5" name="CasellaDiTesto 204">
              <a:extLst>
                <a:ext uri="{FF2B5EF4-FFF2-40B4-BE49-F238E27FC236}">
                  <a16:creationId xmlns:a16="http://schemas.microsoft.com/office/drawing/2014/main" id="{DFA37A46-CD4B-AA9A-45DB-9F69209A776F}"/>
                </a:ext>
              </a:extLst>
            </p:cNvPr>
            <p:cNvSpPr txBox="1"/>
            <p:nvPr/>
          </p:nvSpPr>
          <p:spPr>
            <a:xfrm>
              <a:off x="2286817" y="7273994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06" name="CasellaDiTesto 205">
              <a:extLst>
                <a:ext uri="{FF2B5EF4-FFF2-40B4-BE49-F238E27FC236}">
                  <a16:creationId xmlns:a16="http://schemas.microsoft.com/office/drawing/2014/main" id="{7D8C0CB2-19CA-3DB4-C236-01B51255A6B1}"/>
                </a:ext>
              </a:extLst>
            </p:cNvPr>
            <p:cNvSpPr txBox="1"/>
            <p:nvPr/>
          </p:nvSpPr>
          <p:spPr>
            <a:xfrm>
              <a:off x="2794402" y="7747972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°</a:t>
              </a:r>
            </a:p>
          </p:txBody>
        </p:sp>
      </p:grpSp>
      <p:grpSp>
        <p:nvGrpSpPr>
          <p:cNvPr id="60" name="Gruppo 59">
            <a:extLst>
              <a:ext uri="{FF2B5EF4-FFF2-40B4-BE49-F238E27FC236}">
                <a16:creationId xmlns:a16="http://schemas.microsoft.com/office/drawing/2014/main" id="{A3663AEC-36ED-9ADF-13D1-5FC592EB7C80}"/>
              </a:ext>
            </a:extLst>
          </p:cNvPr>
          <p:cNvGrpSpPr/>
          <p:nvPr/>
        </p:nvGrpSpPr>
        <p:grpSpPr>
          <a:xfrm>
            <a:off x="3586434" y="7140708"/>
            <a:ext cx="2049576" cy="1751772"/>
            <a:chOff x="3586434" y="7140708"/>
            <a:chExt cx="2049576" cy="1751772"/>
          </a:xfrm>
        </p:grpSpPr>
        <p:grpSp>
          <p:nvGrpSpPr>
            <p:cNvPr id="118" name="Gruppo 117">
              <a:extLst>
                <a:ext uri="{FF2B5EF4-FFF2-40B4-BE49-F238E27FC236}">
                  <a16:creationId xmlns:a16="http://schemas.microsoft.com/office/drawing/2014/main" id="{4B3D6DFD-CA45-9FDE-7A21-394691492E2B}"/>
                </a:ext>
              </a:extLst>
            </p:cNvPr>
            <p:cNvGrpSpPr/>
            <p:nvPr/>
          </p:nvGrpSpPr>
          <p:grpSpPr>
            <a:xfrm>
              <a:off x="3586434" y="7220957"/>
              <a:ext cx="2049576" cy="1671523"/>
              <a:chOff x="2404212" y="1793009"/>
              <a:chExt cx="2049576" cy="1671523"/>
            </a:xfrm>
          </p:grpSpPr>
          <p:pic>
            <p:nvPicPr>
              <p:cNvPr id="119" name="Immagine 118">
                <a:extLst>
                  <a:ext uri="{FF2B5EF4-FFF2-40B4-BE49-F238E27FC236}">
                    <a16:creationId xmlns:a16="http://schemas.microsoft.com/office/drawing/2014/main" id="{C620FAED-CED2-724D-CAC4-AC7C7D9002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008102" y="1866715"/>
                <a:ext cx="1187303" cy="1249200"/>
              </a:xfrm>
              <a:prstGeom prst="rect">
                <a:avLst/>
              </a:prstGeom>
            </p:spPr>
          </p:pic>
          <p:sp>
            <p:nvSpPr>
              <p:cNvPr id="120" name="CasellaDiTesto 119">
                <a:extLst>
                  <a:ext uri="{FF2B5EF4-FFF2-40B4-BE49-F238E27FC236}">
                    <a16:creationId xmlns:a16="http://schemas.microsoft.com/office/drawing/2014/main" id="{75055406-16C4-B524-4FF2-FF7CBD4B350B}"/>
                  </a:ext>
                </a:extLst>
              </p:cNvPr>
              <p:cNvSpPr txBox="1"/>
              <p:nvPr/>
            </p:nvSpPr>
            <p:spPr>
              <a:xfrm>
                <a:off x="2726220" y="235699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21" name="CasellaDiTesto 120">
                <a:extLst>
                  <a:ext uri="{FF2B5EF4-FFF2-40B4-BE49-F238E27FC236}">
                    <a16:creationId xmlns:a16="http://schemas.microsoft.com/office/drawing/2014/main" id="{1AD12CD3-13B8-D053-3D9F-803107E1E7DB}"/>
                  </a:ext>
                </a:extLst>
              </p:cNvPr>
              <p:cNvSpPr txBox="1"/>
              <p:nvPr/>
            </p:nvSpPr>
            <p:spPr>
              <a:xfrm>
                <a:off x="2726220" y="292184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22" name="CasellaDiTesto 121">
                <a:extLst>
                  <a:ext uri="{FF2B5EF4-FFF2-40B4-BE49-F238E27FC236}">
                    <a16:creationId xmlns:a16="http://schemas.microsoft.com/office/drawing/2014/main" id="{BEF54C95-385E-E50D-0B36-01EF0EB9E448}"/>
                  </a:ext>
                </a:extLst>
              </p:cNvPr>
              <p:cNvSpPr txBox="1"/>
              <p:nvPr/>
            </p:nvSpPr>
            <p:spPr>
              <a:xfrm>
                <a:off x="2726220" y="179300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123" name="CasellaDiTesto 122">
                <a:extLst>
                  <a:ext uri="{FF2B5EF4-FFF2-40B4-BE49-F238E27FC236}">
                    <a16:creationId xmlns:a16="http://schemas.microsoft.com/office/drawing/2014/main" id="{878927EE-633B-99C1-86C0-293C1468EB89}"/>
                  </a:ext>
                </a:extLst>
              </p:cNvPr>
              <p:cNvSpPr txBox="1"/>
              <p:nvPr/>
            </p:nvSpPr>
            <p:spPr>
              <a:xfrm rot="16200000">
                <a:off x="2106374" y="2279558"/>
                <a:ext cx="99578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cl-2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on CTR)</a:t>
                </a:r>
              </a:p>
            </p:txBody>
          </p: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63E1B62E-AE1C-34F8-1AAB-E743F59E6403}"/>
                  </a:ext>
                </a:extLst>
              </p:cNvPr>
              <p:cNvSpPr txBox="1"/>
              <p:nvPr/>
            </p:nvSpPr>
            <p:spPr>
              <a:xfrm>
                <a:off x="3129044" y="3044958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5" name="CasellaDiTesto 124">
                <a:extLst>
                  <a:ext uri="{FF2B5EF4-FFF2-40B4-BE49-F238E27FC236}">
                    <a16:creationId xmlns:a16="http://schemas.microsoft.com/office/drawing/2014/main" id="{05119358-5D5D-A315-3570-6B1D8BDAE798}"/>
                  </a:ext>
                </a:extLst>
              </p:cNvPr>
              <p:cNvSpPr txBox="1"/>
              <p:nvPr/>
            </p:nvSpPr>
            <p:spPr>
              <a:xfrm>
                <a:off x="3365966" y="3044958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6" name="CasellaDiTesto 125">
                <a:extLst>
                  <a:ext uri="{FF2B5EF4-FFF2-40B4-BE49-F238E27FC236}">
                    <a16:creationId xmlns:a16="http://schemas.microsoft.com/office/drawing/2014/main" id="{327682BD-00C9-E1D7-4195-6BB2C7873DBA}"/>
                  </a:ext>
                </a:extLst>
              </p:cNvPr>
              <p:cNvSpPr txBox="1"/>
              <p:nvPr/>
            </p:nvSpPr>
            <p:spPr>
              <a:xfrm>
                <a:off x="3640832" y="3044958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7" name="CasellaDiTesto 126">
                <a:extLst>
                  <a:ext uri="{FF2B5EF4-FFF2-40B4-BE49-F238E27FC236}">
                    <a16:creationId xmlns:a16="http://schemas.microsoft.com/office/drawing/2014/main" id="{96002670-22C1-9689-91EC-0F0E37D10A7C}"/>
                  </a:ext>
                </a:extLst>
              </p:cNvPr>
              <p:cNvSpPr txBox="1"/>
              <p:nvPr/>
            </p:nvSpPr>
            <p:spPr>
              <a:xfrm>
                <a:off x="4113630" y="3044957"/>
                <a:ext cx="3401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  <p:sp>
            <p:nvSpPr>
              <p:cNvPr id="128" name="CasellaDiTesto 127">
                <a:extLst>
                  <a:ext uri="{FF2B5EF4-FFF2-40B4-BE49-F238E27FC236}">
                    <a16:creationId xmlns:a16="http://schemas.microsoft.com/office/drawing/2014/main" id="{73EB6F54-DAB9-5A3E-8831-533E2E64691A}"/>
                  </a:ext>
                </a:extLst>
              </p:cNvPr>
              <p:cNvSpPr txBox="1"/>
              <p:nvPr/>
            </p:nvSpPr>
            <p:spPr>
              <a:xfrm>
                <a:off x="3896806" y="3044958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29" name="CasellaDiTesto 128">
                <a:extLst>
                  <a:ext uri="{FF2B5EF4-FFF2-40B4-BE49-F238E27FC236}">
                    <a16:creationId xmlns:a16="http://schemas.microsoft.com/office/drawing/2014/main" id="{2D48DA50-0994-7F40-B0AC-0435BCA00EE4}"/>
                  </a:ext>
                </a:extLst>
              </p:cNvPr>
              <p:cNvSpPr txBox="1"/>
              <p:nvPr/>
            </p:nvSpPr>
            <p:spPr>
              <a:xfrm>
                <a:off x="3581231" y="3218311"/>
                <a:ext cx="6335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GART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0" name="Connettore diritto 129">
                <a:extLst>
                  <a:ext uri="{FF2B5EF4-FFF2-40B4-BE49-F238E27FC236}">
                    <a16:creationId xmlns:a16="http://schemas.microsoft.com/office/drawing/2014/main" id="{4B9BDBF4-AC37-0B79-E790-0B88A95FCF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54806" y="3248800"/>
                <a:ext cx="27200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9F89EC4B-80B7-8270-58D7-3AAD915EC7EE}"/>
                </a:ext>
              </a:extLst>
            </p:cNvPr>
            <p:cNvSpPr txBox="1"/>
            <p:nvPr/>
          </p:nvSpPr>
          <p:spPr>
            <a:xfrm>
              <a:off x="4560159" y="714070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B1741483-E9FA-E30E-81D4-E927C96EB51C}"/>
                </a:ext>
              </a:extLst>
            </p:cNvPr>
            <p:cNvSpPr txBox="1"/>
            <p:nvPr/>
          </p:nvSpPr>
          <p:spPr>
            <a:xfrm>
              <a:off x="5075904" y="7321000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°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720894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1F886CC-E53A-736B-D7C2-F2157BF3B2DB}"/>
              </a:ext>
            </a:extLst>
          </p:cNvPr>
          <p:cNvSpPr txBox="1"/>
          <p:nvPr/>
        </p:nvSpPr>
        <p:spPr>
          <a:xfrm>
            <a:off x="1990145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4 </a:t>
            </a:r>
            <a:endParaRPr lang="en-US" b="1" dirty="0"/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300E67E3-4048-6D96-6E04-B01263B10967}"/>
              </a:ext>
            </a:extLst>
          </p:cNvPr>
          <p:cNvSpPr txBox="1"/>
          <p:nvPr/>
        </p:nvSpPr>
        <p:spPr>
          <a:xfrm>
            <a:off x="2060848" y="3955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67D59B7B-6FA0-8896-72E2-9F0F6BD7A30D}"/>
              </a:ext>
            </a:extLst>
          </p:cNvPr>
          <p:cNvSpPr txBox="1"/>
          <p:nvPr/>
        </p:nvSpPr>
        <p:spPr>
          <a:xfrm>
            <a:off x="44624" y="3955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AD34CF2B-1851-1BF0-5191-432DB0B2EE23}"/>
              </a:ext>
            </a:extLst>
          </p:cNvPr>
          <p:cNvSpPr txBox="1"/>
          <p:nvPr/>
        </p:nvSpPr>
        <p:spPr>
          <a:xfrm>
            <a:off x="4573886" y="3955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C</a:t>
            </a:r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0B7BF35D-AA37-165E-5DA7-71E8777949B1}"/>
              </a:ext>
            </a:extLst>
          </p:cNvPr>
          <p:cNvGrpSpPr/>
          <p:nvPr/>
        </p:nvGrpSpPr>
        <p:grpSpPr>
          <a:xfrm>
            <a:off x="2277105" y="782147"/>
            <a:ext cx="2248747" cy="1845637"/>
            <a:chOff x="2277105" y="782147"/>
            <a:chExt cx="2248747" cy="1845637"/>
          </a:xfrm>
        </p:grpSpPr>
        <p:grpSp>
          <p:nvGrpSpPr>
            <p:cNvPr id="87" name="Gruppo 86">
              <a:extLst>
                <a:ext uri="{FF2B5EF4-FFF2-40B4-BE49-F238E27FC236}">
                  <a16:creationId xmlns:a16="http://schemas.microsoft.com/office/drawing/2014/main" id="{D4480864-814A-7645-4111-9E458478A7B3}"/>
                </a:ext>
              </a:extLst>
            </p:cNvPr>
            <p:cNvGrpSpPr/>
            <p:nvPr/>
          </p:nvGrpSpPr>
          <p:grpSpPr>
            <a:xfrm>
              <a:off x="2277105" y="782147"/>
              <a:ext cx="2248747" cy="1845637"/>
              <a:chOff x="3506050" y="525730"/>
              <a:chExt cx="2248747" cy="1845637"/>
            </a:xfrm>
          </p:grpSpPr>
          <p:pic>
            <p:nvPicPr>
              <p:cNvPr id="86" name="Immagine 85">
                <a:extLst>
                  <a:ext uri="{FF2B5EF4-FFF2-40B4-BE49-F238E27FC236}">
                    <a16:creationId xmlns:a16="http://schemas.microsoft.com/office/drawing/2014/main" id="{ECC37A71-AD73-5846-0A5F-5D97F3C86D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103590" y="624836"/>
                <a:ext cx="1225473" cy="1231200"/>
              </a:xfrm>
              <a:prstGeom prst="rect">
                <a:avLst/>
              </a:prstGeom>
            </p:spPr>
          </p:pic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id="{29A6AAFE-A21F-797F-9EE6-3517864DA7A7}"/>
                  </a:ext>
                </a:extLst>
              </p:cNvPr>
              <p:cNvSpPr txBox="1"/>
              <p:nvPr/>
            </p:nvSpPr>
            <p:spPr>
              <a:xfrm>
                <a:off x="3828058" y="108972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1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0</a:t>
                </a:r>
              </a:p>
            </p:txBody>
          </p:sp>
          <p:sp>
            <p:nvSpPr>
              <p:cNvPr id="65" name="CasellaDiTesto 64">
                <a:extLst>
                  <a:ext uri="{FF2B5EF4-FFF2-40B4-BE49-F238E27FC236}">
                    <a16:creationId xmlns:a16="http://schemas.microsoft.com/office/drawing/2014/main" id="{509CA473-DC95-E6A8-A83E-6241A38CB5DF}"/>
                  </a:ext>
                </a:extLst>
              </p:cNvPr>
              <p:cNvSpPr txBox="1"/>
              <p:nvPr/>
            </p:nvSpPr>
            <p:spPr>
              <a:xfrm>
                <a:off x="3828058" y="165456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id="{4350B398-2EFE-C855-B364-EECD72494988}"/>
                  </a:ext>
                </a:extLst>
              </p:cNvPr>
              <p:cNvSpPr txBox="1"/>
              <p:nvPr/>
            </p:nvSpPr>
            <p:spPr>
              <a:xfrm>
                <a:off x="3828058" y="52573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2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0</a:t>
                </a:r>
              </a:p>
            </p:txBody>
          </p:sp>
          <p:sp>
            <p:nvSpPr>
              <p:cNvPr id="67" name="CasellaDiTesto 66">
                <a:extLst>
                  <a:ext uri="{FF2B5EF4-FFF2-40B4-BE49-F238E27FC236}">
                    <a16:creationId xmlns:a16="http://schemas.microsoft.com/office/drawing/2014/main" id="{9AC80309-2BDB-889E-DDA3-59A40F5A46E2}"/>
                  </a:ext>
                </a:extLst>
              </p:cNvPr>
              <p:cNvSpPr txBox="1"/>
              <p:nvPr/>
            </p:nvSpPr>
            <p:spPr>
              <a:xfrm rot="16200000">
                <a:off x="3164930" y="1012279"/>
                <a:ext cx="108234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tD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rbitrary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ts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id="{069E4A68-467D-D814-633A-12709DB2DAB2}"/>
                  </a:ext>
                </a:extLst>
              </p:cNvPr>
              <p:cNvSpPr txBox="1"/>
              <p:nvPr/>
            </p:nvSpPr>
            <p:spPr>
              <a:xfrm>
                <a:off x="4168595" y="177767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9" name="CasellaDiTesto 68">
                <a:extLst>
                  <a:ext uri="{FF2B5EF4-FFF2-40B4-BE49-F238E27FC236}">
                    <a16:creationId xmlns:a16="http://schemas.microsoft.com/office/drawing/2014/main" id="{DEA65DEC-4807-5A21-1A09-BAD95298E22F}"/>
                  </a:ext>
                </a:extLst>
              </p:cNvPr>
              <p:cNvSpPr txBox="1"/>
              <p:nvPr/>
            </p:nvSpPr>
            <p:spPr>
              <a:xfrm>
                <a:off x="4335684" y="177767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id="{D7002510-B816-948A-E99D-00B424AA0726}"/>
                  </a:ext>
                </a:extLst>
              </p:cNvPr>
              <p:cNvSpPr txBox="1"/>
              <p:nvPr/>
            </p:nvSpPr>
            <p:spPr>
              <a:xfrm>
                <a:off x="4531630" y="1777679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1" name="CasellaDiTesto 70">
                <a:extLst>
                  <a:ext uri="{FF2B5EF4-FFF2-40B4-BE49-F238E27FC236}">
                    <a16:creationId xmlns:a16="http://schemas.microsoft.com/office/drawing/2014/main" id="{3E94036E-8F90-C08D-22A7-9236E61316BD}"/>
                  </a:ext>
                </a:extLst>
              </p:cNvPr>
              <p:cNvSpPr txBox="1"/>
              <p:nvPr/>
            </p:nvSpPr>
            <p:spPr>
              <a:xfrm>
                <a:off x="4693525" y="177767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EB481914-F176-4822-3FA7-ADDDE397F120}"/>
                  </a:ext>
                </a:extLst>
              </p:cNvPr>
              <p:cNvSpPr txBox="1"/>
              <p:nvPr/>
            </p:nvSpPr>
            <p:spPr>
              <a:xfrm>
                <a:off x="4883682" y="1777679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1B7C7A36-21D4-2515-FE7C-1EAFA78C0373}"/>
                  </a:ext>
                </a:extLst>
              </p:cNvPr>
              <p:cNvSpPr txBox="1"/>
              <p:nvPr/>
            </p:nvSpPr>
            <p:spPr>
              <a:xfrm>
                <a:off x="5049444" y="1777679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74" name="Connettore diritto 73">
                <a:extLst>
                  <a:ext uri="{FF2B5EF4-FFF2-40B4-BE49-F238E27FC236}">
                    <a16:creationId xmlns:a16="http://schemas.microsoft.com/office/drawing/2014/main" id="{CFB6C4C9-96C3-5E1B-F83E-EDC0F4184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45604" y="2164993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ttore diritto 74">
                <a:extLst>
                  <a:ext uri="{FF2B5EF4-FFF2-40B4-BE49-F238E27FC236}">
                    <a16:creationId xmlns:a16="http://schemas.microsoft.com/office/drawing/2014/main" id="{924A5436-BDDB-381E-7A21-137C3ADC57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7656" y="2164993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CasellaDiTesto 75">
                <a:extLst>
                  <a:ext uri="{FF2B5EF4-FFF2-40B4-BE49-F238E27FC236}">
                    <a16:creationId xmlns:a16="http://schemas.microsoft.com/office/drawing/2014/main" id="{5757F812-EAC2-F276-89FC-16DB156AE8CD}"/>
                  </a:ext>
                </a:extLst>
              </p:cNvPr>
              <p:cNvSpPr txBox="1"/>
              <p:nvPr/>
            </p:nvSpPr>
            <p:spPr>
              <a:xfrm>
                <a:off x="4556858" y="2125146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E5E05B83-6AE0-9C7E-33ED-336CF4133D4D}"/>
                  </a:ext>
                </a:extLst>
              </p:cNvPr>
              <p:cNvSpPr txBox="1"/>
              <p:nvPr/>
            </p:nvSpPr>
            <p:spPr>
              <a:xfrm>
                <a:off x="4873084" y="2125146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02AE9BC2-4C72-3756-3A58-A893D82D575F}"/>
                  </a:ext>
                </a:extLst>
              </p:cNvPr>
              <p:cNvSpPr txBox="1"/>
              <p:nvPr/>
            </p:nvSpPr>
            <p:spPr>
              <a:xfrm>
                <a:off x="4165745" y="1935693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9" name="CasellaDiTesto 78">
                <a:extLst>
                  <a:ext uri="{FF2B5EF4-FFF2-40B4-BE49-F238E27FC236}">
                    <a16:creationId xmlns:a16="http://schemas.microsoft.com/office/drawing/2014/main" id="{9EBE6A0B-060C-F173-36F6-CC188AF1D3E7}"/>
                  </a:ext>
                </a:extLst>
              </p:cNvPr>
              <p:cNvSpPr txBox="1"/>
              <p:nvPr/>
            </p:nvSpPr>
            <p:spPr>
              <a:xfrm>
                <a:off x="4514162" y="1935693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80" name="CasellaDiTesto 79">
                <a:extLst>
                  <a:ext uri="{FF2B5EF4-FFF2-40B4-BE49-F238E27FC236}">
                    <a16:creationId xmlns:a16="http://schemas.microsoft.com/office/drawing/2014/main" id="{63E0A054-B360-7855-1832-AA750276044D}"/>
                  </a:ext>
                </a:extLst>
              </p:cNvPr>
              <p:cNvSpPr txBox="1"/>
              <p:nvPr/>
            </p:nvSpPr>
            <p:spPr>
              <a:xfrm>
                <a:off x="4874202" y="1935693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691CB5C1-D571-2A29-A398-52952F4C1B3A}"/>
                  </a:ext>
                </a:extLst>
              </p:cNvPr>
              <p:cNvSpPr txBox="1"/>
              <p:nvPr/>
            </p:nvSpPr>
            <p:spPr>
              <a:xfrm>
                <a:off x="4351475" y="1935693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77D25592-E415-7C81-E4C4-56A82466E497}"/>
                  </a:ext>
                </a:extLst>
              </p:cNvPr>
              <p:cNvSpPr txBox="1"/>
              <p:nvPr/>
            </p:nvSpPr>
            <p:spPr>
              <a:xfrm>
                <a:off x="5067366" y="1935693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3" name="CasellaDiTesto 82">
                <a:extLst>
                  <a:ext uri="{FF2B5EF4-FFF2-40B4-BE49-F238E27FC236}">
                    <a16:creationId xmlns:a16="http://schemas.microsoft.com/office/drawing/2014/main" id="{28B058C7-4D5A-D701-AAC0-CE520B2E2748}"/>
                  </a:ext>
                </a:extLst>
              </p:cNvPr>
              <p:cNvSpPr txBox="1"/>
              <p:nvPr/>
            </p:nvSpPr>
            <p:spPr>
              <a:xfrm>
                <a:off x="4707326" y="1935693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4" name="CasellaDiTesto 83">
                <a:extLst>
                  <a:ext uri="{FF2B5EF4-FFF2-40B4-BE49-F238E27FC236}">
                    <a16:creationId xmlns:a16="http://schemas.microsoft.com/office/drawing/2014/main" id="{2BE0D3EE-A038-07E0-9164-5474CA168173}"/>
                  </a:ext>
                </a:extLst>
              </p:cNvPr>
              <p:cNvSpPr txBox="1"/>
              <p:nvPr/>
            </p:nvSpPr>
            <p:spPr>
              <a:xfrm>
                <a:off x="5177395" y="1759927"/>
                <a:ext cx="5661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537S</a:t>
                </a:r>
              </a:p>
            </p:txBody>
          </p:sp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38260449-721A-9378-6CF8-F0C719FF185D}"/>
                  </a:ext>
                </a:extLst>
              </p:cNvPr>
              <p:cNvSpPr txBox="1"/>
              <p:nvPr/>
            </p:nvSpPr>
            <p:spPr>
              <a:xfrm>
                <a:off x="5177395" y="1935693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CF-7</a:t>
                </a:r>
              </a:p>
            </p:txBody>
          </p:sp>
        </p:grpSp>
        <p:sp>
          <p:nvSpPr>
            <p:cNvPr id="90" name="CasellaDiTesto 89">
              <a:extLst>
                <a:ext uri="{FF2B5EF4-FFF2-40B4-BE49-F238E27FC236}">
                  <a16:creationId xmlns:a16="http://schemas.microsoft.com/office/drawing/2014/main" id="{6BE94AC7-A9A7-8983-612C-FEF12D74567D}"/>
                </a:ext>
              </a:extLst>
            </p:cNvPr>
            <p:cNvSpPr txBox="1"/>
            <p:nvPr/>
          </p:nvSpPr>
          <p:spPr>
            <a:xfrm>
              <a:off x="3827712" y="96214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0141B8B0-A9A6-2F9F-F65C-D2CC313F0C4E}"/>
                </a:ext>
              </a:extLst>
            </p:cNvPr>
            <p:cNvSpPr txBox="1"/>
            <p:nvPr/>
          </p:nvSpPr>
          <p:spPr>
            <a:xfrm>
              <a:off x="3422683" y="1228415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19" name="Gruppo 18">
            <a:extLst>
              <a:ext uri="{FF2B5EF4-FFF2-40B4-BE49-F238E27FC236}">
                <a16:creationId xmlns:a16="http://schemas.microsoft.com/office/drawing/2014/main" id="{2930A98E-13DC-7D02-8E07-13E11C186535}"/>
              </a:ext>
            </a:extLst>
          </p:cNvPr>
          <p:cNvGrpSpPr/>
          <p:nvPr/>
        </p:nvGrpSpPr>
        <p:grpSpPr>
          <a:xfrm>
            <a:off x="205471" y="782147"/>
            <a:ext cx="2248747" cy="1845637"/>
            <a:chOff x="205471" y="782147"/>
            <a:chExt cx="2248747" cy="1845637"/>
          </a:xfrm>
        </p:grpSpPr>
        <p:grpSp>
          <p:nvGrpSpPr>
            <p:cNvPr id="88" name="Gruppo 87">
              <a:extLst>
                <a:ext uri="{FF2B5EF4-FFF2-40B4-BE49-F238E27FC236}">
                  <a16:creationId xmlns:a16="http://schemas.microsoft.com/office/drawing/2014/main" id="{D99FA70C-CA50-CE1A-A566-9F39045CF8E2}"/>
                </a:ext>
              </a:extLst>
            </p:cNvPr>
            <p:cNvGrpSpPr/>
            <p:nvPr/>
          </p:nvGrpSpPr>
          <p:grpSpPr>
            <a:xfrm>
              <a:off x="205471" y="782147"/>
              <a:ext cx="2248747" cy="1845637"/>
              <a:chOff x="1268760" y="539552"/>
              <a:chExt cx="2248747" cy="1845637"/>
            </a:xfrm>
          </p:grpSpPr>
          <p:pic>
            <p:nvPicPr>
              <p:cNvPr id="62" name="Immagine 61">
                <a:extLst>
                  <a:ext uri="{FF2B5EF4-FFF2-40B4-BE49-F238E27FC236}">
                    <a16:creationId xmlns:a16="http://schemas.microsoft.com/office/drawing/2014/main" id="{973D4BB9-A2CD-0E53-9F72-26A9E5FF06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66300" y="638658"/>
                <a:ext cx="1225526" cy="1231200"/>
              </a:xfrm>
              <a:prstGeom prst="rect">
                <a:avLst/>
              </a:prstGeom>
            </p:spPr>
          </p:pic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32DCF4AE-BDF5-1551-2B77-F442B9B35A87}"/>
                  </a:ext>
                </a:extLst>
              </p:cNvPr>
              <p:cNvSpPr txBox="1"/>
              <p:nvPr/>
            </p:nvSpPr>
            <p:spPr>
              <a:xfrm>
                <a:off x="1590768" y="110354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1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0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016EF145-4AE7-89C1-17AF-A3201AD5D856}"/>
                  </a:ext>
                </a:extLst>
              </p:cNvPr>
              <p:cNvSpPr txBox="1"/>
              <p:nvPr/>
            </p:nvSpPr>
            <p:spPr>
              <a:xfrm>
                <a:off x="1590768" y="166839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83A9A9DF-6B45-D984-0F8C-0B57E04A75DA}"/>
                  </a:ext>
                </a:extLst>
              </p:cNvPr>
              <p:cNvSpPr txBox="1"/>
              <p:nvPr/>
            </p:nvSpPr>
            <p:spPr>
              <a:xfrm>
                <a:off x="1590768" y="53955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2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0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5D417451-FEB0-7EE6-057E-7D63BED1DB82}"/>
                  </a:ext>
                </a:extLst>
              </p:cNvPr>
              <p:cNvSpPr txBox="1"/>
              <p:nvPr/>
            </p:nvSpPr>
            <p:spPr>
              <a:xfrm rot="16200000">
                <a:off x="927640" y="1026101"/>
                <a:ext cx="108234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S2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rbitrary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ts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C13E590F-398A-5707-36F0-4DF4A0B035CD}"/>
                  </a:ext>
                </a:extLst>
              </p:cNvPr>
              <p:cNvSpPr txBox="1"/>
              <p:nvPr/>
            </p:nvSpPr>
            <p:spPr>
              <a:xfrm>
                <a:off x="1931305" y="1791501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4FAD96CE-F873-A000-F717-13AF84F8D8AC}"/>
                  </a:ext>
                </a:extLst>
              </p:cNvPr>
              <p:cNvSpPr txBox="1"/>
              <p:nvPr/>
            </p:nvSpPr>
            <p:spPr>
              <a:xfrm>
                <a:off x="2098394" y="1791501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855F4F18-A4EA-F8AC-5978-9E99758854F4}"/>
                  </a:ext>
                </a:extLst>
              </p:cNvPr>
              <p:cNvSpPr txBox="1"/>
              <p:nvPr/>
            </p:nvSpPr>
            <p:spPr>
              <a:xfrm>
                <a:off x="2294340" y="1791501"/>
                <a:ext cx="227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3231B69F-C68B-9D86-D4DB-E4EFCAE698D2}"/>
                  </a:ext>
                </a:extLst>
              </p:cNvPr>
              <p:cNvSpPr txBox="1"/>
              <p:nvPr/>
            </p:nvSpPr>
            <p:spPr>
              <a:xfrm>
                <a:off x="2456235" y="1791501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239C68C3-CB17-FF63-E0EA-5811AC86480A}"/>
                  </a:ext>
                </a:extLst>
              </p:cNvPr>
              <p:cNvSpPr txBox="1"/>
              <p:nvPr/>
            </p:nvSpPr>
            <p:spPr>
              <a:xfrm>
                <a:off x="2646392" y="1791501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4F27DBE9-16C5-A86F-E448-B820EB1564A0}"/>
                  </a:ext>
                </a:extLst>
              </p:cNvPr>
              <p:cNvSpPr txBox="1"/>
              <p:nvPr/>
            </p:nvSpPr>
            <p:spPr>
              <a:xfrm>
                <a:off x="2812154" y="1791501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31" name="Connettore diritto 30">
                <a:extLst>
                  <a:ext uri="{FF2B5EF4-FFF2-40B4-BE49-F238E27FC236}">
                    <a16:creationId xmlns:a16="http://schemas.microsoft.com/office/drawing/2014/main" id="{21C274DF-A3C1-6301-EE5F-0914AAABA2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8314" y="2178815"/>
                <a:ext cx="17792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Connettore diritto 31">
                <a:extLst>
                  <a:ext uri="{FF2B5EF4-FFF2-40B4-BE49-F238E27FC236}">
                    <a16:creationId xmlns:a16="http://schemas.microsoft.com/office/drawing/2014/main" id="{048D4001-6B81-C897-080B-BD10F1EF22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60366" y="2178815"/>
                <a:ext cx="18179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1FCCD2E6-984F-DE76-82B8-86EDCEBA61AD}"/>
                  </a:ext>
                </a:extLst>
              </p:cNvPr>
              <p:cNvSpPr txBox="1"/>
              <p:nvPr/>
            </p:nvSpPr>
            <p:spPr>
              <a:xfrm>
                <a:off x="2319568" y="2138968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CI</a:t>
                </a:r>
              </a:p>
            </p:txBody>
          </p: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862B674D-9DE0-9999-C062-ED603EEF6898}"/>
                  </a:ext>
                </a:extLst>
              </p:cNvPr>
              <p:cNvSpPr txBox="1"/>
              <p:nvPr/>
            </p:nvSpPr>
            <p:spPr>
              <a:xfrm>
                <a:off x="2635794" y="2138968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MX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E7ADE498-6500-1B6E-D71E-872D4D7ADAF6}"/>
                  </a:ext>
                </a:extLst>
              </p:cNvPr>
              <p:cNvSpPr txBox="1"/>
              <p:nvPr/>
            </p:nvSpPr>
            <p:spPr>
              <a:xfrm>
                <a:off x="1928455" y="194951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58FE380E-151A-1EA8-D187-F1496FB210CD}"/>
                  </a:ext>
                </a:extLst>
              </p:cNvPr>
              <p:cNvSpPr txBox="1"/>
              <p:nvPr/>
            </p:nvSpPr>
            <p:spPr>
              <a:xfrm>
                <a:off x="2276872" y="194951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A83FFA8C-4E07-199F-0CFD-3C21A0F27DAB}"/>
                  </a:ext>
                </a:extLst>
              </p:cNvPr>
              <p:cNvSpPr txBox="1"/>
              <p:nvPr/>
            </p:nvSpPr>
            <p:spPr>
              <a:xfrm>
                <a:off x="2636912" y="1949515"/>
                <a:ext cx="2600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id="{C06EEE40-D691-6E3D-45B1-23D59D283F17}"/>
                  </a:ext>
                </a:extLst>
              </p:cNvPr>
              <p:cNvSpPr txBox="1"/>
              <p:nvPr/>
            </p:nvSpPr>
            <p:spPr>
              <a:xfrm>
                <a:off x="2114185" y="1949515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id="{DBFDA900-813F-E535-ACD9-AC777A89ED1E}"/>
                  </a:ext>
                </a:extLst>
              </p:cNvPr>
              <p:cNvSpPr txBox="1"/>
              <p:nvPr/>
            </p:nvSpPr>
            <p:spPr>
              <a:xfrm>
                <a:off x="2830076" y="1949515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59" name="CasellaDiTesto 58">
                <a:extLst>
                  <a:ext uri="{FF2B5EF4-FFF2-40B4-BE49-F238E27FC236}">
                    <a16:creationId xmlns:a16="http://schemas.microsoft.com/office/drawing/2014/main" id="{00424509-4B7C-6E60-DADF-178CAB3013A1}"/>
                  </a:ext>
                </a:extLst>
              </p:cNvPr>
              <p:cNvSpPr txBox="1"/>
              <p:nvPr/>
            </p:nvSpPr>
            <p:spPr>
              <a:xfrm>
                <a:off x="2470036" y="1949515"/>
                <a:ext cx="2279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0" name="CasellaDiTesto 59">
                <a:extLst>
                  <a:ext uri="{FF2B5EF4-FFF2-40B4-BE49-F238E27FC236}">
                    <a16:creationId xmlns:a16="http://schemas.microsoft.com/office/drawing/2014/main" id="{2D27656C-7486-031D-527E-27654BB678C6}"/>
                  </a:ext>
                </a:extLst>
              </p:cNvPr>
              <p:cNvSpPr txBox="1"/>
              <p:nvPr/>
            </p:nvSpPr>
            <p:spPr>
              <a:xfrm>
                <a:off x="2940105" y="1773749"/>
                <a:ext cx="5661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537S</a:t>
                </a:r>
              </a:p>
            </p:txBody>
          </p: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id="{BDBA115D-BB05-0E91-7867-421FADD43CF5}"/>
                  </a:ext>
                </a:extLst>
              </p:cNvPr>
              <p:cNvSpPr txBox="1"/>
              <p:nvPr/>
            </p:nvSpPr>
            <p:spPr>
              <a:xfrm>
                <a:off x="2940105" y="1949515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CF-7</a:t>
                </a:r>
              </a:p>
            </p:txBody>
          </p:sp>
        </p:grp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B6EB8A48-F3AC-FA4B-D59F-12D84062DD91}"/>
                </a:ext>
              </a:extLst>
            </p:cNvPr>
            <p:cNvSpPr txBox="1"/>
            <p:nvPr/>
          </p:nvSpPr>
          <p:spPr>
            <a:xfrm>
              <a:off x="1378695" y="128808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/>
                <a:t>*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C584A86E-3836-554D-F77C-FF5A2C7948BC}"/>
                </a:ext>
              </a:extLst>
            </p:cNvPr>
            <p:cNvSpPr txBox="1"/>
            <p:nvPr/>
          </p:nvSpPr>
          <p:spPr>
            <a:xfrm>
              <a:off x="1744485" y="946616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29" name="Gruppo 28">
            <a:extLst>
              <a:ext uri="{FF2B5EF4-FFF2-40B4-BE49-F238E27FC236}">
                <a16:creationId xmlns:a16="http://schemas.microsoft.com/office/drawing/2014/main" id="{82738BE6-ECB0-DBD7-8274-42721FE7BC38}"/>
              </a:ext>
            </a:extLst>
          </p:cNvPr>
          <p:cNvGrpSpPr/>
          <p:nvPr/>
        </p:nvGrpSpPr>
        <p:grpSpPr>
          <a:xfrm>
            <a:off x="4580396" y="567301"/>
            <a:ext cx="1804697" cy="1843984"/>
            <a:chOff x="4580396" y="567301"/>
            <a:chExt cx="1804697" cy="1843984"/>
          </a:xfrm>
        </p:grpSpPr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BCF04638-70EA-53EB-21D5-FF8C3F52D432}"/>
                </a:ext>
              </a:extLst>
            </p:cNvPr>
            <p:cNvGrpSpPr/>
            <p:nvPr/>
          </p:nvGrpSpPr>
          <p:grpSpPr>
            <a:xfrm>
              <a:off x="4580396" y="567301"/>
              <a:ext cx="1804697" cy="1843984"/>
              <a:chOff x="2484110" y="3282619"/>
              <a:chExt cx="1804697" cy="1843984"/>
            </a:xfrm>
          </p:grpSpPr>
          <p:grpSp>
            <p:nvGrpSpPr>
              <p:cNvPr id="3" name="Gruppo 2">
                <a:extLst>
                  <a:ext uri="{FF2B5EF4-FFF2-40B4-BE49-F238E27FC236}">
                    <a16:creationId xmlns:a16="http://schemas.microsoft.com/office/drawing/2014/main" id="{43F2551F-F885-10A0-CA10-0FC9BF8D7E4C}"/>
                  </a:ext>
                </a:extLst>
              </p:cNvPr>
              <p:cNvGrpSpPr/>
              <p:nvPr/>
            </p:nvGrpSpPr>
            <p:grpSpPr>
              <a:xfrm>
                <a:off x="2484110" y="3488749"/>
                <a:ext cx="1804697" cy="1637854"/>
                <a:chOff x="8297426" y="1515306"/>
                <a:chExt cx="1804697" cy="1637854"/>
              </a:xfrm>
            </p:grpSpPr>
            <p:pic>
              <p:nvPicPr>
                <p:cNvPr id="5" name="Immagine 4">
                  <a:extLst>
                    <a:ext uri="{FF2B5EF4-FFF2-40B4-BE49-F238E27FC236}">
                      <a16:creationId xmlns:a16="http://schemas.microsoft.com/office/drawing/2014/main" id="{C70D1790-E63C-5DD6-89FF-A7E2D763AD8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894966" y="1614412"/>
                  <a:ext cx="1203090" cy="1231200"/>
                </a:xfrm>
                <a:prstGeom prst="rect">
                  <a:avLst/>
                </a:prstGeom>
              </p:spPr>
            </p:pic>
            <p:sp>
              <p:nvSpPr>
                <p:cNvPr id="6" name="CasellaDiTesto 5">
                  <a:extLst>
                    <a:ext uri="{FF2B5EF4-FFF2-40B4-BE49-F238E27FC236}">
                      <a16:creationId xmlns:a16="http://schemas.microsoft.com/office/drawing/2014/main" id="{5BD8663D-949B-7DA5-8118-E230827877BB}"/>
                    </a:ext>
                  </a:extLst>
                </p:cNvPr>
                <p:cNvSpPr txBox="1"/>
                <p:nvPr/>
              </p:nvSpPr>
              <p:spPr>
                <a:xfrm>
                  <a:off x="8619434" y="2079296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6</a:t>
                  </a:r>
                </a:p>
              </p:txBody>
            </p:sp>
            <p:sp>
              <p:nvSpPr>
                <p:cNvPr id="7" name="CasellaDiTesto 6">
                  <a:extLst>
                    <a:ext uri="{FF2B5EF4-FFF2-40B4-BE49-F238E27FC236}">
                      <a16:creationId xmlns:a16="http://schemas.microsoft.com/office/drawing/2014/main" id="{F96B4B39-D953-B746-191C-652250105C65}"/>
                    </a:ext>
                  </a:extLst>
                </p:cNvPr>
                <p:cNvSpPr txBox="1"/>
                <p:nvPr/>
              </p:nvSpPr>
              <p:spPr>
                <a:xfrm>
                  <a:off x="8619434" y="2644145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8" name="CasellaDiTesto 7">
                  <a:extLst>
                    <a:ext uri="{FF2B5EF4-FFF2-40B4-BE49-F238E27FC236}">
                      <a16:creationId xmlns:a16="http://schemas.microsoft.com/office/drawing/2014/main" id="{B82AFFF9-DA5B-544E-E18B-02FC37B25BA7}"/>
                    </a:ext>
                  </a:extLst>
                </p:cNvPr>
                <p:cNvSpPr txBox="1"/>
                <p:nvPr/>
              </p:nvSpPr>
              <p:spPr>
                <a:xfrm>
                  <a:off x="8619434" y="1515306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2</a:t>
                  </a:r>
                </a:p>
              </p:txBody>
            </p:sp>
            <p:sp>
              <p:nvSpPr>
                <p:cNvPr id="9" name="CasellaDiTesto 8">
                  <a:extLst>
                    <a:ext uri="{FF2B5EF4-FFF2-40B4-BE49-F238E27FC236}">
                      <a16:creationId xmlns:a16="http://schemas.microsoft.com/office/drawing/2014/main" id="{37CBC5B9-71B4-2B0A-D85B-8EA760D2AF69}"/>
                    </a:ext>
                  </a:extLst>
                </p:cNvPr>
                <p:cNvSpPr txBox="1"/>
                <p:nvPr/>
              </p:nvSpPr>
              <p:spPr>
                <a:xfrm rot="16200000">
                  <a:off x="7999588" y="2001855"/>
                  <a:ext cx="99578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</a:t>
                  </a:r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Levels</a:t>
                  </a:r>
                  <a:endParaRPr lang="it-IT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old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n CTR)</a:t>
                  </a:r>
                </a:p>
              </p:txBody>
            </p:sp>
            <p:sp>
              <p:nvSpPr>
                <p:cNvPr id="10" name="CasellaDiTesto 9">
                  <a:extLst>
                    <a:ext uri="{FF2B5EF4-FFF2-40B4-BE49-F238E27FC236}">
                      <a16:creationId xmlns:a16="http://schemas.microsoft.com/office/drawing/2014/main" id="{56EE53F8-3BB5-3F05-3F20-12B2D590CA37}"/>
                    </a:ext>
                  </a:extLst>
                </p:cNvPr>
                <p:cNvSpPr txBox="1"/>
                <p:nvPr/>
              </p:nvSpPr>
              <p:spPr>
                <a:xfrm>
                  <a:off x="8969496" y="2767255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1" name="CasellaDiTesto 10">
                  <a:extLst>
                    <a:ext uri="{FF2B5EF4-FFF2-40B4-BE49-F238E27FC236}">
                      <a16:creationId xmlns:a16="http://schemas.microsoft.com/office/drawing/2014/main" id="{6110CDB7-D2C3-57B9-0629-DA4AA21238A7}"/>
                    </a:ext>
                  </a:extLst>
                </p:cNvPr>
                <p:cNvSpPr txBox="1"/>
                <p:nvPr/>
              </p:nvSpPr>
              <p:spPr>
                <a:xfrm>
                  <a:off x="9158808" y="2767255"/>
                  <a:ext cx="2984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8</a:t>
                  </a:r>
                </a:p>
              </p:txBody>
            </p:sp>
            <p:sp>
              <p:nvSpPr>
                <p:cNvPr id="12" name="CasellaDiTesto 11">
                  <a:extLst>
                    <a:ext uri="{FF2B5EF4-FFF2-40B4-BE49-F238E27FC236}">
                      <a16:creationId xmlns:a16="http://schemas.microsoft.com/office/drawing/2014/main" id="{CCBCC664-35E1-04B2-0A85-43265D62E64A}"/>
                    </a:ext>
                  </a:extLst>
                </p:cNvPr>
                <p:cNvSpPr txBox="1"/>
                <p:nvPr/>
              </p:nvSpPr>
              <p:spPr>
                <a:xfrm>
                  <a:off x="9369041" y="2767255"/>
                  <a:ext cx="2984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7</a:t>
                  </a:r>
                </a:p>
              </p:txBody>
            </p:sp>
            <p:sp>
              <p:nvSpPr>
                <p:cNvPr id="13" name="CasellaDiTesto 12">
                  <a:extLst>
                    <a:ext uri="{FF2B5EF4-FFF2-40B4-BE49-F238E27FC236}">
                      <a16:creationId xmlns:a16="http://schemas.microsoft.com/office/drawing/2014/main" id="{215499FA-8885-083C-6967-74D38B1211BC}"/>
                    </a:ext>
                  </a:extLst>
                </p:cNvPr>
                <p:cNvSpPr txBox="1"/>
                <p:nvPr/>
              </p:nvSpPr>
              <p:spPr>
                <a:xfrm>
                  <a:off x="9594437" y="2767255"/>
                  <a:ext cx="2984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6</a:t>
                  </a:r>
                </a:p>
              </p:txBody>
            </p:sp>
            <p:sp>
              <p:nvSpPr>
                <p:cNvPr id="14" name="CasellaDiTesto 13">
                  <a:extLst>
                    <a:ext uri="{FF2B5EF4-FFF2-40B4-BE49-F238E27FC236}">
                      <a16:creationId xmlns:a16="http://schemas.microsoft.com/office/drawing/2014/main" id="{B7920940-E8F0-5C8E-E126-3C4577CA6B66}"/>
                    </a:ext>
                  </a:extLst>
                </p:cNvPr>
                <p:cNvSpPr txBox="1"/>
                <p:nvPr/>
              </p:nvSpPr>
              <p:spPr>
                <a:xfrm>
                  <a:off x="9803643" y="2767255"/>
                  <a:ext cx="29848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</a:t>
                  </a:r>
                </a:p>
              </p:txBody>
            </p:sp>
            <p:sp>
              <p:nvSpPr>
                <p:cNvPr id="15" name="CasellaDiTesto 14">
                  <a:extLst>
                    <a:ext uri="{FF2B5EF4-FFF2-40B4-BE49-F238E27FC236}">
                      <a16:creationId xmlns:a16="http://schemas.microsoft.com/office/drawing/2014/main" id="{A5BC26AA-99D4-7A4D-1B80-3B2032FA0836}"/>
                    </a:ext>
                  </a:extLst>
                </p:cNvPr>
                <p:cNvSpPr txBox="1"/>
                <p:nvPr/>
              </p:nvSpPr>
              <p:spPr>
                <a:xfrm>
                  <a:off x="9253644" y="2906939"/>
                  <a:ext cx="7649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g [LMX]</a:t>
                  </a:r>
                </a:p>
              </p:txBody>
            </p:sp>
            <p:cxnSp>
              <p:nvCxnSpPr>
                <p:cNvPr id="16" name="Connettore diritto 15">
                  <a:extLst>
                    <a:ext uri="{FF2B5EF4-FFF2-40B4-BE49-F238E27FC236}">
                      <a16:creationId xmlns:a16="http://schemas.microsoft.com/office/drawing/2014/main" id="{DE14660B-E73F-55BD-BC1F-CAD3C22C17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287660" y="2956826"/>
                  <a:ext cx="696921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" name="CasellaDiTesto 3">
                <a:extLst>
                  <a:ext uri="{FF2B5EF4-FFF2-40B4-BE49-F238E27FC236}">
                    <a16:creationId xmlns:a16="http://schemas.microsoft.com/office/drawing/2014/main" id="{C9C3C577-9484-60D1-5463-7B07BAF228E7}"/>
                  </a:ext>
                </a:extLst>
              </p:cNvPr>
              <p:cNvSpPr txBox="1"/>
              <p:nvPr/>
            </p:nvSpPr>
            <p:spPr>
              <a:xfrm>
                <a:off x="3421874" y="3282619"/>
                <a:ext cx="5661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Y537S</a:t>
                </a:r>
              </a:p>
            </p:txBody>
          </p:sp>
        </p:grp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7CB97EC8-6310-7100-8E47-630DD9A2D6DC}"/>
                </a:ext>
              </a:extLst>
            </p:cNvPr>
            <p:cNvSpPr txBox="1"/>
            <p:nvPr/>
          </p:nvSpPr>
          <p:spPr>
            <a:xfrm>
              <a:off x="5672267" y="100830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/>
                <a:t>*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id="{F8896A50-9C04-FAEE-2EE8-81DD81871DC4}"/>
                </a:ext>
              </a:extLst>
            </p:cNvPr>
            <p:cNvSpPr txBox="1"/>
            <p:nvPr/>
          </p:nvSpPr>
          <p:spPr>
            <a:xfrm>
              <a:off x="5886526" y="117891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/>
                <a:t>*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B7F87CF6-A0C3-0325-E9E7-E3586DCECFCA}"/>
                </a:ext>
              </a:extLst>
            </p:cNvPr>
            <p:cNvSpPr txBox="1"/>
            <p:nvPr/>
          </p:nvSpPr>
          <p:spPr>
            <a:xfrm>
              <a:off x="6093827" y="1316789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  <a:p>
              <a:r>
                <a:rPr lang="it-IT" sz="1000" dirty="0"/>
                <a:t>*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862803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D32F19C5-789A-E9D2-6AC1-7FCF0D64FB11}"/>
              </a:ext>
            </a:extLst>
          </p:cNvPr>
          <p:cNvSpPr txBox="1"/>
          <p:nvPr/>
        </p:nvSpPr>
        <p:spPr>
          <a:xfrm>
            <a:off x="1990145" y="0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gure 5 </a:t>
            </a:r>
            <a:endParaRPr lang="en-US" b="1" dirty="0"/>
          </a:p>
        </p:txBody>
      </p: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8739A73D-9DA9-B3B3-8EAD-845846874495}"/>
              </a:ext>
            </a:extLst>
          </p:cNvPr>
          <p:cNvGrpSpPr/>
          <p:nvPr/>
        </p:nvGrpSpPr>
        <p:grpSpPr>
          <a:xfrm>
            <a:off x="404664" y="755576"/>
            <a:ext cx="2879178" cy="1683078"/>
            <a:chOff x="514776" y="904355"/>
            <a:chExt cx="2879178" cy="1683078"/>
          </a:xfrm>
        </p:grpSpPr>
        <p:pic>
          <p:nvPicPr>
            <p:cNvPr id="31" name="Immagine 30">
              <a:extLst>
                <a:ext uri="{FF2B5EF4-FFF2-40B4-BE49-F238E27FC236}">
                  <a16:creationId xmlns:a16="http://schemas.microsoft.com/office/drawing/2014/main" id="{0CABB75A-6F88-A979-B0F5-060E495D22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4213" y="998698"/>
              <a:ext cx="1781552" cy="1231200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6B7742B2-A5AE-7FEA-243F-7128AF7FAB30}"/>
                </a:ext>
              </a:extLst>
            </p:cNvPr>
            <p:cNvSpPr txBox="1"/>
            <p:nvPr/>
          </p:nvSpPr>
          <p:spPr>
            <a:xfrm>
              <a:off x="850161" y="146358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765C5D92-F10A-4BDA-1CAE-50FEA7619D9A}"/>
                </a:ext>
              </a:extLst>
            </p:cNvPr>
            <p:cNvSpPr txBox="1"/>
            <p:nvPr/>
          </p:nvSpPr>
          <p:spPr>
            <a:xfrm>
              <a:off x="920693" y="202843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0C166466-E17C-9A4C-A0E2-7C4CDFDB3065}"/>
                </a:ext>
              </a:extLst>
            </p:cNvPr>
            <p:cNvSpPr txBox="1"/>
            <p:nvPr/>
          </p:nvSpPr>
          <p:spPr>
            <a:xfrm>
              <a:off x="779629" y="90435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1CC4439B-5F96-9FB5-2BDA-5C0AEBFC667F}"/>
                </a:ext>
              </a:extLst>
            </p:cNvPr>
            <p:cNvSpPr txBox="1"/>
            <p:nvPr/>
          </p:nvSpPr>
          <p:spPr>
            <a:xfrm rot="16200000">
              <a:off x="266631" y="1386141"/>
              <a:ext cx="8964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</a:t>
              </a:r>
              <a:r>
                <a:rPr lang="it-IT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(% on 0)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635E6387-13D1-7CF5-B3CB-D987FBFA2563}"/>
                </a:ext>
              </a:extLst>
            </p:cNvPr>
            <p:cNvSpPr txBox="1"/>
            <p:nvPr/>
          </p:nvSpPr>
          <p:spPr>
            <a:xfrm>
              <a:off x="1248761" y="218072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D0728CCE-3D4E-C4F2-A85F-2E09537706D5}"/>
                </a:ext>
              </a:extLst>
            </p:cNvPr>
            <p:cNvSpPr txBox="1"/>
            <p:nvPr/>
          </p:nvSpPr>
          <p:spPr>
            <a:xfrm>
              <a:off x="1432947" y="2180723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F33202FD-3E58-B255-1152-E610D8EDAF5F}"/>
                </a:ext>
              </a:extLst>
            </p:cNvPr>
            <p:cNvSpPr txBox="1"/>
            <p:nvPr/>
          </p:nvSpPr>
          <p:spPr>
            <a:xfrm>
              <a:off x="1930856" y="218072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6D2C04AF-3BDF-19C9-9977-1D7C94803102}"/>
                </a:ext>
              </a:extLst>
            </p:cNvPr>
            <p:cNvSpPr txBox="1"/>
            <p:nvPr/>
          </p:nvSpPr>
          <p:spPr>
            <a:xfrm>
              <a:off x="1688987" y="218072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8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CFA3A488-F81B-DB30-A928-1C3A47F770E6}"/>
                </a:ext>
              </a:extLst>
            </p:cNvPr>
            <p:cNvSpPr txBox="1"/>
            <p:nvPr/>
          </p:nvSpPr>
          <p:spPr>
            <a:xfrm>
              <a:off x="1716128" y="2341212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Log [TAM]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07AE722B-B4EA-AA1C-158B-B83FC4D8A6EF}"/>
                </a:ext>
              </a:extLst>
            </p:cNvPr>
            <p:cNvSpPr txBox="1"/>
            <p:nvPr/>
          </p:nvSpPr>
          <p:spPr>
            <a:xfrm>
              <a:off x="2196662" y="218072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DC9ED4B6-90FC-D7BE-A136-9B43F6C6E728}"/>
                </a:ext>
              </a:extLst>
            </p:cNvPr>
            <p:cNvSpPr txBox="1"/>
            <p:nvPr/>
          </p:nvSpPr>
          <p:spPr>
            <a:xfrm>
              <a:off x="2438531" y="218072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cxnSp>
          <p:nvCxnSpPr>
            <p:cNvPr id="36" name="Connettore diritto 35">
              <a:extLst>
                <a:ext uri="{FF2B5EF4-FFF2-40B4-BE49-F238E27FC236}">
                  <a16:creationId xmlns:a16="http://schemas.microsoft.com/office/drawing/2014/main" id="{BF197A0E-A983-D45F-863F-F8D15B9ABCBE}"/>
                </a:ext>
              </a:extLst>
            </p:cNvPr>
            <p:cNvCxnSpPr>
              <a:cxnSpLocks/>
            </p:cNvCxnSpPr>
            <p:nvPr/>
          </p:nvCxnSpPr>
          <p:spPr>
            <a:xfrm>
              <a:off x="1617453" y="2384079"/>
              <a:ext cx="97031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44" name="Gruppo 43">
              <a:extLst>
                <a:ext uri="{FF2B5EF4-FFF2-40B4-BE49-F238E27FC236}">
                  <a16:creationId xmlns:a16="http://schemas.microsoft.com/office/drawing/2014/main" id="{F0FCCA48-C6BE-6470-BC67-81B2C137DAB5}"/>
                </a:ext>
              </a:extLst>
            </p:cNvPr>
            <p:cNvGrpSpPr/>
            <p:nvPr/>
          </p:nvGrpSpPr>
          <p:grpSpPr>
            <a:xfrm>
              <a:off x="2515960" y="1065007"/>
              <a:ext cx="877994" cy="949083"/>
              <a:chOff x="2542580" y="880659"/>
              <a:chExt cx="877994" cy="949083"/>
            </a:xfrm>
          </p:grpSpPr>
          <p:pic>
            <p:nvPicPr>
              <p:cNvPr id="32" name="Immagine 31">
                <a:extLst>
                  <a:ext uri="{FF2B5EF4-FFF2-40B4-BE49-F238E27FC236}">
                    <a16:creationId xmlns:a16="http://schemas.microsoft.com/office/drawing/2014/main" id="{EA521B2B-9A27-0625-2812-213DBAC322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542580" y="979333"/>
                <a:ext cx="168883" cy="786638"/>
              </a:xfrm>
              <a:prstGeom prst="rect">
                <a:avLst/>
              </a:prstGeom>
            </p:spPr>
          </p:pic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8DB3061F-F03C-5247-315A-FC48DEA34B38}"/>
                  </a:ext>
                </a:extLst>
              </p:cNvPr>
              <p:cNvSpPr txBox="1"/>
              <p:nvPr/>
            </p:nvSpPr>
            <p:spPr>
              <a:xfrm>
                <a:off x="2681269" y="880659"/>
                <a:ext cx="4972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CF-7</a:t>
                </a:r>
              </a:p>
            </p:txBody>
          </p:sp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E0C38E90-4CB5-EDA9-F3F8-75E1DFC4CDCB}"/>
                  </a:ext>
                </a:extLst>
              </p:cNvPr>
              <p:cNvSpPr txBox="1"/>
              <p:nvPr/>
            </p:nvSpPr>
            <p:spPr>
              <a:xfrm>
                <a:off x="2681269" y="1014885"/>
                <a:ext cx="5277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47D-1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69CBF8BD-1445-AE8E-494F-F829E07DDA3E}"/>
                  </a:ext>
                </a:extLst>
              </p:cNvPr>
              <p:cNvSpPr txBox="1"/>
              <p:nvPr/>
            </p:nvSpPr>
            <p:spPr>
              <a:xfrm>
                <a:off x="2681269" y="1149111"/>
                <a:ext cx="5613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ZR-75-1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4E003D6B-1A1F-E8B8-5781-0A201F5B2EF9}"/>
                  </a:ext>
                </a:extLst>
              </p:cNvPr>
              <p:cNvSpPr txBox="1"/>
              <p:nvPr/>
            </p:nvSpPr>
            <p:spPr>
              <a:xfrm>
                <a:off x="2681269" y="1266545"/>
                <a:ext cx="63671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CC1428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E188271A-DC38-1437-8FEF-EB82C64E9212}"/>
                  </a:ext>
                </a:extLst>
              </p:cNvPr>
              <p:cNvSpPr txBox="1"/>
              <p:nvPr/>
            </p:nvSpPr>
            <p:spPr>
              <a:xfrm>
                <a:off x="2681269" y="1387231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T-474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0FB3BE10-5250-A63F-C636-1A4B05461082}"/>
                  </a:ext>
                </a:extLst>
              </p:cNvPr>
              <p:cNvSpPr txBox="1"/>
              <p:nvPr/>
            </p:nvSpPr>
            <p:spPr>
              <a:xfrm>
                <a:off x="2681269" y="1494953"/>
                <a:ext cx="7393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DAMB361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237F9393-7D83-84A7-A038-543BC3C84F69}"/>
                  </a:ext>
                </a:extLst>
              </p:cNvPr>
              <p:cNvSpPr txBox="1"/>
              <p:nvPr/>
            </p:nvSpPr>
            <p:spPr>
              <a:xfrm>
                <a:off x="2681269" y="1614298"/>
                <a:ext cx="6479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FM192C</a:t>
                </a:r>
              </a:p>
            </p:txBody>
          </p:sp>
        </p:grpSp>
      </p:grpSp>
      <p:grpSp>
        <p:nvGrpSpPr>
          <p:cNvPr id="63" name="Gruppo 62">
            <a:extLst>
              <a:ext uri="{FF2B5EF4-FFF2-40B4-BE49-F238E27FC236}">
                <a16:creationId xmlns:a16="http://schemas.microsoft.com/office/drawing/2014/main" id="{0D31C916-3E2A-E1FB-477C-0198B1C871F0}"/>
              </a:ext>
            </a:extLst>
          </p:cNvPr>
          <p:cNvGrpSpPr/>
          <p:nvPr/>
        </p:nvGrpSpPr>
        <p:grpSpPr>
          <a:xfrm>
            <a:off x="3701864" y="683568"/>
            <a:ext cx="3368140" cy="1755086"/>
            <a:chOff x="3701864" y="683568"/>
            <a:chExt cx="3368140" cy="1755086"/>
          </a:xfrm>
        </p:grpSpPr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7D871B02-34F2-340E-35B8-D380AF458700}"/>
                </a:ext>
              </a:extLst>
            </p:cNvPr>
            <p:cNvSpPr txBox="1"/>
            <p:nvPr/>
          </p:nvSpPr>
          <p:spPr>
            <a:xfrm>
              <a:off x="4303682" y="683568"/>
              <a:ext cx="27663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b="1" i="1" dirty="0" err="1"/>
                <a:t>Spear</a:t>
              </a:r>
              <a:r>
                <a:rPr lang="it-IT" sz="900" b="1" i="1" dirty="0"/>
                <a:t>. </a:t>
              </a:r>
              <a:r>
                <a:rPr lang="it-IT" sz="900" b="1" i="1" dirty="0" err="1"/>
                <a:t>Corr</a:t>
              </a:r>
              <a:r>
                <a:rPr lang="it-IT" sz="900" b="1" i="1" dirty="0"/>
                <a:t>.: r = 0.7453 p=0.05</a:t>
              </a:r>
            </a:p>
          </p:txBody>
        </p:sp>
        <p:grpSp>
          <p:nvGrpSpPr>
            <p:cNvPr id="60" name="Gruppo 59">
              <a:extLst>
                <a:ext uri="{FF2B5EF4-FFF2-40B4-BE49-F238E27FC236}">
                  <a16:creationId xmlns:a16="http://schemas.microsoft.com/office/drawing/2014/main" id="{23359F62-6526-7379-8CFA-EDBDA9F66894}"/>
                </a:ext>
              </a:extLst>
            </p:cNvPr>
            <p:cNvGrpSpPr/>
            <p:nvPr/>
          </p:nvGrpSpPr>
          <p:grpSpPr>
            <a:xfrm>
              <a:off x="3701864" y="705660"/>
              <a:ext cx="2447611" cy="1732994"/>
              <a:chOff x="3701864" y="705660"/>
              <a:chExt cx="2447611" cy="1732994"/>
            </a:xfrm>
          </p:grpSpPr>
          <p:pic>
            <p:nvPicPr>
              <p:cNvPr id="59" name="Immagine 58">
                <a:extLst>
                  <a:ext uri="{FF2B5EF4-FFF2-40B4-BE49-F238E27FC236}">
                    <a16:creationId xmlns:a16="http://schemas.microsoft.com/office/drawing/2014/main" id="{D3E09387-F362-B111-EB3D-EBB94D3C07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323236" y="873982"/>
                <a:ext cx="1659000" cy="1134000"/>
              </a:xfrm>
              <a:prstGeom prst="rect">
                <a:avLst/>
              </a:prstGeom>
            </p:spPr>
          </p:pic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05D6AAB4-99D6-F7C5-FDF8-421486660A3C}"/>
                  </a:ext>
                </a:extLst>
              </p:cNvPr>
              <p:cNvSpPr txBox="1"/>
              <p:nvPr/>
            </p:nvSpPr>
            <p:spPr>
              <a:xfrm>
                <a:off x="4009158" y="1813969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-1.0</a:t>
                </a:r>
              </a:p>
            </p:txBody>
          </p:sp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C549B55A-FDCB-962D-BFD9-222962E5E690}"/>
                  </a:ext>
                </a:extLst>
              </p:cNvPr>
              <p:cNvSpPr txBox="1"/>
              <p:nvPr/>
            </p:nvSpPr>
            <p:spPr>
              <a:xfrm>
                <a:off x="4052440" y="129677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0.0</a:t>
                </a: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ADF073FF-A89E-D749-955C-580D40015220}"/>
                  </a:ext>
                </a:extLst>
              </p:cNvPr>
              <p:cNvSpPr txBox="1"/>
              <p:nvPr/>
            </p:nvSpPr>
            <p:spPr>
              <a:xfrm>
                <a:off x="4052440" y="77082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1.0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91BBD907-1250-C1DB-831E-384C865D1A06}"/>
                  </a:ext>
                </a:extLst>
              </p:cNvPr>
              <p:cNvSpPr txBox="1"/>
              <p:nvPr/>
            </p:nvSpPr>
            <p:spPr>
              <a:xfrm>
                <a:off x="4214330" y="2038544"/>
                <a:ext cx="193514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 err="1"/>
                  <a:t>Sensitivity</a:t>
                </a:r>
                <a:r>
                  <a:rPr lang="it-IT" sz="1000" dirty="0"/>
                  <a:t> to Tam </a:t>
                </a:r>
                <a:r>
                  <a:rPr lang="it-IT" sz="1000" dirty="0" err="1"/>
                  <a:t>present</a:t>
                </a:r>
                <a:r>
                  <a:rPr lang="it-IT" sz="1000" dirty="0"/>
                  <a:t> data</a:t>
                </a:r>
              </a:p>
              <a:p>
                <a:pPr algn="ctr"/>
                <a:r>
                  <a:rPr lang="it-IT" sz="1000" dirty="0">
                    <a:latin typeface="+mn-lt"/>
                  </a:rPr>
                  <a:t>(Relative </a:t>
                </a:r>
                <a:r>
                  <a:rPr lang="it-IT" sz="1000" dirty="0" err="1">
                    <a:latin typeface="+mn-lt"/>
                  </a:rPr>
                  <a:t>Units</a:t>
                </a:r>
                <a:r>
                  <a:rPr lang="it-IT" sz="1000" dirty="0">
                    <a:latin typeface="+mn-lt"/>
                  </a:rPr>
                  <a:t>)</a:t>
                </a: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014AB04B-B783-1EBD-A370-B7962694CE8F}"/>
                  </a:ext>
                </a:extLst>
              </p:cNvPr>
              <p:cNvSpPr txBox="1"/>
              <p:nvPr/>
            </p:nvSpPr>
            <p:spPr>
              <a:xfrm>
                <a:off x="4193518" y="192078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0.0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157CB351-8907-91DD-969B-B94280EF507C}"/>
                  </a:ext>
                </a:extLst>
              </p:cNvPr>
              <p:cNvSpPr txBox="1"/>
              <p:nvPr/>
            </p:nvSpPr>
            <p:spPr>
              <a:xfrm>
                <a:off x="5192166" y="1920782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20.0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9C37A9E9-6A74-EDD7-F8C8-A88168E75BF3}"/>
                  </a:ext>
                </a:extLst>
              </p:cNvPr>
              <p:cNvSpPr txBox="1"/>
              <p:nvPr/>
            </p:nvSpPr>
            <p:spPr>
              <a:xfrm>
                <a:off x="5701443" y="1920782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30.0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D8ED4ABC-BD84-4325-749B-A269436E5F9F}"/>
                  </a:ext>
                </a:extLst>
              </p:cNvPr>
              <p:cNvSpPr txBox="1"/>
              <p:nvPr/>
            </p:nvSpPr>
            <p:spPr>
              <a:xfrm>
                <a:off x="4661255" y="1920782"/>
                <a:ext cx="4315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/>
                  <a:t>10.0</a:t>
                </a:r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id="{DF6B2258-2433-8E49-5593-EDF65CBA5854}"/>
                  </a:ext>
                </a:extLst>
              </p:cNvPr>
              <p:cNvSpPr txBox="1"/>
              <p:nvPr/>
            </p:nvSpPr>
            <p:spPr>
              <a:xfrm rot="16200000">
                <a:off x="3046556" y="1360968"/>
                <a:ext cx="171072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 err="1"/>
                  <a:t>Sensitivity</a:t>
                </a:r>
                <a:r>
                  <a:rPr lang="it-IT" sz="1000" dirty="0"/>
                  <a:t> to Tam </a:t>
                </a:r>
                <a:r>
                  <a:rPr lang="it-IT" sz="1000" dirty="0" err="1"/>
                  <a:t>DepMap</a:t>
                </a:r>
                <a:endParaRPr lang="it-IT" sz="1000" dirty="0"/>
              </a:p>
              <a:p>
                <a:pPr algn="ctr"/>
                <a:r>
                  <a:rPr lang="it-IT" sz="1000" dirty="0">
                    <a:latin typeface="+mn-lt"/>
                  </a:rPr>
                  <a:t>(Relative </a:t>
                </a:r>
                <a:r>
                  <a:rPr lang="it-IT" sz="1000" dirty="0" err="1">
                    <a:latin typeface="+mn-lt"/>
                  </a:rPr>
                  <a:t>Units</a:t>
                </a:r>
                <a:r>
                  <a:rPr lang="it-IT" sz="1000" dirty="0">
                    <a:latin typeface="+mn-lt"/>
                  </a:rPr>
                  <a:t>)</a:t>
                </a:r>
              </a:p>
            </p:txBody>
          </p:sp>
        </p:grpSp>
      </p:grp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B086FAD5-80E0-0251-13B8-8EFC02065511}"/>
              </a:ext>
            </a:extLst>
          </p:cNvPr>
          <p:cNvSpPr txBox="1"/>
          <p:nvPr/>
        </p:nvSpPr>
        <p:spPr>
          <a:xfrm>
            <a:off x="3349750" y="5379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B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7135C369-C402-746F-FD3E-ED6209372D94}"/>
              </a:ext>
            </a:extLst>
          </p:cNvPr>
          <p:cNvSpPr txBox="1"/>
          <p:nvPr/>
        </p:nvSpPr>
        <p:spPr>
          <a:xfrm>
            <a:off x="260648" y="5379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17475677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17</TotalTime>
  <Words>503</Words>
  <Application>Microsoft Office PowerPoint</Application>
  <PresentationFormat>Presentazione su schermo (4:3)</PresentationFormat>
  <Paragraphs>343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Default Design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ilippo Acconcia</dc:creator>
  <cp:lastModifiedBy>Filippo Acconcia</cp:lastModifiedBy>
  <cp:revision>624</cp:revision>
  <cp:lastPrinted>2016-12-30T08:51:21Z</cp:lastPrinted>
  <dcterms:created xsi:type="dcterms:W3CDTF">2014-12-18T14:53:45Z</dcterms:created>
  <dcterms:modified xsi:type="dcterms:W3CDTF">2022-10-29T13:58:46Z</dcterms:modified>
</cp:coreProperties>
</file>